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6" r:id="rId3"/>
    <p:sldId id="267" r:id="rId4"/>
  </p:sldIdLst>
  <p:sldSz cx="12192000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3" d="100"/>
          <a:sy n="83" d="100"/>
        </p:scale>
        <p:origin x="686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63D3EB4E-0FDD-DAB9-62B5-5D4BB27E121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Alcím 2">
            <a:extLst>
              <a:ext uri="{FF2B5EF4-FFF2-40B4-BE49-F238E27FC236}">
                <a16:creationId xmlns:a16="http://schemas.microsoft.com/office/drawing/2014/main" id="{2682DAF0-A4E4-7F40-CA35-1F428FAD0B2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/>
              <a:t>Kattintson ide az alcím mintájának szerkesztéséhez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9127DD6F-8282-D826-742E-4BDF759006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ACE589A8-07C2-D398-5024-84D814B258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03BBE8ED-4132-90C9-D9C1-A14AA0D620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5706775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FA18142C-CDFE-547F-3C69-4B12251288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6A171963-386D-8D95-5487-EF002306F2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6178EA5D-CEED-8F7A-434F-A3B8B72A24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6EF3970C-B95F-CE71-BD56-79AE731F5D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B7AFB0A5-2092-22E5-329D-3CC07FC066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818344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>
            <a:extLst>
              <a:ext uri="{FF2B5EF4-FFF2-40B4-BE49-F238E27FC236}">
                <a16:creationId xmlns:a16="http://schemas.microsoft.com/office/drawing/2014/main" id="{8F90296C-F140-C5D5-3839-44D222BF9F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A9F68C5D-AF0B-00A6-2382-21BEFD512F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FB613BAB-988B-B11B-2CAA-44C53106C4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C4D4BD31-E7B0-2CB8-DBD0-E113E85260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AA9BDE5A-DA49-2D4F-AE08-0FDC2C3DD8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9960304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3306890D-953B-A523-D491-7F11DB8068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52838409-7F06-49AF-1375-9FAF69F3AC2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D7BA1735-F4C4-E5BC-C631-087F053E57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ED762BD8-419F-7B68-FE0A-D96246A610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E2EA530B-D3BB-C24F-1E63-A92F4F9837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2715002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DCFA2DBD-226E-9F87-01DC-4E0CBE7598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A3923EEC-2545-A34E-C388-145E73517A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F6D1716F-41BC-3A0A-79C9-9FD600D76E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24E20AF0-E01B-DCF0-E353-F7FF3A543F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A524D8FD-7037-A81D-67CF-CB81A477C8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030480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7911CB4C-2B15-3509-45F7-2DF644714F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F3411103-0948-6130-A09E-941C0219A8A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18316E82-BE57-3BF8-74A7-11D4B0C1A3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DA4B0C3F-BF58-D699-510B-7C314233E6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86EF3B0B-C6D5-5572-39AF-7E87BF07CD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D24B19B3-1C44-EE5A-2E54-7BE1FD2262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6491605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56051A81-9269-A031-1439-951A50176A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3E735BDB-B78C-6A5D-387C-9E948F2F36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039BE8D8-D06E-CA01-0348-C8A09ED7AD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Szöveg helye 4">
            <a:extLst>
              <a:ext uri="{FF2B5EF4-FFF2-40B4-BE49-F238E27FC236}">
                <a16:creationId xmlns:a16="http://schemas.microsoft.com/office/drawing/2014/main" id="{907B9B77-D522-8C56-EB62-7826ACC5A5A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Tartalom helye 5">
            <a:extLst>
              <a:ext uri="{FF2B5EF4-FFF2-40B4-BE49-F238E27FC236}">
                <a16:creationId xmlns:a16="http://schemas.microsoft.com/office/drawing/2014/main" id="{112960BD-3823-CB1D-8794-322A75235C9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7" name="Dátum helye 6">
            <a:extLst>
              <a:ext uri="{FF2B5EF4-FFF2-40B4-BE49-F238E27FC236}">
                <a16:creationId xmlns:a16="http://schemas.microsoft.com/office/drawing/2014/main" id="{10AE7140-FBD9-81AC-591D-8DDEBCCF87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8" name="Élőláb helye 7">
            <a:extLst>
              <a:ext uri="{FF2B5EF4-FFF2-40B4-BE49-F238E27FC236}">
                <a16:creationId xmlns:a16="http://schemas.microsoft.com/office/drawing/2014/main" id="{520E7E60-A060-B8DC-9C33-E70F3D9962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>
            <a:extLst>
              <a:ext uri="{FF2B5EF4-FFF2-40B4-BE49-F238E27FC236}">
                <a16:creationId xmlns:a16="http://schemas.microsoft.com/office/drawing/2014/main" id="{75F0E0F3-9A79-AED0-14F1-3B2DCF3C3A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13711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2CA2F278-0655-A398-F982-468D2E6EBA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Dátum helye 2">
            <a:extLst>
              <a:ext uri="{FF2B5EF4-FFF2-40B4-BE49-F238E27FC236}">
                <a16:creationId xmlns:a16="http://schemas.microsoft.com/office/drawing/2014/main" id="{6146CBDF-52F2-03AB-FEB4-37DCD63171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4" name="Élőláb helye 3">
            <a:extLst>
              <a:ext uri="{FF2B5EF4-FFF2-40B4-BE49-F238E27FC236}">
                <a16:creationId xmlns:a16="http://schemas.microsoft.com/office/drawing/2014/main" id="{7CD74A26-663F-59A7-4AFD-2EE2CFC871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>
            <a:extLst>
              <a:ext uri="{FF2B5EF4-FFF2-40B4-BE49-F238E27FC236}">
                <a16:creationId xmlns:a16="http://schemas.microsoft.com/office/drawing/2014/main" id="{C9E09467-A6FE-5B16-165E-67E685704C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9969121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>
            <a:extLst>
              <a:ext uri="{FF2B5EF4-FFF2-40B4-BE49-F238E27FC236}">
                <a16:creationId xmlns:a16="http://schemas.microsoft.com/office/drawing/2014/main" id="{5D9A19CE-B9A8-05B5-79B8-68D7A64545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3" name="Élőláb helye 2">
            <a:extLst>
              <a:ext uri="{FF2B5EF4-FFF2-40B4-BE49-F238E27FC236}">
                <a16:creationId xmlns:a16="http://schemas.microsoft.com/office/drawing/2014/main" id="{C39B68FF-469A-0288-2C31-DE640D68DA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>
            <a:extLst>
              <a:ext uri="{FF2B5EF4-FFF2-40B4-BE49-F238E27FC236}">
                <a16:creationId xmlns:a16="http://schemas.microsoft.com/office/drawing/2014/main" id="{454C1566-9FFE-391A-B50C-EDCCA41484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0584263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BC8E1726-18C6-98BC-3C9B-42E98B9F05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6B4EF117-5E4C-53D6-C6FD-2B8503E285C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76CE4C73-1399-26BF-5064-BF2FE49638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24034B12-3B4D-3E0E-1850-125039B324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C80C3718-0B99-1E4D-A5BE-4F02CF65C1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A056087C-2178-34D1-9999-525FD44C0D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917729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3241D0E5-3CC6-BB73-7801-1E21358692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Kép helye 2">
            <a:extLst>
              <a:ext uri="{FF2B5EF4-FFF2-40B4-BE49-F238E27FC236}">
                <a16:creationId xmlns:a16="http://schemas.microsoft.com/office/drawing/2014/main" id="{A4550096-2B35-7649-C9A6-92525879B5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2DF7DFFC-5EDD-592F-907A-AEBD2A0CD7D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FA50EBCD-5314-6286-2A6A-F239C7064A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CEFBC52E-3B91-39DA-1EF3-A7A88562A8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AC8AA4DE-44D0-E589-9C32-F958304508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800532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>
            <a:extLst>
              <a:ext uri="{FF2B5EF4-FFF2-40B4-BE49-F238E27FC236}">
                <a16:creationId xmlns:a16="http://schemas.microsoft.com/office/drawing/2014/main" id="{6CE8559C-B575-BF2E-B70B-D19E0B524A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DEA01872-7F80-2350-ED99-961E6B4DE1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D8E67A6B-F86B-E496-F259-CC5BD46D681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EA164B19-A872-2E22-BE5E-9D6EAA68BA9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67DFAC13-AB3A-0719-EBE6-7F346631DA1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242160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10" Type="http://schemas.openxmlformats.org/officeDocument/2006/relationships/image" Target="../media/image9.tif"/><Relationship Id="rId4" Type="http://schemas.openxmlformats.org/officeDocument/2006/relationships/image" Target="../media/image3.tif"/><Relationship Id="rId9" Type="http://schemas.openxmlformats.org/officeDocument/2006/relationships/image" Target="../media/image8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"/><Relationship Id="rId2" Type="http://schemas.openxmlformats.org/officeDocument/2006/relationships/image" Target="../media/image10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"/><Relationship Id="rId2" Type="http://schemas.openxmlformats.org/officeDocument/2006/relationships/image" Target="../media/image13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zövegdoboz 3">
            <a:extLst>
              <a:ext uri="{FF2B5EF4-FFF2-40B4-BE49-F238E27FC236}">
                <a16:creationId xmlns:a16="http://schemas.microsoft.com/office/drawing/2014/main" id="{4E61EA46-CF03-FBB6-50D2-3D75129E7EDA}"/>
              </a:ext>
            </a:extLst>
          </p:cNvPr>
          <p:cNvSpPr txBox="1"/>
          <p:nvPr/>
        </p:nvSpPr>
        <p:spPr>
          <a:xfrm>
            <a:off x="68367" y="68366"/>
            <a:ext cx="22506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b="1" dirty="0" smtClean="0"/>
              <a:t>BxPC-3:</a:t>
            </a:r>
            <a:endParaRPr lang="hu-HU" b="1" dirty="0"/>
          </a:p>
        </p:txBody>
      </p:sp>
      <p:grpSp>
        <p:nvGrpSpPr>
          <p:cNvPr id="101" name="Csoportba foglalás 100">
            <a:extLst>
              <a:ext uri="{FF2B5EF4-FFF2-40B4-BE49-F238E27FC236}">
                <a16:creationId xmlns:a16="http://schemas.microsoft.com/office/drawing/2014/main" id="{D459D6BC-C8C6-7896-D092-1FCC4D5B5D06}"/>
              </a:ext>
            </a:extLst>
          </p:cNvPr>
          <p:cNvGrpSpPr/>
          <p:nvPr/>
        </p:nvGrpSpPr>
        <p:grpSpPr>
          <a:xfrm>
            <a:off x="68366" y="378270"/>
            <a:ext cx="11964551" cy="2059144"/>
            <a:chOff x="68366" y="378270"/>
            <a:chExt cx="11964551" cy="2059144"/>
          </a:xfrm>
        </p:grpSpPr>
        <p:grpSp>
          <p:nvGrpSpPr>
            <p:cNvPr id="98" name="Csoportba foglalás 97">
              <a:extLst>
                <a:ext uri="{FF2B5EF4-FFF2-40B4-BE49-F238E27FC236}">
                  <a16:creationId xmlns:a16="http://schemas.microsoft.com/office/drawing/2014/main" id="{7907D71C-C669-5AB8-B35F-9F976F08F83A}"/>
                </a:ext>
              </a:extLst>
            </p:cNvPr>
            <p:cNvGrpSpPr/>
            <p:nvPr/>
          </p:nvGrpSpPr>
          <p:grpSpPr>
            <a:xfrm>
              <a:off x="68366" y="378270"/>
              <a:ext cx="11964551" cy="2059144"/>
              <a:chOff x="68366" y="378270"/>
              <a:chExt cx="11964551" cy="2059144"/>
            </a:xfrm>
          </p:grpSpPr>
          <p:grpSp>
            <p:nvGrpSpPr>
              <p:cNvPr id="91" name="Csoportba foglalás 90">
                <a:extLst>
                  <a:ext uri="{FF2B5EF4-FFF2-40B4-BE49-F238E27FC236}">
                    <a16:creationId xmlns:a16="http://schemas.microsoft.com/office/drawing/2014/main" id="{FDE87C2D-DD7C-7D12-847C-6488D6D9E335}"/>
                  </a:ext>
                </a:extLst>
              </p:cNvPr>
              <p:cNvGrpSpPr/>
              <p:nvPr/>
            </p:nvGrpSpPr>
            <p:grpSpPr>
              <a:xfrm>
                <a:off x="68366" y="378270"/>
                <a:ext cx="11964551" cy="2059144"/>
                <a:chOff x="68366" y="378270"/>
                <a:chExt cx="11964551" cy="2059144"/>
              </a:xfrm>
            </p:grpSpPr>
            <p:grpSp>
              <p:nvGrpSpPr>
                <p:cNvPr id="87" name="Csoportba foglalás 86">
                  <a:extLst>
                    <a:ext uri="{FF2B5EF4-FFF2-40B4-BE49-F238E27FC236}">
                      <a16:creationId xmlns:a16="http://schemas.microsoft.com/office/drawing/2014/main" id="{49146A8E-4C74-2DAA-5D3F-E63587F8951D}"/>
                    </a:ext>
                  </a:extLst>
                </p:cNvPr>
                <p:cNvGrpSpPr/>
                <p:nvPr/>
              </p:nvGrpSpPr>
              <p:grpSpPr>
                <a:xfrm>
                  <a:off x="68366" y="378270"/>
                  <a:ext cx="11964551" cy="2059144"/>
                  <a:chOff x="68366" y="378270"/>
                  <a:chExt cx="11964551" cy="2059144"/>
                </a:xfrm>
              </p:grpSpPr>
              <p:grpSp>
                <p:nvGrpSpPr>
                  <p:cNvPr id="60" name="Csoportba foglalás 59">
                    <a:extLst>
                      <a:ext uri="{FF2B5EF4-FFF2-40B4-BE49-F238E27FC236}">
                        <a16:creationId xmlns:a16="http://schemas.microsoft.com/office/drawing/2014/main" id="{06D82926-FC07-52A6-C716-60F83AAAE9F9}"/>
                      </a:ext>
                    </a:extLst>
                  </p:cNvPr>
                  <p:cNvGrpSpPr/>
                  <p:nvPr/>
                </p:nvGrpSpPr>
                <p:grpSpPr>
                  <a:xfrm>
                    <a:off x="68366" y="378270"/>
                    <a:ext cx="11964551" cy="2059144"/>
                    <a:chOff x="68366" y="378270"/>
                    <a:chExt cx="11964551" cy="2059144"/>
                  </a:xfrm>
                </p:grpSpPr>
                <p:grpSp>
                  <p:nvGrpSpPr>
                    <p:cNvPr id="37" name="Csoportba foglalás 36">
                      <a:extLst>
                        <a:ext uri="{FF2B5EF4-FFF2-40B4-BE49-F238E27FC236}">
                          <a16:creationId xmlns:a16="http://schemas.microsoft.com/office/drawing/2014/main" id="{7ABE39CD-B09A-D0DA-A9E3-2DBE21D36FA7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8366" y="378270"/>
                      <a:ext cx="11964551" cy="2059144"/>
                      <a:chOff x="68366" y="378270"/>
                      <a:chExt cx="11964551" cy="2059144"/>
                    </a:xfrm>
                  </p:grpSpPr>
                  <p:grpSp>
                    <p:nvGrpSpPr>
                      <p:cNvPr id="14" name="Csoportba foglalás 13">
                        <a:extLst>
                          <a:ext uri="{FF2B5EF4-FFF2-40B4-BE49-F238E27FC236}">
                            <a16:creationId xmlns:a16="http://schemas.microsoft.com/office/drawing/2014/main" id="{3884A261-C4C8-2226-4DFA-BEB73B87D669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68366" y="378270"/>
                        <a:ext cx="11964551" cy="2059144"/>
                        <a:chOff x="68366" y="378270"/>
                        <a:chExt cx="11964551" cy="2059144"/>
                      </a:xfrm>
                    </p:grpSpPr>
                    <p:grpSp>
                      <p:nvGrpSpPr>
                        <p:cNvPr id="77" name="Csoportba foglalás 76">
                          <a:extLst>
                            <a:ext uri="{FF2B5EF4-FFF2-40B4-BE49-F238E27FC236}">
                              <a16:creationId xmlns:a16="http://schemas.microsoft.com/office/drawing/2014/main" id="{C569ACAC-D16B-0D65-7D7D-1F76F44BC39F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68366" y="378270"/>
                          <a:ext cx="11964551" cy="2059144"/>
                          <a:chOff x="68366" y="378270"/>
                          <a:chExt cx="11964551" cy="2059144"/>
                        </a:xfrm>
                      </p:grpSpPr>
                      <p:grpSp>
                        <p:nvGrpSpPr>
                          <p:cNvPr id="55" name="Csoportba foglalás 54">
                            <a:extLst>
                              <a:ext uri="{FF2B5EF4-FFF2-40B4-BE49-F238E27FC236}">
                                <a16:creationId xmlns:a16="http://schemas.microsoft.com/office/drawing/2014/main" id="{B208A52F-F241-4C85-A7AA-64EA20BF16B9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68366" y="378270"/>
                            <a:ext cx="11964551" cy="2059144"/>
                            <a:chOff x="68366" y="378270"/>
                            <a:chExt cx="11964551" cy="2059144"/>
                          </a:xfrm>
                        </p:grpSpPr>
                        <p:grpSp>
                          <p:nvGrpSpPr>
                            <p:cNvPr id="33" name="Csoportba foglalás 32">
                              <a:extLst>
                                <a:ext uri="{FF2B5EF4-FFF2-40B4-BE49-F238E27FC236}">
                                  <a16:creationId xmlns:a16="http://schemas.microsoft.com/office/drawing/2014/main" id="{74234755-A58A-362A-7964-89361751F9AD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68366" y="378270"/>
                              <a:ext cx="11964551" cy="2059144"/>
                              <a:chOff x="68366" y="378270"/>
                              <a:chExt cx="11964551" cy="2059144"/>
                            </a:xfrm>
                          </p:grpSpPr>
                          <p:grpSp>
                            <p:nvGrpSpPr>
                              <p:cNvPr id="82" name="Csoportba foglalás 81">
                                <a:extLst>
                                  <a:ext uri="{FF2B5EF4-FFF2-40B4-BE49-F238E27FC236}">
                                    <a16:creationId xmlns:a16="http://schemas.microsoft.com/office/drawing/2014/main" id="{E4D819F0-F49E-F51F-1614-D4572937A902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68366" y="378270"/>
                                <a:ext cx="11964551" cy="2059144"/>
                                <a:chOff x="68366" y="378270"/>
                                <a:chExt cx="11964551" cy="2059144"/>
                              </a:xfrm>
                            </p:grpSpPr>
                            <p:grpSp>
                              <p:nvGrpSpPr>
                                <p:cNvPr id="76" name="Csoportba foglalás 75">
                                  <a:extLst>
                                    <a:ext uri="{FF2B5EF4-FFF2-40B4-BE49-F238E27FC236}">
                                      <a16:creationId xmlns:a16="http://schemas.microsoft.com/office/drawing/2014/main" id="{07F847BE-36B5-68B3-4646-5E2854D87DFD}"/>
                                    </a:ext>
                                  </a:extLst>
                                </p:cNvPr>
                                <p:cNvGrpSpPr/>
                                <p:nvPr/>
                              </p:nvGrpSpPr>
                              <p:grpSpPr>
                                <a:xfrm>
                                  <a:off x="68366" y="378270"/>
                                  <a:ext cx="11964551" cy="2059144"/>
                                  <a:chOff x="68366" y="378270"/>
                                  <a:chExt cx="11964551" cy="2059144"/>
                                </a:xfrm>
                              </p:grpSpPr>
                              <p:grpSp>
                                <p:nvGrpSpPr>
                                  <p:cNvPr id="70" name="Csoportba foglalás 69">
                                    <a:extLst>
                                      <a:ext uri="{FF2B5EF4-FFF2-40B4-BE49-F238E27FC236}">
                                        <a16:creationId xmlns:a16="http://schemas.microsoft.com/office/drawing/2014/main" id="{60DE8A5E-1551-9ADE-B800-4FE5FDE480CA}"/>
                                      </a:ext>
                                    </a:extLst>
                                  </p:cNvPr>
                                  <p:cNvGrpSpPr/>
                                  <p:nvPr/>
                                </p:nvGrpSpPr>
                                <p:grpSpPr>
                                  <a:xfrm>
                                    <a:off x="68366" y="378270"/>
                                    <a:ext cx="11964551" cy="2059144"/>
                                    <a:chOff x="68366" y="378270"/>
                                    <a:chExt cx="11964551" cy="2059144"/>
                                  </a:xfrm>
                                </p:grpSpPr>
                                <p:grpSp>
                                  <p:nvGrpSpPr>
                                    <p:cNvPr id="64" name="Csoportba foglalás 63">
                                      <a:extLst>
                                        <a:ext uri="{FF2B5EF4-FFF2-40B4-BE49-F238E27FC236}">
                                          <a16:creationId xmlns:a16="http://schemas.microsoft.com/office/drawing/2014/main" id="{99070FB3-458C-B6BA-F426-7CBE7ACAB0A8}"/>
                                        </a:ext>
                                      </a:extLst>
                                    </p:cNvPr>
                                    <p:cNvGrpSpPr/>
                                    <p:nvPr/>
                                  </p:nvGrpSpPr>
                                  <p:grpSpPr>
                                    <a:xfrm>
                                      <a:off x="68366" y="378270"/>
                                      <a:ext cx="11964551" cy="2059144"/>
                                      <a:chOff x="68366" y="378270"/>
                                      <a:chExt cx="11964551" cy="2059144"/>
                                    </a:xfrm>
                                  </p:grpSpPr>
                                  <p:grpSp>
                                    <p:nvGrpSpPr>
                                      <p:cNvPr id="59" name="Csoportba foglalás 58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D69FBEC8-63C6-D8A3-6667-5AB6865BEE97}"/>
                                          </a:ext>
                                        </a:extLst>
                                      </p:cNvPr>
                                      <p:cNvGrpSpPr/>
                                      <p:nvPr/>
                                    </p:nvGrpSpPr>
                                    <p:grpSpPr>
                                      <a:xfrm>
                                        <a:off x="68366" y="378270"/>
                                        <a:ext cx="11964551" cy="2059144"/>
                                        <a:chOff x="68366" y="378270"/>
                                        <a:chExt cx="11964551" cy="2059144"/>
                                      </a:xfrm>
                                    </p:grpSpPr>
                                    <p:grpSp>
                                      <p:nvGrpSpPr>
                                        <p:cNvPr id="5" name="Csoportba foglalás 4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666EC76C-2260-6217-0624-8D898ED5A4E4}"/>
                                            </a:ext>
                                          </a:extLst>
                                        </p:cNvPr>
                                        <p:cNvGrpSpPr/>
                                        <p:nvPr/>
                                      </p:nvGrpSpPr>
                                      <p:grpSpPr>
                                        <a:xfrm>
                                          <a:off x="68366" y="378270"/>
                                          <a:ext cx="11964551" cy="2059144"/>
                                          <a:chOff x="68366" y="378270"/>
                                          <a:chExt cx="11964551" cy="2059144"/>
                                        </a:xfrm>
                                      </p:grpSpPr>
                                      <p:sp>
                                        <p:nvSpPr>
                                          <p:cNvPr id="6" name="Szövegdoboz 5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1EE92C5E-E4EC-2CEC-670B-01AFCBAF0098}"/>
                                              </a:ext>
                                            </a:extLst>
                                          </p:cNvPr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5457394" y="1528132"/>
                                            <a:ext cx="470000" cy="215444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none" rtlCol="0">
                                            <a:spAutoFit/>
                                          </a:bodyPr>
                                          <a:lstStyle/>
                                          <a:p>
                                            <a:r>
                                              <a:rPr lang="hu-HU" sz="800" dirty="0"/>
                                              <a:t>DMSO</a:t>
                                            </a:r>
                                          </a:p>
                                        </p:txBody>
                                      </p:sp>
                                      <p:sp>
                                        <p:nvSpPr>
                                          <p:cNvPr id="7" name="Szövegdoboz 6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DCA53139-B3EF-2478-66CC-2DBFD2DA811A}"/>
                                              </a:ext>
                                            </a:extLst>
                                          </p:cNvPr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5791141" y="1525040"/>
                                            <a:ext cx="457176" cy="215444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none" rtlCol="0">
                                            <a:spAutoFit/>
                                          </a:bodyPr>
                                          <a:lstStyle/>
                                          <a:p>
                                            <a:r>
                                              <a:rPr lang="hu-HU" sz="800" dirty="0"/>
                                              <a:t>UDCA</a:t>
                                            </a:r>
                                          </a:p>
                                        </p:txBody>
                                      </p:sp>
                                      <p:sp>
                                        <p:nvSpPr>
                                          <p:cNvPr id="8" name="Szövegdoboz 7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59B18E5D-9CAA-1B96-B3D8-B587D74C772B}"/>
                                              </a:ext>
                                            </a:extLst>
                                          </p:cNvPr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2255554" y="1516044"/>
                                            <a:ext cx="470000" cy="215444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none" rtlCol="0">
                                            <a:spAutoFit/>
                                          </a:bodyPr>
                                          <a:lstStyle/>
                                          <a:p>
                                            <a:r>
                                              <a:rPr lang="hu-HU" sz="800" dirty="0"/>
                                              <a:t>DMSO</a:t>
                                            </a:r>
                                          </a:p>
                                        </p:txBody>
                                      </p:sp>
                                      <p:sp>
                                        <p:nvSpPr>
                                          <p:cNvPr id="9" name="Szövegdoboz 8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CBA7CB9F-0B07-F693-FF24-6BAB2FD09EA9}"/>
                                              </a:ext>
                                            </a:extLst>
                                          </p:cNvPr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2551596" y="1522379"/>
                                            <a:ext cx="457176" cy="215444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none" rtlCol="0">
                                            <a:spAutoFit/>
                                          </a:bodyPr>
                                          <a:lstStyle/>
                                          <a:p>
                                            <a:r>
                                              <a:rPr lang="hu-HU" sz="800" dirty="0"/>
                                              <a:t>UDCA</a:t>
                                            </a:r>
                                          </a:p>
                                        </p:txBody>
                                      </p:sp>
                                      <p:sp>
                                        <p:nvSpPr>
                                          <p:cNvPr id="10" name="Szövegdoboz 9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26D52466-16B5-4210-DBA7-126A8D1CC5F2}"/>
                                              </a:ext>
                                            </a:extLst>
                                          </p:cNvPr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9446442" y="1510630"/>
                                            <a:ext cx="470000" cy="215444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none" rtlCol="0">
                                            <a:spAutoFit/>
                                          </a:bodyPr>
                                          <a:lstStyle/>
                                          <a:p>
                                            <a:r>
                                              <a:rPr lang="hu-HU" sz="800" dirty="0"/>
                                              <a:t>DMSO</a:t>
                                            </a:r>
                                          </a:p>
                                        </p:txBody>
                                      </p:sp>
                                      <p:sp>
                                        <p:nvSpPr>
                                          <p:cNvPr id="11" name="Szövegdoboz 10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E1C1C8CB-BEF3-799C-6817-7756DC67E587}"/>
                                              </a:ext>
                                            </a:extLst>
                                          </p:cNvPr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9769887" y="1514943"/>
                                            <a:ext cx="457176" cy="215444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none" rtlCol="0">
                                            <a:spAutoFit/>
                                          </a:bodyPr>
                                          <a:lstStyle/>
                                          <a:p>
                                            <a:r>
                                              <a:rPr lang="hu-HU" sz="800" dirty="0"/>
                                              <a:t>UDCA</a:t>
                                            </a:r>
                                          </a:p>
                                        </p:txBody>
                                      </p:sp>
                                      <p:grpSp>
                                        <p:nvGrpSpPr>
                                          <p:cNvPr id="13" name="Csoportba foglalás 12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F7953510-80C4-08DE-5F12-30E0E9381EFE}"/>
                                              </a:ext>
                                            </a:extLst>
                                          </p:cNvPr>
                                          <p:cNvGrpSpPr/>
                                          <p:nvPr/>
                                        </p:nvGrpSpPr>
                                        <p:grpSpPr>
                                          <a:xfrm>
                                            <a:off x="68366" y="378270"/>
                                            <a:ext cx="11964551" cy="2059144"/>
                                            <a:chOff x="68366" y="378270"/>
                                            <a:chExt cx="11964551" cy="2059144"/>
                                          </a:xfrm>
                                        </p:grpSpPr>
                                        <p:grpSp>
                                          <p:nvGrpSpPr>
                                            <p:cNvPr id="17" name="Csoportba foglalás 16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D2869022-5E02-D495-459D-4C73CF0945AD}"/>
                                                </a:ext>
                                              </a:extLst>
                                            </p:cNvPr>
                                            <p:cNvGrpSpPr/>
                                            <p:nvPr/>
                                          </p:nvGrpSpPr>
                                          <p:grpSpPr>
                                            <a:xfrm>
                                              <a:off x="68366" y="378270"/>
                                              <a:ext cx="11964551" cy="2059144"/>
                                              <a:chOff x="68366" y="378270"/>
                                              <a:chExt cx="11964551" cy="2059144"/>
                                            </a:xfrm>
                                          </p:grpSpPr>
                                          <p:sp>
                                            <p:nvSpPr>
                                              <p:cNvPr id="24" name="Szövegdoboz 23">
                                                <a:extLst>
                                                  <a:ext uri="{FF2B5EF4-FFF2-40B4-BE49-F238E27FC236}">
                                                    <a16:creationId xmlns:a16="http://schemas.microsoft.com/office/drawing/2014/main" id="{9DBE9E64-7749-5286-A934-87C2DA3328AA}"/>
                                                  </a:ext>
                                                </a:extLst>
                                              </p:cNvPr>
                                              <p:cNvSpPr txBox="1"/>
                                              <p:nvPr/>
                                            </p:nvSpPr>
                                            <p:spPr>
                                              <a:xfrm>
                                                <a:off x="5163594" y="649865"/>
                                                <a:ext cx="470000" cy="215444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</p:spPr>
                                            <p:txBody>
                                              <a:bodyPr wrap="none" rtlCol="0">
                                                <a:spAutoFit/>
                                              </a:bodyPr>
                                              <a:lstStyle/>
                                              <a:p>
                                                <a:r>
                                                  <a:rPr lang="hu-HU" sz="800" dirty="0"/>
                                                  <a:t>DMSO</a:t>
                                                </a:r>
                                              </a:p>
                                            </p:txBody>
                                          </p:sp>
                                          <p:sp>
                                            <p:nvSpPr>
                                              <p:cNvPr id="25" name="Szövegdoboz 24">
                                                <a:extLst>
                                                  <a:ext uri="{FF2B5EF4-FFF2-40B4-BE49-F238E27FC236}">
                                                    <a16:creationId xmlns:a16="http://schemas.microsoft.com/office/drawing/2014/main" id="{74AB1839-0AF7-9320-D373-719005F5B9E5}"/>
                                                  </a:ext>
                                                </a:extLst>
                                              </p:cNvPr>
                                              <p:cNvSpPr txBox="1"/>
                                              <p:nvPr/>
                                            </p:nvSpPr>
                                            <p:spPr>
                                              <a:xfrm>
                                                <a:off x="5478484" y="656200"/>
                                                <a:ext cx="457176" cy="215444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</p:spPr>
                                            <p:txBody>
                                              <a:bodyPr wrap="none" rtlCol="0">
                                                <a:spAutoFit/>
                                              </a:bodyPr>
                                              <a:lstStyle/>
                                              <a:p>
                                                <a:r>
                                                  <a:rPr lang="hu-HU" sz="800" dirty="0"/>
                                                  <a:t>UDCA</a:t>
                                                </a:r>
                                              </a:p>
                                            </p:txBody>
                                          </p:sp>
                                          <p:grpSp>
                                            <p:nvGrpSpPr>
                                              <p:cNvPr id="40" name="Csoportba foglalás 39">
                                                <a:extLst>
                                                  <a:ext uri="{FF2B5EF4-FFF2-40B4-BE49-F238E27FC236}">
                                                    <a16:creationId xmlns:a16="http://schemas.microsoft.com/office/drawing/2014/main" id="{AD74C5FA-955A-53AC-A5DE-7102165BBD28}"/>
                                                  </a:ext>
                                                </a:extLst>
                                              </p:cNvPr>
                                              <p:cNvGrpSpPr/>
                                              <p:nvPr/>
                                            </p:nvGrpSpPr>
                                            <p:grpSpPr>
                                              <a:xfrm>
                                                <a:off x="68366" y="378270"/>
                                                <a:ext cx="11964551" cy="2059144"/>
                                                <a:chOff x="68366" y="415477"/>
                                                <a:chExt cx="11964551" cy="2059144"/>
                                              </a:xfrm>
                                            </p:grpSpPr>
                                            <p:sp>
                                              <p:nvSpPr>
                                                <p:cNvPr id="45" name="Szövegdoboz 44">
                                                  <a:extLst>
                                                    <a:ext uri="{FF2B5EF4-FFF2-40B4-BE49-F238E27FC236}">
                                                      <a16:creationId xmlns:a16="http://schemas.microsoft.com/office/drawing/2014/main" id="{66D3585D-B626-E2C5-481E-54A1670C3C57}"/>
                                                    </a:ext>
                                                  </a:extLst>
                                                </p:cNvPr>
                                                <p:cNvSpPr txBox="1"/>
                                                <p:nvPr/>
                                              </p:nvSpPr>
                                              <p:spPr>
                                                <a:xfrm>
                                                  <a:off x="68367" y="1048238"/>
                                                  <a:ext cx="999857" cy="307777"/>
                                                </a:xfrm>
                                                <a:prstGeom prst="rect">
                                                  <a:avLst/>
                                                </a:prstGeom>
                                                <a:noFill/>
                                              </p:spPr>
                                              <p:txBody>
                                                <a:bodyPr wrap="square" rtlCol="0">
                                                  <a:spAutoFit/>
                                                </a:bodyPr>
                                                <a:lstStyle/>
                                                <a:p>
                                                  <a:r>
                                                    <a:rPr lang="hu-HU" sz="1400" dirty="0" err="1"/>
                                                    <a:t>Snail</a:t>
                                                  </a:r>
                                                  <a:r>
                                                    <a:rPr lang="hu-HU" sz="1400" dirty="0"/>
                                                    <a:t>:</a:t>
                                                  </a:r>
                                                </a:p>
                                              </p:txBody>
                                            </p:sp>
                                            <p:sp>
                                              <p:nvSpPr>
                                                <p:cNvPr id="46" name="Szövegdoboz 45">
                                                  <a:extLst>
                                                    <a:ext uri="{FF2B5EF4-FFF2-40B4-BE49-F238E27FC236}">
                                                      <a16:creationId xmlns:a16="http://schemas.microsoft.com/office/drawing/2014/main" id="{D28978E5-AA9F-8E23-7150-26C97BBEA88B}"/>
                                                    </a:ext>
                                                  </a:extLst>
                                                </p:cNvPr>
                                                <p:cNvSpPr txBox="1"/>
                                                <p:nvPr/>
                                              </p:nvSpPr>
                                              <p:spPr>
                                                <a:xfrm>
                                                  <a:off x="68366" y="1815547"/>
                                                  <a:ext cx="1117045" cy="307777"/>
                                                </a:xfrm>
                                                <a:prstGeom prst="rect">
                                                  <a:avLst/>
                                                </a:prstGeom>
                                                <a:noFill/>
                                              </p:spPr>
                                              <p:txBody>
                                                <a:bodyPr wrap="square" rtlCol="0">
                                                  <a:spAutoFit/>
                                                </a:bodyPr>
                                                <a:lstStyle/>
                                                <a:p>
                                                  <a:r>
                                                    <a:rPr lang="hu-HU" sz="1400" dirty="0"/>
                                                    <a:t>β-</a:t>
                                                  </a:r>
                                                  <a:r>
                                                    <a:rPr lang="hu-HU" sz="1400" dirty="0" err="1"/>
                                                    <a:t>actin</a:t>
                                                  </a:r>
                                                  <a:r>
                                                    <a:rPr lang="hu-HU" sz="1400" dirty="0"/>
                                                    <a:t>:</a:t>
                                                  </a:r>
                                                </a:p>
                                              </p:txBody>
                                            </p:sp>
                                            <p:grpSp>
                                              <p:nvGrpSpPr>
                                                <p:cNvPr id="47" name="Csoportba foglalás 46">
                                                  <a:extLst>
                                                    <a:ext uri="{FF2B5EF4-FFF2-40B4-BE49-F238E27FC236}">
                                                      <a16:creationId xmlns:a16="http://schemas.microsoft.com/office/drawing/2014/main" id="{ECC78131-FA46-9B9E-121A-F2AFAC1773DF}"/>
                                                    </a:ext>
                                                  </a:extLst>
                                                </p:cNvPr>
                                                <p:cNvGrpSpPr/>
                                                <p:nvPr/>
                                              </p:nvGrpSpPr>
                                              <p:grpSpPr>
                                                <a:xfrm>
                                                  <a:off x="2329402" y="415641"/>
                                                  <a:ext cx="800663" cy="490549"/>
                                                  <a:chOff x="2329402" y="415641"/>
                                                  <a:chExt cx="800663" cy="490549"/>
                                                </a:xfrm>
                                              </p:grpSpPr>
                                              <p:grpSp>
                                                <p:nvGrpSpPr>
                                                  <p:cNvPr id="51" name="Csoportba foglalás 50">
                                                    <a:extLst>
                                                      <a:ext uri="{FF2B5EF4-FFF2-40B4-BE49-F238E27FC236}">
                                                        <a16:creationId xmlns:a16="http://schemas.microsoft.com/office/drawing/2014/main" id="{D1F86804-959C-FDB1-6496-7E5C944541AE}"/>
                                                      </a:ext>
                                                    </a:extLst>
                                                  </p:cNvPr>
                                                  <p:cNvGrpSpPr/>
                                                  <p:nvPr/>
                                                </p:nvGrpSpPr>
                                                <p:grpSpPr>
                                                  <a:xfrm>
                                                    <a:off x="2329402" y="684411"/>
                                                    <a:ext cx="753217" cy="221779"/>
                                                    <a:chOff x="2329402" y="308401"/>
                                                    <a:chExt cx="753217" cy="221779"/>
                                                  </a:xfrm>
                                                </p:grpSpPr>
                                                <p:sp>
                                                  <p:nvSpPr>
                                                    <p:cNvPr id="53" name="Szövegdoboz 52">
                                                      <a:extLst>
                                                        <a:ext uri="{FF2B5EF4-FFF2-40B4-BE49-F238E27FC236}">
                                                          <a16:creationId xmlns:a16="http://schemas.microsoft.com/office/drawing/2014/main" id="{4185ACB4-2E26-53E4-7817-E9EC98D80B21}"/>
                                                        </a:ext>
                                                      </a:extLst>
                                                    </p:cNvPr>
                                                    <p:cNvSpPr txBox="1"/>
                                                    <p:nvPr/>
                                                  </p:nvSpPr>
                                                  <p:spPr>
                                                    <a:xfrm>
                                                      <a:off x="2329402" y="308401"/>
                                                      <a:ext cx="470000" cy="215444"/>
                                                    </a:xfrm>
                                                    <a:prstGeom prst="rect">
                                                      <a:avLst/>
                                                    </a:prstGeom>
                                                    <a:noFill/>
                                                  </p:spPr>
                                                  <p:txBody>
                                                    <a:bodyPr wrap="none" rtlCol="0">
                                                      <a:spAutoFit/>
                                                    </a:bodyPr>
                                                    <a:lstStyle/>
                                                    <a:p>
                                                      <a:r>
                                                        <a:rPr lang="hu-HU" sz="800" dirty="0"/>
                                                        <a:t>DMSO</a:t>
                                                      </a:r>
                                                    </a:p>
                                                  </p:txBody>
                                                </p:sp>
                                                <p:sp>
                                                  <p:nvSpPr>
                                                    <p:cNvPr id="54" name="Szövegdoboz 53">
                                                      <a:extLst>
                                                        <a:ext uri="{FF2B5EF4-FFF2-40B4-BE49-F238E27FC236}">
                                                          <a16:creationId xmlns:a16="http://schemas.microsoft.com/office/drawing/2014/main" id="{FBEA5532-CAE2-88D1-FBDE-A57D01FAD56E}"/>
                                                        </a:ext>
                                                      </a:extLst>
                                                    </p:cNvPr>
                                                    <p:cNvSpPr txBox="1"/>
                                                    <p:nvPr/>
                                                  </p:nvSpPr>
                                                  <p:spPr>
                                                    <a:xfrm>
                                                      <a:off x="2625443" y="314736"/>
                                                      <a:ext cx="457176" cy="215444"/>
                                                    </a:xfrm>
                                                    <a:prstGeom prst="rect">
                                                      <a:avLst/>
                                                    </a:prstGeom>
                                                    <a:noFill/>
                                                  </p:spPr>
                                                  <p:txBody>
                                                    <a:bodyPr wrap="none" rtlCol="0">
                                                      <a:spAutoFit/>
                                                    </a:bodyPr>
                                                    <a:lstStyle/>
                                                    <a:p>
                                                      <a:r>
                                                        <a:rPr lang="hu-HU" sz="800" dirty="0"/>
                                                        <a:t>UDCA</a:t>
                                                      </a:r>
                                                    </a:p>
                                                  </p:txBody>
                                                </p:sp>
                                              </p:grpSp>
                                              <p:sp>
                                                <p:nvSpPr>
                                                  <p:cNvPr id="52" name="Szövegdoboz 51">
                                                    <a:extLst>
                                                      <a:ext uri="{FF2B5EF4-FFF2-40B4-BE49-F238E27FC236}">
                                                        <a16:creationId xmlns:a16="http://schemas.microsoft.com/office/drawing/2014/main" id="{87C03FB1-0305-6610-B2F8-3AF2F9687DAF}"/>
                                                      </a:ext>
                                                    </a:extLst>
                                                  </p:cNvPr>
                                                  <p:cNvSpPr txBox="1"/>
                                                  <p:nvPr/>
                                                </p:nvSpPr>
                                                <p:spPr>
                                                  <a:xfrm>
                                                    <a:off x="2797923" y="415641"/>
                                                    <a:ext cx="332142" cy="307777"/>
                                                  </a:xfrm>
                                                  <a:prstGeom prst="rect">
                                                    <a:avLst/>
                                                  </a:prstGeom>
                                                  <a:noFill/>
                                                </p:spPr>
                                                <p:txBody>
                                                  <a:bodyPr wrap="none" rtlCol="0">
                                                    <a:spAutoFit/>
                                                  </a:bodyPr>
                                                  <a:lstStyle/>
                                                  <a:p>
                                                    <a:r>
                                                      <a:rPr lang="hu-HU" sz="1400" b="1" dirty="0"/>
                                                      <a:t>1.</a:t>
                                                    </a:r>
                                                  </a:p>
                                                </p:txBody>
                                              </p:sp>
                                            </p:grpSp>
                                            <p:sp>
                                              <p:nvSpPr>
                                                <p:cNvPr id="48" name="Szövegdoboz 47">
                                                  <a:extLst>
                                                    <a:ext uri="{FF2B5EF4-FFF2-40B4-BE49-F238E27FC236}">
                                                      <a16:creationId xmlns:a16="http://schemas.microsoft.com/office/drawing/2014/main" id="{FF8775A9-DE28-A990-FA6B-A5EA7988A5B4}"/>
                                                    </a:ext>
                                                  </a:extLst>
                                                </p:cNvPr>
                                                <p:cNvSpPr txBox="1"/>
                                                <p:nvPr/>
                                              </p:nvSpPr>
                                              <p:spPr>
                                                <a:xfrm>
                                                  <a:off x="6271647" y="416294"/>
                                                  <a:ext cx="335348" cy="307777"/>
                                                </a:xfrm>
                                                <a:prstGeom prst="rect">
                                                  <a:avLst/>
                                                </a:prstGeom>
                                                <a:noFill/>
                                              </p:spPr>
                                              <p:txBody>
                                                <a:bodyPr wrap="none" rtlCol="0">
                                                  <a:spAutoFit/>
                                                </a:bodyPr>
                                                <a:lstStyle/>
                                                <a:p>
                                                  <a:r>
                                                    <a:rPr lang="hu-HU" sz="1400" b="1" dirty="0"/>
                                                    <a:t>2.</a:t>
                                                  </a:r>
                                                </a:p>
                                              </p:txBody>
                                            </p:sp>
                                            <p:sp>
                                              <p:nvSpPr>
                                                <p:cNvPr id="49" name="Szövegdoboz 48">
                                                  <a:extLst>
                                                    <a:ext uri="{FF2B5EF4-FFF2-40B4-BE49-F238E27FC236}">
                                                      <a16:creationId xmlns:a16="http://schemas.microsoft.com/office/drawing/2014/main" id="{D9333B53-470F-176B-2960-30B707B78615}"/>
                                                    </a:ext>
                                                  </a:extLst>
                                                </p:cNvPr>
                                                <p:cNvSpPr txBox="1"/>
                                                <p:nvPr/>
                                              </p:nvSpPr>
                                              <p:spPr>
                                                <a:xfrm>
                                                  <a:off x="10016820" y="415477"/>
                                                  <a:ext cx="335348" cy="307777"/>
                                                </a:xfrm>
                                                <a:prstGeom prst="rect">
                                                  <a:avLst/>
                                                </a:prstGeom>
                                                <a:noFill/>
                                              </p:spPr>
                                              <p:txBody>
                                                <a:bodyPr wrap="none" rtlCol="0">
                                                  <a:spAutoFit/>
                                                </a:bodyPr>
                                                <a:lstStyle/>
                                                <a:p>
                                                  <a:r>
                                                    <a:rPr lang="hu-HU" sz="1400" b="1" dirty="0"/>
                                                    <a:t>3.</a:t>
                                                  </a:r>
                                                </a:p>
                                              </p:txBody>
                                            </p:sp>
                                            <p:sp>
                                              <p:nvSpPr>
                                                <p:cNvPr id="50" name="Téglalap 49">
                                                  <a:extLst>
                                                    <a:ext uri="{FF2B5EF4-FFF2-40B4-BE49-F238E27FC236}">
                                                      <a16:creationId xmlns:a16="http://schemas.microsoft.com/office/drawing/2014/main" id="{7EE5AF85-79AD-2E88-859A-74FA3BC508C3}"/>
                                                    </a:ext>
                                                  </a:extLst>
                                                </p:cNvPr>
                                                <p:cNvSpPr/>
                                                <p:nvPr/>
                                              </p:nvSpPr>
                                              <p:spPr>
                                                <a:xfrm>
                                                  <a:off x="70822" y="474905"/>
                                                  <a:ext cx="11962095" cy="1999716"/>
                                                </a:xfrm>
                                                <a:prstGeom prst="rect">
                                                  <a:avLst/>
                                                </a:prstGeom>
                                                <a:noFill/>
                                              </p:spPr>
                                              <p:style>
                                                <a:lnRef idx="2">
                                                  <a:schemeClr val="accent1">
                                                    <a:shade val="15000"/>
                                                  </a:schemeClr>
                                                </a:lnRef>
                                                <a:fillRef idx="1">
                                                  <a:schemeClr val="accent1"/>
                                                </a:fillRef>
                                                <a:effectRef idx="0">
                                                  <a:schemeClr val="accent1"/>
                                                </a:effectRef>
                                                <a:fontRef idx="minor">
                                                  <a:schemeClr val="lt1"/>
                                                </a:fontRef>
                                              </p:style>
                                              <p:txBody>
                                                <a:bodyPr rtlCol="0" anchor="ctr"/>
                                                <a:lstStyle/>
                                                <a:p>
                                                  <a:pPr algn="ctr"/>
                                                  <a:endParaRPr lang="hu-HU"/>
                                                </a:p>
                                              </p:txBody>
                                            </p:sp>
                                          </p:grpSp>
                                        </p:grpSp>
                                        <p:sp>
                                          <p:nvSpPr>
                                            <p:cNvPr id="19" name="Szövegdoboz 18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BF3BA821-64F9-7542-13DC-3694C7DD53BF}"/>
                                                </a:ext>
                                              </a:extLst>
                                            </p:cNvPr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9397738" y="604082"/>
                                              <a:ext cx="470000" cy="215444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non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r>
                                                <a:rPr lang="hu-HU" sz="800" dirty="0"/>
                                                <a:t>DMSO</a:t>
                                              </a:r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20" name="Szövegdoboz 19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BFA7C2B5-D68F-0DB7-73EE-E123146A0886}"/>
                                                </a:ext>
                                              </a:extLst>
                                            </p:cNvPr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9702336" y="608395"/>
                                              <a:ext cx="457176" cy="215444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non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r>
                                                <a:rPr lang="hu-HU" sz="800" dirty="0"/>
                                                <a:t>UDCA</a:t>
                                              </a:r>
                                            </a:p>
                                          </p:txBody>
                                        </p:sp>
                                      </p:grpSp>
                                    </p:grpSp>
                                    <p:sp>
                                      <p:nvSpPr>
                                        <p:cNvPr id="58" name="Szövegdoboz 57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0FA3A88A-7BFD-0A39-C497-4857235015E0}"/>
                                            </a:ext>
                                          </a:extLst>
                                        </p:cNvPr>
                                        <p:cNvSpPr txBox="1"/>
                                        <p:nvPr/>
                                      </p:nvSpPr>
                                      <p:spPr>
                                        <a:xfrm>
                                          <a:off x="1499097" y="912658"/>
                                          <a:ext cx="293670" cy="215444"/>
                                        </a:xfrm>
                                        <a:prstGeom prst="rect">
                                          <a:avLst/>
                                        </a:prstGeom>
                                        <a:noFill/>
                                      </p:spPr>
                                      <p:txBody>
                                        <a:bodyPr wrap="none" rtlCol="0">
                                          <a:spAutoFit/>
                                        </a:bodyPr>
                                        <a:lstStyle/>
                                        <a:p>
                                          <a:r>
                                            <a:rPr lang="hu-HU" sz="800" dirty="0"/>
                                            <a:t>35</a:t>
                                          </a:r>
                                        </a:p>
                                      </p:txBody>
                                    </p:sp>
                                  </p:grpSp>
                                  <p:sp>
                                    <p:nvSpPr>
                                      <p:cNvPr id="63" name="Szövegdoboz 62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1C6F6342-181D-2A47-4D70-C59B7A57178E}"/>
                                          </a:ext>
                                        </a:extLst>
                                      </p:cNvPr>
                                      <p:cNvSpPr txBox="1"/>
                                      <p:nvPr/>
                                    </p:nvSpPr>
                                    <p:spPr>
                                      <a:xfrm>
                                        <a:off x="1491238" y="1696650"/>
                                        <a:ext cx="293670" cy="215444"/>
                                      </a:xfrm>
                                      <a:prstGeom prst="rect">
                                        <a:avLst/>
                                      </a:prstGeom>
                                      <a:noFill/>
                                    </p:spPr>
                                    <p:txBody>
                                      <a:bodyPr wrap="none" rtlCol="0">
                                        <a:spAutoFit/>
                                      </a:bodyPr>
                                      <a:lstStyle/>
                                      <a:p>
                                        <a:r>
                                          <a:rPr lang="hu-HU" sz="800" dirty="0"/>
                                          <a:t>55</a:t>
                                        </a:r>
                                      </a:p>
                                    </p:txBody>
                                  </p:sp>
                                </p:grpSp>
                                <p:sp>
                                  <p:nvSpPr>
                                    <p:cNvPr id="68" name="Szövegdoboz 67">
                                      <a:extLst>
                                        <a:ext uri="{FF2B5EF4-FFF2-40B4-BE49-F238E27FC236}">
                                          <a16:creationId xmlns:a16="http://schemas.microsoft.com/office/drawing/2014/main" id="{8DBE66C4-12F2-DD57-ECF1-DA0D24D51BFB}"/>
                                        </a:ext>
                                      </a:extLst>
                                    </p:cNvPr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4968994" y="1274708"/>
                                      <a:ext cx="293670" cy="2154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none" rtlCol="0">
                                      <a:spAutoFit/>
                                    </a:bodyPr>
                                    <a:lstStyle/>
                                    <a:p>
                                      <a:r>
                                        <a:rPr lang="hu-HU" sz="800" dirty="0"/>
                                        <a:t>25</a:t>
                                      </a:r>
                                    </a:p>
                                  </p:txBody>
                                </p:sp>
                                <p:sp>
                                  <p:nvSpPr>
                                    <p:cNvPr id="69" name="Szövegdoboz 68">
                                      <a:extLst>
                                        <a:ext uri="{FF2B5EF4-FFF2-40B4-BE49-F238E27FC236}">
                                          <a16:creationId xmlns:a16="http://schemas.microsoft.com/office/drawing/2014/main" id="{BCBE7002-9572-864F-B271-4C392B6D54C9}"/>
                                        </a:ext>
                                      </a:extLst>
                                    </p:cNvPr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4970562" y="833216"/>
                                      <a:ext cx="293670" cy="2154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none" rtlCol="0">
                                      <a:spAutoFit/>
                                    </a:bodyPr>
                                    <a:lstStyle/>
                                    <a:p>
                                      <a:r>
                                        <a:rPr lang="hu-HU" sz="800" dirty="0"/>
                                        <a:t>35</a:t>
                                      </a:r>
                                    </a:p>
                                  </p:txBody>
                                </p:sp>
                              </p:grpSp>
                              <p:sp>
                                <p:nvSpPr>
                                  <p:cNvPr id="74" name="Szövegdoboz 73">
                                    <a:extLst>
                                      <a:ext uri="{FF2B5EF4-FFF2-40B4-BE49-F238E27FC236}">
                                        <a16:creationId xmlns:a16="http://schemas.microsoft.com/office/drawing/2014/main" id="{3B0CFB52-98AD-0BAE-3F2B-AA20920D756B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4961135" y="2068132"/>
                                    <a:ext cx="293670" cy="215444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hu-HU" sz="800" dirty="0"/>
                                      <a:t>35</a:t>
                                    </a:r>
                                  </a:p>
                                </p:txBody>
                              </p:sp>
                              <p:sp>
                                <p:nvSpPr>
                                  <p:cNvPr id="75" name="Szövegdoboz 74">
                                    <a:extLst>
                                      <a:ext uri="{FF2B5EF4-FFF2-40B4-BE49-F238E27FC236}">
                                        <a16:creationId xmlns:a16="http://schemas.microsoft.com/office/drawing/2014/main" id="{CA52119A-7028-EC42-B001-B72931896E94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4962703" y="1654921"/>
                                    <a:ext cx="293670" cy="215444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hu-HU" sz="800" dirty="0"/>
                                      <a:t>55</a:t>
                                    </a:r>
                                  </a:p>
                                </p:txBody>
                              </p:sp>
                            </p:grpSp>
                            <p:sp>
                              <p:nvSpPr>
                                <p:cNvPr id="80" name="Szövegdoboz 79">
                                  <a:extLst>
                                    <a:ext uri="{FF2B5EF4-FFF2-40B4-BE49-F238E27FC236}">
                                      <a16:creationId xmlns:a16="http://schemas.microsoft.com/office/drawing/2014/main" id="{BE0AE24B-F7DA-5C43-7207-DD5032C6A0E0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8628166" y="1643919"/>
                                  <a:ext cx="293670" cy="215444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non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800" dirty="0"/>
                                    <a:t>55</a:t>
                                  </a:r>
                                </a:p>
                              </p:txBody>
                            </p:sp>
                          </p:grpSp>
                          <p:sp>
                            <p:nvSpPr>
                              <p:cNvPr id="32" name="Szövegdoboz 31">
                                <a:extLst>
                                  <a:ext uri="{FF2B5EF4-FFF2-40B4-BE49-F238E27FC236}">
                                    <a16:creationId xmlns:a16="http://schemas.microsoft.com/office/drawing/2014/main" id="{4E50FDCC-5278-358B-F6B8-D5CD847F8219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1483379" y="2150710"/>
                                <a:ext cx="293670" cy="215444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r>
                                  <a:rPr lang="hu-HU" sz="800" dirty="0"/>
                                  <a:t>35</a:t>
                                </a:r>
                              </a:p>
                            </p:txBody>
                          </p:sp>
                        </p:grpSp>
                        <p:sp>
                          <p:nvSpPr>
                            <p:cNvPr id="38" name="Szövegdoboz 37">
                              <a:extLst>
                                <a:ext uri="{FF2B5EF4-FFF2-40B4-BE49-F238E27FC236}">
                                  <a16:creationId xmlns:a16="http://schemas.microsoft.com/office/drawing/2014/main" id="{E16B3E01-124D-D197-00C9-8DFEA7036688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8627333" y="763394"/>
                              <a:ext cx="293670" cy="215444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r>
                                <a:rPr lang="hu-HU" sz="800" dirty="0"/>
                                <a:t>35</a:t>
                              </a:r>
                            </a:p>
                          </p:txBody>
                        </p:sp>
                        <p:sp>
                          <p:nvSpPr>
                            <p:cNvPr id="43" name="Szövegdoboz 42">
                              <a:extLst>
                                <a:ext uri="{FF2B5EF4-FFF2-40B4-BE49-F238E27FC236}">
                                  <a16:creationId xmlns:a16="http://schemas.microsoft.com/office/drawing/2014/main" id="{546524FE-6B32-7EA5-0C2D-A5917FA4A87F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8621044" y="1228453"/>
                              <a:ext cx="293670" cy="215444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r>
                                <a:rPr lang="hu-HU" sz="800" dirty="0"/>
                                <a:t>25</a:t>
                              </a:r>
                            </a:p>
                          </p:txBody>
                        </p:sp>
                      </p:grpSp>
                      <p:sp>
                        <p:nvSpPr>
                          <p:cNvPr id="73" name="Szövegdoboz 72">
                            <a:extLst>
                              <a:ext uri="{FF2B5EF4-FFF2-40B4-BE49-F238E27FC236}">
                                <a16:creationId xmlns:a16="http://schemas.microsoft.com/office/drawing/2014/main" id="{8C45F1EF-436E-B74A-BAF6-0C9C20D9DD4E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8621039" y="2105143"/>
                            <a:ext cx="293670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hu-HU" sz="800" dirty="0"/>
                              <a:t>35</a:t>
                            </a:r>
                          </a:p>
                        </p:txBody>
                      </p:sp>
                    </p:grpSp>
                    <p:pic>
                      <p:nvPicPr>
                        <p:cNvPr id="12" name="Kép 11" descr="A képen fekete, monokróm, fekete-fehér, Monokróm fényképezés látható&#10;&#10;Automatikusan generált leírás">
                          <a:extLst>
                            <a:ext uri="{FF2B5EF4-FFF2-40B4-BE49-F238E27FC236}">
                              <a16:creationId xmlns:a16="http://schemas.microsoft.com/office/drawing/2014/main" id="{4871979B-E955-BC8D-6718-0693E198E3FC}"/>
                            </a:ext>
                          </a:extLst>
                        </p:cNvPr>
                        <p:cNvPicPr>
                          <a:picLocks/>
                        </p:cNvPicPr>
                        <p:nvPr/>
                      </p:nvPicPr>
                      <p:blipFill>
                        <a:blip r:embed="rId2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tretch>
                          <a:fillRect/>
                        </a:stretch>
                      </p:blipFill>
                      <p:spPr>
                        <a:xfrm>
                          <a:off x="1803780" y="877479"/>
                          <a:ext cx="2340000" cy="540000"/>
                        </a:xfrm>
                        <a:prstGeom prst="rect">
                          <a:avLst/>
                        </a:prstGeom>
                        <a:ln w="9525">
                          <a:solidFill>
                            <a:schemeClr val="tx1"/>
                          </a:solidFill>
                        </a:ln>
                      </p:spPr>
                    </p:pic>
                  </p:grpSp>
                  <p:sp>
                    <p:nvSpPr>
                      <p:cNvPr id="31" name="Szövegdoboz 30">
                        <a:extLst>
                          <a:ext uri="{FF2B5EF4-FFF2-40B4-BE49-F238E27FC236}">
                            <a16:creationId xmlns:a16="http://schemas.microsoft.com/office/drawing/2014/main" id="{A685FF3C-507F-75A2-2AAE-AADB4322394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500665" y="1263025"/>
                        <a:ext cx="29367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hu-HU" sz="800" dirty="0"/>
                          <a:t>25</a:t>
                        </a:r>
                      </a:p>
                    </p:txBody>
                  </p:sp>
                </p:grpSp>
                <p:pic>
                  <p:nvPicPr>
                    <p:cNvPr id="44" name="Kép 43">
                      <a:extLst>
                        <a:ext uri="{FF2B5EF4-FFF2-40B4-BE49-F238E27FC236}">
                          <a16:creationId xmlns:a16="http://schemas.microsoft.com/office/drawing/2014/main" id="{32D6D1F6-6871-AC42-6ABD-5DBFB0C2BE09}"/>
                        </a:ext>
                      </a:extLst>
                    </p:cNvPr>
                    <p:cNvPicPr>
                      <a:picLocks/>
                    </p:cNvPicPr>
                    <p:nvPr/>
                  </p:nvPicPr>
                  <p:blipFill>
                    <a:blip r:embed="rId3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1793868" y="1746319"/>
                      <a:ext cx="2340000" cy="540000"/>
                    </a:xfrm>
                    <a:prstGeom prst="rect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</p:pic>
              </p:grpSp>
              <p:pic>
                <p:nvPicPr>
                  <p:cNvPr id="78" name="Kép 77" descr="A képen fekete, fekete-fehér, monokróm, Monokróm fényképezés látható&#10;&#10;Automatikusan generált leírás">
                    <a:extLst>
                      <a:ext uri="{FF2B5EF4-FFF2-40B4-BE49-F238E27FC236}">
                        <a16:creationId xmlns:a16="http://schemas.microsoft.com/office/drawing/2014/main" id="{73104230-44A5-C363-02DE-F2133300571D}"/>
                      </a:ext>
                    </a:extLst>
                  </p:cNvPr>
                  <p:cNvPicPr>
                    <a:picLocks/>
                  </p:cNvPicPr>
                  <p:nvPr/>
                </p:nvPicPr>
                <p:blipFill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269321" y="877479"/>
                    <a:ext cx="2340000" cy="540000"/>
                  </a:xfrm>
                  <a:prstGeom prst="rect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</p:pic>
            </p:grpSp>
            <p:pic>
              <p:nvPicPr>
                <p:cNvPr id="89" name="Kép 88" descr="A képen fekete-fehér, fekete, monokróm, Monokróm fényképezés látható&#10;&#10;Automatikusan generált leírás">
                  <a:extLst>
                    <a:ext uri="{FF2B5EF4-FFF2-40B4-BE49-F238E27FC236}">
                      <a16:creationId xmlns:a16="http://schemas.microsoft.com/office/drawing/2014/main" id="{23CB9058-1738-C138-0B15-0176C8D84894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269321" y="1746319"/>
                  <a:ext cx="2340000" cy="540000"/>
                </a:xfrm>
                <a:prstGeom prst="rect">
                  <a:avLst/>
                </a:prstGeom>
                <a:ln w="9525">
                  <a:solidFill>
                    <a:schemeClr val="tx1"/>
                  </a:solidFill>
                </a:ln>
              </p:spPr>
            </p:pic>
          </p:grpSp>
          <p:pic>
            <p:nvPicPr>
              <p:cNvPr id="97" name="Kép 96" descr="A képen fekete, fekete-fehér, monokróm, Monokróm fényképezés látható&#10;&#10;Automatikusan generált leírás">
                <a:extLst>
                  <a:ext uri="{FF2B5EF4-FFF2-40B4-BE49-F238E27FC236}">
                    <a16:creationId xmlns:a16="http://schemas.microsoft.com/office/drawing/2014/main" id="{00D48C76-8CBC-0C88-E1C0-71AF161010B2}"/>
                  </a:ext>
                </a:extLst>
              </p:cNvPr>
              <p:cNvPicPr>
                <a:picLocks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928370" y="831826"/>
                <a:ext cx="2340000" cy="540000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</p:grpSp>
        <p:pic>
          <p:nvPicPr>
            <p:cNvPr id="100" name="Kép 99" descr="A képen fekete-fehér, fekete, monokróm, Monokróm fényképezés látható&#10;&#10;Automatikusan generált leírás">
              <a:extLst>
                <a:ext uri="{FF2B5EF4-FFF2-40B4-BE49-F238E27FC236}">
                  <a16:creationId xmlns:a16="http://schemas.microsoft.com/office/drawing/2014/main" id="{999C0485-FB58-CA1D-7167-9CC320473A2F}"/>
                </a:ext>
              </a:extLst>
            </p:cNvPr>
            <p:cNvPicPr>
              <a:picLocks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928370" y="1746319"/>
              <a:ext cx="2340000" cy="540000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</p:grpSp>
      <p:grpSp>
        <p:nvGrpSpPr>
          <p:cNvPr id="61" name="Csoportba foglalás 60">
            <a:extLst>
              <a:ext uri="{FF2B5EF4-FFF2-40B4-BE49-F238E27FC236}">
                <a16:creationId xmlns:a16="http://schemas.microsoft.com/office/drawing/2014/main" id="{685086F7-2BEF-0472-1E98-768387F6A7B6}"/>
              </a:ext>
            </a:extLst>
          </p:cNvPr>
          <p:cNvGrpSpPr/>
          <p:nvPr/>
        </p:nvGrpSpPr>
        <p:grpSpPr>
          <a:xfrm>
            <a:off x="69594" y="3303048"/>
            <a:ext cx="11964550" cy="2062084"/>
            <a:chOff x="69594" y="2505301"/>
            <a:chExt cx="11964550" cy="2062084"/>
          </a:xfrm>
        </p:grpSpPr>
        <p:grpSp>
          <p:nvGrpSpPr>
            <p:cNvPr id="62" name="Csoportba foglalás 61">
              <a:extLst>
                <a:ext uri="{FF2B5EF4-FFF2-40B4-BE49-F238E27FC236}">
                  <a16:creationId xmlns:a16="http://schemas.microsoft.com/office/drawing/2014/main" id="{549D8BA3-8171-8804-B7D9-134A74260D3B}"/>
                </a:ext>
              </a:extLst>
            </p:cNvPr>
            <p:cNvGrpSpPr/>
            <p:nvPr/>
          </p:nvGrpSpPr>
          <p:grpSpPr>
            <a:xfrm>
              <a:off x="69594" y="2505301"/>
              <a:ext cx="11964550" cy="2062084"/>
              <a:chOff x="69594" y="2505301"/>
              <a:chExt cx="11964550" cy="2062084"/>
            </a:xfrm>
          </p:grpSpPr>
          <p:grpSp>
            <p:nvGrpSpPr>
              <p:cNvPr id="72" name="Csoportba foglalás 71">
                <a:extLst>
                  <a:ext uri="{FF2B5EF4-FFF2-40B4-BE49-F238E27FC236}">
                    <a16:creationId xmlns:a16="http://schemas.microsoft.com/office/drawing/2014/main" id="{C7862EE5-81E8-F8E4-25F9-F1B426ABC3EB}"/>
                  </a:ext>
                </a:extLst>
              </p:cNvPr>
              <p:cNvGrpSpPr/>
              <p:nvPr/>
            </p:nvGrpSpPr>
            <p:grpSpPr>
              <a:xfrm>
                <a:off x="69594" y="2505301"/>
                <a:ext cx="11964550" cy="2062084"/>
                <a:chOff x="69594" y="2505301"/>
                <a:chExt cx="11964550" cy="2062084"/>
              </a:xfrm>
            </p:grpSpPr>
            <p:grpSp>
              <p:nvGrpSpPr>
                <p:cNvPr id="83" name="Csoportba foglalás 82">
                  <a:extLst>
                    <a:ext uri="{FF2B5EF4-FFF2-40B4-BE49-F238E27FC236}">
                      <a16:creationId xmlns:a16="http://schemas.microsoft.com/office/drawing/2014/main" id="{9CA451FC-2518-63DD-52A9-CBEEE489DE3D}"/>
                    </a:ext>
                  </a:extLst>
                </p:cNvPr>
                <p:cNvGrpSpPr/>
                <p:nvPr/>
              </p:nvGrpSpPr>
              <p:grpSpPr>
                <a:xfrm>
                  <a:off x="69594" y="2505301"/>
                  <a:ext cx="11964550" cy="2062084"/>
                  <a:chOff x="69594" y="2505301"/>
                  <a:chExt cx="11964550" cy="2062084"/>
                </a:xfrm>
              </p:grpSpPr>
              <p:grpSp>
                <p:nvGrpSpPr>
                  <p:cNvPr id="86" name="Csoportba foglalás 85">
                    <a:extLst>
                      <a:ext uri="{FF2B5EF4-FFF2-40B4-BE49-F238E27FC236}">
                        <a16:creationId xmlns:a16="http://schemas.microsoft.com/office/drawing/2014/main" id="{1E2DA457-DA07-3C7A-CDF8-8A6204B835F4}"/>
                      </a:ext>
                    </a:extLst>
                  </p:cNvPr>
                  <p:cNvGrpSpPr/>
                  <p:nvPr/>
                </p:nvGrpSpPr>
                <p:grpSpPr>
                  <a:xfrm>
                    <a:off x="69594" y="2505301"/>
                    <a:ext cx="11964550" cy="2062084"/>
                    <a:chOff x="69594" y="2505301"/>
                    <a:chExt cx="11964550" cy="2062084"/>
                  </a:xfrm>
                </p:grpSpPr>
                <p:grpSp>
                  <p:nvGrpSpPr>
                    <p:cNvPr id="90" name="Csoportba foglalás 89">
                      <a:extLst>
                        <a:ext uri="{FF2B5EF4-FFF2-40B4-BE49-F238E27FC236}">
                          <a16:creationId xmlns:a16="http://schemas.microsoft.com/office/drawing/2014/main" id="{6BC8E7C1-2DFC-30E6-2FDD-0B0EA13DBF2E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9594" y="2505301"/>
                      <a:ext cx="11964550" cy="2062084"/>
                      <a:chOff x="69594" y="2505301"/>
                      <a:chExt cx="11964550" cy="2062084"/>
                    </a:xfrm>
                  </p:grpSpPr>
                  <p:grpSp>
                    <p:nvGrpSpPr>
                      <p:cNvPr id="95" name="Csoportba foglalás 94">
                        <a:extLst>
                          <a:ext uri="{FF2B5EF4-FFF2-40B4-BE49-F238E27FC236}">
                            <a16:creationId xmlns:a16="http://schemas.microsoft.com/office/drawing/2014/main" id="{FBA3CB69-96FF-5B3C-6641-A18589833897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69594" y="2505301"/>
                        <a:ext cx="11964550" cy="2062084"/>
                        <a:chOff x="69594" y="2505301"/>
                        <a:chExt cx="11964550" cy="2062084"/>
                      </a:xfrm>
                    </p:grpSpPr>
                    <p:grpSp>
                      <p:nvGrpSpPr>
                        <p:cNvPr id="102" name="Csoportba foglalás 101">
                          <a:extLst>
                            <a:ext uri="{FF2B5EF4-FFF2-40B4-BE49-F238E27FC236}">
                              <a16:creationId xmlns:a16="http://schemas.microsoft.com/office/drawing/2014/main" id="{7DCFBDDE-F0A6-8061-6270-CDBEE4C7E0C7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69594" y="2505301"/>
                          <a:ext cx="11964550" cy="2062084"/>
                          <a:chOff x="69594" y="2505301"/>
                          <a:chExt cx="11964550" cy="2062084"/>
                        </a:xfrm>
                      </p:grpSpPr>
                      <p:grpSp>
                        <p:nvGrpSpPr>
                          <p:cNvPr id="104" name="Csoportba foglalás 103">
                            <a:extLst>
                              <a:ext uri="{FF2B5EF4-FFF2-40B4-BE49-F238E27FC236}">
                                <a16:creationId xmlns:a16="http://schemas.microsoft.com/office/drawing/2014/main" id="{FF04FF68-6B71-645B-AE51-7A1141AA3B01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69594" y="2505301"/>
                            <a:ext cx="11964550" cy="2062084"/>
                            <a:chOff x="69594" y="2505301"/>
                            <a:chExt cx="11964550" cy="2062084"/>
                          </a:xfrm>
                        </p:grpSpPr>
                        <p:grpSp>
                          <p:nvGrpSpPr>
                            <p:cNvPr id="107" name="Csoportba foglalás 106">
                              <a:extLst>
                                <a:ext uri="{FF2B5EF4-FFF2-40B4-BE49-F238E27FC236}">
                                  <a16:creationId xmlns:a16="http://schemas.microsoft.com/office/drawing/2014/main" id="{936D8384-80DA-BC2D-79C1-9212F401AD41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69594" y="2505301"/>
                              <a:ext cx="11964550" cy="2062084"/>
                              <a:chOff x="69594" y="2505301"/>
                              <a:chExt cx="11964550" cy="2062084"/>
                            </a:xfrm>
                          </p:grpSpPr>
                          <p:grpSp>
                            <p:nvGrpSpPr>
                              <p:cNvPr id="109" name="Csoportba foglalás 108">
                                <a:extLst>
                                  <a:ext uri="{FF2B5EF4-FFF2-40B4-BE49-F238E27FC236}">
                                    <a16:creationId xmlns:a16="http://schemas.microsoft.com/office/drawing/2014/main" id="{7602B8A9-C4C8-5FA5-AB06-75D52AD4710F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69594" y="2505301"/>
                                <a:ext cx="11964550" cy="2062084"/>
                                <a:chOff x="69594" y="2505301"/>
                                <a:chExt cx="11964550" cy="2062084"/>
                              </a:xfrm>
                            </p:grpSpPr>
                            <p:pic>
                              <p:nvPicPr>
                                <p:cNvPr id="111" name="Kép 110" descr="A képen fehér, fekete, fekete-fehér, monokróm látható&#10;&#10;Automatikusan generált leírás">
                                  <a:extLst>
                                    <a:ext uri="{FF2B5EF4-FFF2-40B4-BE49-F238E27FC236}">
                                      <a16:creationId xmlns:a16="http://schemas.microsoft.com/office/drawing/2014/main" id="{05D95C64-6189-14E1-C788-A566522D6041}"/>
                                    </a:ext>
                                  </a:extLst>
                                </p:cNvPr>
                                <p:cNvPicPr>
                                  <a:picLocks/>
                                </p:cNvPicPr>
                                <p:nvPr/>
                              </p:nvPicPr>
                              <p:blipFill>
                                <a:blip r:embed="rId6">
                                  <a:extLst>
                                    <a:ext uri="{28A0092B-C50C-407E-A947-70E740481C1C}">
                                      <a14:useLocalDpi xmlns:a14="http://schemas.microsoft.com/office/drawing/2010/main" val="0"/>
                                    </a:ext>
                                  </a:extLst>
                                </a:blip>
                                <a:stretch>
                                  <a:fillRect/>
                                </a:stretch>
                              </p:blipFill>
                              <p:spPr>
                                <a:xfrm>
                                  <a:off x="1756291" y="3913798"/>
                                  <a:ext cx="2340000" cy="540000"/>
                                </a:xfrm>
                                <a:prstGeom prst="rect">
                                  <a:avLst/>
                                </a:prstGeom>
                                <a:ln w="9525">
                                  <a:solidFill>
                                    <a:schemeClr val="tx1"/>
                                  </a:solidFill>
                                </a:ln>
                              </p:spPr>
                            </p:pic>
                            <p:grpSp>
                              <p:nvGrpSpPr>
                                <p:cNvPr id="112" name="Csoportba foglalás 111">
                                  <a:extLst>
                                    <a:ext uri="{FF2B5EF4-FFF2-40B4-BE49-F238E27FC236}">
                                      <a16:creationId xmlns:a16="http://schemas.microsoft.com/office/drawing/2014/main" id="{B5696110-33D4-C1D5-1E4F-73C0D4840D56}"/>
                                    </a:ext>
                                  </a:extLst>
                                </p:cNvPr>
                                <p:cNvGrpSpPr/>
                                <p:nvPr/>
                              </p:nvGrpSpPr>
                              <p:grpSpPr>
                                <a:xfrm>
                                  <a:off x="69594" y="2505301"/>
                                  <a:ext cx="11964550" cy="2062084"/>
                                  <a:chOff x="69594" y="2505301"/>
                                  <a:chExt cx="11964550" cy="2062084"/>
                                </a:xfrm>
                              </p:grpSpPr>
                              <p:grpSp>
                                <p:nvGrpSpPr>
                                  <p:cNvPr id="113" name="Csoportba foglalás 112">
                                    <a:extLst>
                                      <a:ext uri="{FF2B5EF4-FFF2-40B4-BE49-F238E27FC236}">
                                        <a16:creationId xmlns:a16="http://schemas.microsoft.com/office/drawing/2014/main" id="{095EF88C-ED17-A9AD-67F4-F820AD43B2F2}"/>
                                      </a:ext>
                                    </a:extLst>
                                  </p:cNvPr>
                                  <p:cNvGrpSpPr/>
                                  <p:nvPr/>
                                </p:nvGrpSpPr>
                                <p:grpSpPr>
                                  <a:xfrm>
                                    <a:off x="69594" y="2505301"/>
                                    <a:ext cx="11964550" cy="2062084"/>
                                    <a:chOff x="69594" y="2505301"/>
                                    <a:chExt cx="11964550" cy="2062084"/>
                                  </a:xfrm>
                                </p:grpSpPr>
                                <p:grpSp>
                                  <p:nvGrpSpPr>
                                    <p:cNvPr id="116" name="Csoportba foglalás 115">
                                      <a:extLst>
                                        <a:ext uri="{FF2B5EF4-FFF2-40B4-BE49-F238E27FC236}">
                                          <a16:creationId xmlns:a16="http://schemas.microsoft.com/office/drawing/2014/main" id="{75DB2AA7-2AE6-C65E-937C-0E59E2EA8E12}"/>
                                        </a:ext>
                                      </a:extLst>
                                    </p:cNvPr>
                                    <p:cNvGrpSpPr/>
                                    <p:nvPr/>
                                  </p:nvGrpSpPr>
                                  <p:grpSpPr>
                                    <a:xfrm>
                                      <a:off x="69594" y="2505301"/>
                                      <a:ext cx="11964550" cy="2062084"/>
                                      <a:chOff x="69594" y="2505301"/>
                                      <a:chExt cx="11964550" cy="2062084"/>
                                    </a:xfrm>
                                  </p:grpSpPr>
                                  <p:grpSp>
                                    <p:nvGrpSpPr>
                                      <p:cNvPr id="119" name="Csoportba foglalás 118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BA417395-BE5E-1E38-2C58-76B286AAB8B9}"/>
                                          </a:ext>
                                        </a:extLst>
                                      </p:cNvPr>
                                      <p:cNvGrpSpPr/>
                                      <p:nvPr/>
                                    </p:nvGrpSpPr>
                                    <p:grpSpPr>
                                      <a:xfrm>
                                        <a:off x="69594" y="2505301"/>
                                        <a:ext cx="11964550" cy="2062084"/>
                                        <a:chOff x="69594" y="2505301"/>
                                        <a:chExt cx="11964550" cy="2062084"/>
                                      </a:xfrm>
                                    </p:grpSpPr>
                                    <p:grpSp>
                                      <p:nvGrpSpPr>
                                        <p:cNvPr id="122" name="Csoportba foglalás 121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5733D2FB-2DC7-A52B-52F2-86DEA22FA11C}"/>
                                            </a:ext>
                                          </a:extLst>
                                        </p:cNvPr>
                                        <p:cNvGrpSpPr/>
                                        <p:nvPr/>
                                      </p:nvGrpSpPr>
                                      <p:grpSpPr>
                                        <a:xfrm>
                                          <a:off x="69594" y="2505301"/>
                                          <a:ext cx="11964550" cy="2062084"/>
                                          <a:chOff x="68367" y="412537"/>
                                          <a:chExt cx="11964550" cy="2062084"/>
                                        </a:xfrm>
                                      </p:grpSpPr>
                                      <p:sp>
                                        <p:nvSpPr>
                                          <p:cNvPr id="126" name="Szövegdoboz 125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192360AF-9B4D-07C0-69D9-9D4B9F2D9575}"/>
                                              </a:ext>
                                            </a:extLst>
                                          </p:cNvPr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68367" y="1057665"/>
                                            <a:ext cx="998630" cy="307777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square" rtlCol="0">
                                            <a:spAutoFit/>
                                          </a:bodyPr>
                                          <a:lstStyle/>
                                          <a:p>
                                            <a:r>
                                              <a:rPr lang="hu-HU" sz="1400" dirty="0" err="1"/>
                                              <a:t>Snail</a:t>
                                            </a:r>
                                            <a:r>
                                              <a:rPr lang="hu-HU" sz="1400" dirty="0"/>
                                              <a:t>:</a:t>
                                            </a:r>
                                          </a:p>
                                        </p:txBody>
                                      </p:sp>
                                      <p:sp>
                                        <p:nvSpPr>
                                          <p:cNvPr id="127" name="Szövegdoboz 126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9F69B1C1-A029-B6E6-5879-C80CB14AC6E2}"/>
                                              </a:ext>
                                            </a:extLst>
                                          </p:cNvPr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68367" y="1749558"/>
                                            <a:ext cx="1115818" cy="307777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square" rtlCol="0">
                                            <a:spAutoFit/>
                                          </a:bodyPr>
                                          <a:lstStyle/>
                                          <a:p>
                                            <a:r>
                                              <a:rPr lang="hu-HU" sz="1400" dirty="0"/>
                                              <a:t>β-</a:t>
                                            </a:r>
                                            <a:r>
                                              <a:rPr lang="hu-HU" sz="1400" dirty="0" err="1"/>
                                              <a:t>actin</a:t>
                                            </a:r>
                                            <a:r>
                                              <a:rPr lang="hu-HU" sz="1400" dirty="0"/>
                                              <a:t>:</a:t>
                                            </a:r>
                                          </a:p>
                                        </p:txBody>
                                      </p:sp>
                                      <p:sp>
                                        <p:nvSpPr>
                                          <p:cNvPr id="128" name="Szövegdoboz 127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749D704C-7DF4-04E1-8398-242EF9E268F2}"/>
                                              </a:ext>
                                            </a:extLst>
                                          </p:cNvPr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2758993" y="412537"/>
                                            <a:ext cx="332142" cy="307777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none" rtlCol="0">
                                            <a:spAutoFit/>
                                          </a:bodyPr>
                                          <a:lstStyle/>
                                          <a:p>
                                            <a:r>
                                              <a:rPr lang="hu-HU" sz="1400" b="1" dirty="0"/>
                                              <a:t>1.</a:t>
                                            </a:r>
                                          </a:p>
                                        </p:txBody>
                                      </p:sp>
                                      <p:sp>
                                        <p:nvSpPr>
                                          <p:cNvPr id="129" name="Szövegdoboz 128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36327FCF-C64E-A4AF-6AAD-8F5C7E40787E}"/>
                                              </a:ext>
                                            </a:extLst>
                                          </p:cNvPr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6279791" y="421963"/>
                                            <a:ext cx="335348" cy="307777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none" rtlCol="0">
                                            <a:spAutoFit/>
                                          </a:bodyPr>
                                          <a:lstStyle/>
                                          <a:p>
                                            <a:r>
                                              <a:rPr lang="hu-HU" sz="1400" b="1" dirty="0"/>
                                              <a:t>2.</a:t>
                                            </a:r>
                                          </a:p>
                                        </p:txBody>
                                      </p:sp>
                                      <p:sp>
                                        <p:nvSpPr>
                                          <p:cNvPr id="130" name="Szövegdoboz 129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45E0954E-F720-D6DC-28A2-EE23352E491D}"/>
                                              </a:ext>
                                            </a:extLst>
                                          </p:cNvPr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10015593" y="420959"/>
                                            <a:ext cx="335348" cy="307777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none" rtlCol="0">
                                            <a:spAutoFit/>
                                          </a:bodyPr>
                                          <a:lstStyle/>
                                          <a:p>
                                            <a:r>
                                              <a:rPr lang="hu-HU" sz="1400" b="1" dirty="0"/>
                                              <a:t>3.</a:t>
                                            </a:r>
                                          </a:p>
                                        </p:txBody>
                                      </p:sp>
                                      <p:sp>
                                        <p:nvSpPr>
                                          <p:cNvPr id="131" name="Téglalap 130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6B9CFD71-3E98-F54A-5DA3-B922DB367C4D}"/>
                                              </a:ext>
                                            </a:extLst>
                                          </p:cNvPr>
                                          <p:cNvSpPr/>
                                          <p:nvPr/>
                                        </p:nvSpPr>
                                        <p:spPr>
                                          <a:xfrm>
                                            <a:off x="70822" y="474905"/>
                                            <a:ext cx="11962095" cy="1999716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style>
                                          <a:lnRef idx="2">
                                            <a:schemeClr val="accent1">
                                              <a:shade val="15000"/>
                                            </a:schemeClr>
                                          </a:lnRef>
                                          <a:fillRef idx="1">
                                            <a:schemeClr val="accent1"/>
                                          </a:fillRef>
                                          <a:effectRef idx="0">
                                            <a:schemeClr val="accent1"/>
                                          </a:effectRef>
                                          <a:fontRef idx="minor">
                                            <a:schemeClr val="lt1"/>
                                          </a:fontRef>
                                        </p:style>
                                        <p:txBody>
                                          <a:bodyPr rtlCol="0" anchor="ctr"/>
                                          <a:lstStyle/>
                                          <a:p>
                                            <a:pPr algn="ctr"/>
                                            <a:endParaRPr lang="hu-HU"/>
                                          </a:p>
                                        </p:txBody>
                                      </p:sp>
                                    </p:grpSp>
                                    <p:pic>
                                      <p:nvPicPr>
                                        <p:cNvPr id="123" name="Kép 122" descr="A képen fekete, fehér, fekete-fehér, monokróm látható&#10;&#10;Automatikusan generált leírás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E1CCC610-848A-79BD-2694-59EF75C63772}"/>
                                            </a:ext>
                                          </a:extLst>
                                        </p:cNvPr>
                                        <p:cNvPicPr>
                                          <a:picLocks/>
                                        </p:cNvPicPr>
                                        <p:nvPr/>
                                      </p:nvPicPr>
                                      <p:blipFill>
                                        <a:blip r:embed="rId7">
                                          <a:extLst>
                                            <a:ext uri="{28A0092B-C50C-407E-A947-70E740481C1C}">
                                              <a14:useLocalDpi xmlns:a14="http://schemas.microsoft.com/office/drawing/2010/main" val="0"/>
                                            </a:ext>
                                          </a:extLst>
                                        </a:blip>
                                        <a:stretch>
                                          <a:fillRect/>
                                        </a:stretch>
                                      </p:blipFill>
                                      <p:spPr>
                                        <a:xfrm>
                                          <a:off x="1758570" y="3055663"/>
                                          <a:ext cx="2340000" cy="540000"/>
                                        </a:xfrm>
                                        <a:prstGeom prst="rect">
                                          <a:avLst/>
                                        </a:prstGeom>
                                        <a:ln w="9525">
                                          <a:solidFill>
                                            <a:schemeClr val="tx1"/>
                                          </a:solidFill>
                                        </a:ln>
                                      </p:spPr>
                                    </p:pic>
                                    <p:sp>
                                      <p:nvSpPr>
                                        <p:cNvPr id="124" name="Szövegdoboz 123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799A181A-8E73-41DB-53DC-66A9A73A6C00}"/>
                                            </a:ext>
                                          </a:extLst>
                                        </p:cNvPr>
                                        <p:cNvSpPr txBox="1"/>
                                        <p:nvPr/>
                                      </p:nvSpPr>
                                      <p:spPr>
                                        <a:xfrm>
                                          <a:off x="2380853" y="2827772"/>
                                          <a:ext cx="470000" cy="215444"/>
                                        </a:xfrm>
                                        <a:prstGeom prst="rect">
                                          <a:avLst/>
                                        </a:prstGeom>
                                        <a:noFill/>
                                      </p:spPr>
                                      <p:txBody>
                                        <a:bodyPr wrap="none" rtlCol="0">
                                          <a:spAutoFit/>
                                        </a:bodyPr>
                                        <a:lstStyle/>
                                        <a:p>
                                          <a:r>
                                            <a:rPr lang="hu-HU" sz="800" dirty="0"/>
                                            <a:t>DMSO</a:t>
                                          </a:r>
                                        </a:p>
                                      </p:txBody>
                                    </p:sp>
                                    <p:sp>
                                      <p:nvSpPr>
                                        <p:cNvPr id="125" name="Szövegdoboz 124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E48C66BF-4536-044F-42AC-7FEC7B4A4789}"/>
                                            </a:ext>
                                          </a:extLst>
                                        </p:cNvPr>
                                        <p:cNvSpPr txBox="1"/>
                                        <p:nvPr/>
                                      </p:nvSpPr>
                                      <p:spPr>
                                        <a:xfrm>
                                          <a:off x="3223647" y="2834107"/>
                                          <a:ext cx="457176" cy="215444"/>
                                        </a:xfrm>
                                        <a:prstGeom prst="rect">
                                          <a:avLst/>
                                        </a:prstGeom>
                                        <a:noFill/>
                                      </p:spPr>
                                      <p:txBody>
                                        <a:bodyPr wrap="none" rtlCol="0">
                                          <a:spAutoFit/>
                                        </a:bodyPr>
                                        <a:lstStyle/>
                                        <a:p>
                                          <a:r>
                                            <a:rPr lang="hu-HU" sz="800" dirty="0"/>
                                            <a:t>UDCA</a:t>
                                          </a:r>
                                        </a:p>
                                      </p:txBody>
                                    </p:sp>
                                  </p:grpSp>
                                  <p:sp>
                                    <p:nvSpPr>
                                      <p:cNvPr id="120" name="Szövegdoboz 119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4018CC21-F3BA-E012-A532-A0CC78AA8F1C}"/>
                                          </a:ext>
                                        </a:extLst>
                                      </p:cNvPr>
                                      <p:cNvSpPr txBox="1"/>
                                      <p:nvPr/>
                                    </p:nvSpPr>
                                    <p:spPr>
                                      <a:xfrm>
                                        <a:off x="1451991" y="2985353"/>
                                        <a:ext cx="293670" cy="215444"/>
                                      </a:xfrm>
                                      <a:prstGeom prst="rect">
                                        <a:avLst/>
                                      </a:prstGeom>
                                      <a:noFill/>
                                    </p:spPr>
                                    <p:txBody>
                                      <a:bodyPr wrap="none" rtlCol="0">
                                        <a:spAutoFit/>
                                      </a:bodyPr>
                                      <a:lstStyle/>
                                      <a:p>
                                        <a:r>
                                          <a:rPr lang="hu-HU" sz="800" dirty="0"/>
                                          <a:t>55</a:t>
                                        </a:r>
                                      </a:p>
                                    </p:txBody>
                                  </p:sp>
                                  <p:sp>
                                    <p:nvSpPr>
                                      <p:cNvPr id="121" name="Szövegdoboz 120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93347026-A392-0280-F7F4-87EC5E8F8F4A}"/>
                                          </a:ext>
                                        </a:extLst>
                                      </p:cNvPr>
                                      <p:cNvSpPr txBox="1"/>
                                      <p:nvPr/>
                                    </p:nvSpPr>
                                    <p:spPr>
                                      <a:xfrm>
                                        <a:off x="1456230" y="3326680"/>
                                        <a:ext cx="293670" cy="215444"/>
                                      </a:xfrm>
                                      <a:prstGeom prst="rect">
                                        <a:avLst/>
                                      </a:prstGeom>
                                      <a:noFill/>
                                    </p:spPr>
                                    <p:txBody>
                                      <a:bodyPr wrap="none" rtlCol="0">
                                        <a:spAutoFit/>
                                      </a:bodyPr>
                                      <a:lstStyle/>
                                      <a:p>
                                        <a:r>
                                          <a:rPr lang="hu-HU" sz="800" dirty="0"/>
                                          <a:t>35</a:t>
                                        </a:r>
                                      </a:p>
                                    </p:txBody>
                                  </p:sp>
                                </p:grpSp>
                                <p:sp>
                                  <p:nvSpPr>
                                    <p:cNvPr id="117" name="Szövegdoboz 116">
                                      <a:extLst>
                                        <a:ext uri="{FF2B5EF4-FFF2-40B4-BE49-F238E27FC236}">
                                          <a16:creationId xmlns:a16="http://schemas.microsoft.com/office/drawing/2014/main" id="{27635DAD-E3B6-796C-0410-706C69E0CE92}"/>
                                        </a:ext>
                                      </a:extLst>
                                    </p:cNvPr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2389113" y="3676356"/>
                                      <a:ext cx="470000" cy="2154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none" rtlCol="0">
                                      <a:spAutoFit/>
                                    </a:bodyPr>
                                    <a:lstStyle/>
                                    <a:p>
                                      <a:r>
                                        <a:rPr lang="hu-HU" sz="800" dirty="0"/>
                                        <a:t>DMSO</a:t>
                                      </a:r>
                                    </a:p>
                                  </p:txBody>
                                </p:sp>
                                <p:sp>
                                  <p:nvSpPr>
                                    <p:cNvPr id="118" name="Szövegdoboz 117">
                                      <a:extLst>
                                        <a:ext uri="{FF2B5EF4-FFF2-40B4-BE49-F238E27FC236}">
                                          <a16:creationId xmlns:a16="http://schemas.microsoft.com/office/drawing/2014/main" id="{29CA0B6D-08F4-2A91-1BF2-E5059F95781C}"/>
                                        </a:ext>
                                      </a:extLst>
                                    </p:cNvPr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3235846" y="3674597"/>
                                      <a:ext cx="457176" cy="2154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none" rtlCol="0">
                                      <a:spAutoFit/>
                                    </a:bodyPr>
                                    <a:lstStyle/>
                                    <a:p>
                                      <a:r>
                                        <a:rPr lang="hu-HU" sz="800" dirty="0"/>
                                        <a:t>UDCA</a:t>
                                      </a:r>
                                    </a:p>
                                  </p:txBody>
                                </p:sp>
                              </p:grpSp>
                              <p:sp>
                                <p:nvSpPr>
                                  <p:cNvPr id="114" name="Szövegdoboz 113">
                                    <a:extLst>
                                      <a:ext uri="{FF2B5EF4-FFF2-40B4-BE49-F238E27FC236}">
                                        <a16:creationId xmlns:a16="http://schemas.microsoft.com/office/drawing/2014/main" id="{EDDE0F62-9677-FACA-89AB-58401F103AEB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1462986" y="3844766"/>
                                    <a:ext cx="293670" cy="215444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hu-HU" sz="800" dirty="0"/>
                                      <a:t>55</a:t>
                                    </a:r>
                                  </a:p>
                                </p:txBody>
                              </p:sp>
                              <p:sp>
                                <p:nvSpPr>
                                  <p:cNvPr id="115" name="Szövegdoboz 114">
                                    <a:extLst>
                                      <a:ext uri="{FF2B5EF4-FFF2-40B4-BE49-F238E27FC236}">
                                        <a16:creationId xmlns:a16="http://schemas.microsoft.com/office/drawing/2014/main" id="{91D84E2B-74E3-9C5D-64AD-847EC2730B9B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1467225" y="4289790"/>
                                    <a:ext cx="293670" cy="215444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hu-HU" sz="800" dirty="0"/>
                                      <a:t>35</a:t>
                                    </a:r>
                                  </a:p>
                                </p:txBody>
                              </p:sp>
                            </p:grpSp>
                          </p:grpSp>
                          <p:pic>
                            <p:nvPicPr>
                              <p:cNvPr id="110" name="Kép 109" descr="A képen fekete, monokróm, fekete-fehér, Monokróm fényképezés látható&#10;&#10;Automatikusan generált leírás">
                                <a:extLst>
                                  <a:ext uri="{FF2B5EF4-FFF2-40B4-BE49-F238E27FC236}">
                                    <a16:creationId xmlns:a16="http://schemas.microsoft.com/office/drawing/2014/main" id="{72379B52-D963-F692-EFEB-DB154A70BFF0}"/>
                                  </a:ext>
                                </a:extLst>
                              </p:cNvPr>
                              <p:cNvPicPr>
                                <a:picLocks/>
                              </p:cNvPicPr>
                              <p:nvPr/>
                            </p:nvPicPr>
                            <p:blipFill>
                              <a:blip r:embed="rId8">
                                <a:extLst>
                                  <a:ext uri="{28A0092B-C50C-407E-A947-70E740481C1C}">
                                    <a14:useLocalDpi xmlns:a14="http://schemas.microsoft.com/office/drawing/2010/main" val="0"/>
                                  </a:ext>
                                </a:extLst>
                              </a:blip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5282450" y="3055663"/>
                                <a:ext cx="2340000" cy="540000"/>
                              </a:xfrm>
                              <a:prstGeom prst="rect">
                                <a:avLst/>
                              </a:prstGeom>
                              <a:ln w="9525">
                                <a:solidFill>
                                  <a:schemeClr val="tx1"/>
                                </a:solidFill>
                              </a:ln>
                            </p:spPr>
                          </p:pic>
                        </p:grpSp>
                        <p:sp>
                          <p:nvSpPr>
                            <p:cNvPr id="108" name="Szövegdoboz 107">
                              <a:extLst>
                                <a:ext uri="{FF2B5EF4-FFF2-40B4-BE49-F238E27FC236}">
                                  <a16:creationId xmlns:a16="http://schemas.microsoft.com/office/drawing/2014/main" id="{C0B8EBF1-7338-3161-C726-0915FFADFBBB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4996626" y="3015030"/>
                              <a:ext cx="293670" cy="215444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r>
                                <a:rPr lang="hu-HU" sz="800" dirty="0"/>
                                <a:t>35</a:t>
                              </a:r>
                            </a:p>
                          </p:txBody>
                        </p:sp>
                      </p:grpSp>
                      <p:sp>
                        <p:nvSpPr>
                          <p:cNvPr id="105" name="Szövegdoboz 104">
                            <a:extLst>
                              <a:ext uri="{FF2B5EF4-FFF2-40B4-BE49-F238E27FC236}">
                                <a16:creationId xmlns:a16="http://schemas.microsoft.com/office/drawing/2014/main" id="{D11609BE-ECBB-05DD-D192-16B5A613AC06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6775319" y="2819913"/>
                            <a:ext cx="470000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hu-HU" sz="800" dirty="0"/>
                              <a:t>DMSO</a:t>
                            </a:r>
                          </a:p>
                        </p:txBody>
                      </p:sp>
                      <p:sp>
                        <p:nvSpPr>
                          <p:cNvPr id="106" name="Szövegdoboz 105">
                            <a:extLst>
                              <a:ext uri="{FF2B5EF4-FFF2-40B4-BE49-F238E27FC236}">
                                <a16:creationId xmlns:a16="http://schemas.microsoft.com/office/drawing/2014/main" id="{E5F9D8AF-FCD6-DFED-6D82-B5141147514F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7156199" y="2826248"/>
                            <a:ext cx="457176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hu-HU" sz="800" dirty="0"/>
                              <a:t>UDCA</a:t>
                            </a:r>
                          </a:p>
                        </p:txBody>
                      </p:sp>
                    </p:grpSp>
                    <p:pic>
                      <p:nvPicPr>
                        <p:cNvPr id="103" name="Kép 102" descr="A képen fehér, fekete, fekete-fehér, monokróm látható&#10;&#10;Automatikusan generált leírás">
                          <a:extLst>
                            <a:ext uri="{FF2B5EF4-FFF2-40B4-BE49-F238E27FC236}">
                              <a16:creationId xmlns:a16="http://schemas.microsoft.com/office/drawing/2014/main" id="{E75FD681-BCDC-13BB-5F5C-C03FD7AED6C6}"/>
                            </a:ext>
                          </a:extLst>
                        </p:cNvPr>
                        <p:cNvPicPr>
                          <a:picLocks/>
                        </p:cNvPicPr>
                        <p:nvPr/>
                      </p:nvPicPr>
                      <p:blipFill>
                        <a:blip r:embed="rId9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tretch>
                          <a:fillRect/>
                        </a:stretch>
                      </p:blipFill>
                      <p:spPr>
                        <a:xfrm>
                          <a:off x="5278692" y="3913798"/>
                          <a:ext cx="2340000" cy="540000"/>
                        </a:xfrm>
                        <a:prstGeom prst="rect">
                          <a:avLst/>
                        </a:prstGeom>
                        <a:ln w="9525">
                          <a:solidFill>
                            <a:schemeClr val="tx1"/>
                          </a:solidFill>
                        </a:ln>
                      </p:spPr>
                    </p:pic>
                  </p:grpSp>
                  <p:sp>
                    <p:nvSpPr>
                      <p:cNvPr id="96" name="Szövegdoboz 95">
                        <a:extLst>
                          <a:ext uri="{FF2B5EF4-FFF2-40B4-BE49-F238E27FC236}">
                            <a16:creationId xmlns:a16="http://schemas.microsoft.com/office/drawing/2014/main" id="{7EEE28AD-0954-CCB7-B68D-2253DD273EA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671627" y="3677758"/>
                        <a:ext cx="47000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hu-HU" sz="800" dirty="0"/>
                          <a:t>DMSO</a:t>
                        </a:r>
                      </a:p>
                    </p:txBody>
                  </p:sp>
                  <p:sp>
                    <p:nvSpPr>
                      <p:cNvPr id="99" name="Szövegdoboz 98">
                        <a:extLst>
                          <a:ext uri="{FF2B5EF4-FFF2-40B4-BE49-F238E27FC236}">
                            <a16:creationId xmlns:a16="http://schemas.microsoft.com/office/drawing/2014/main" id="{C825099F-62CF-341F-3DDA-320DAB4770A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995942" y="3674666"/>
                        <a:ext cx="457176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hu-HU" sz="800" dirty="0"/>
                          <a:t>UDCA</a:t>
                        </a:r>
                      </a:p>
                    </p:txBody>
                  </p:sp>
                </p:grpSp>
                <p:sp>
                  <p:nvSpPr>
                    <p:cNvPr id="92" name="Szövegdoboz 91">
                      <a:extLst>
                        <a:ext uri="{FF2B5EF4-FFF2-40B4-BE49-F238E27FC236}">
                          <a16:creationId xmlns:a16="http://schemas.microsoft.com/office/drawing/2014/main" id="{18E07304-10A6-887B-2880-401EEF12657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69231" y="3852509"/>
                      <a:ext cx="293670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hu-HU" sz="800" dirty="0"/>
                        <a:t>70</a:t>
                      </a:r>
                    </a:p>
                  </p:txBody>
                </p:sp>
                <p:sp>
                  <p:nvSpPr>
                    <p:cNvPr id="93" name="Szövegdoboz 92">
                      <a:extLst>
                        <a:ext uri="{FF2B5EF4-FFF2-40B4-BE49-F238E27FC236}">
                          <a16:creationId xmlns:a16="http://schemas.microsoft.com/office/drawing/2014/main" id="{5A34C85D-2529-84CE-7924-A3472952413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64043" y="4005301"/>
                      <a:ext cx="293670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hu-HU" sz="800" dirty="0"/>
                        <a:t>55</a:t>
                      </a:r>
                    </a:p>
                  </p:txBody>
                </p:sp>
                <p:sp>
                  <p:nvSpPr>
                    <p:cNvPr id="94" name="Szövegdoboz 93">
                      <a:extLst>
                        <a:ext uri="{FF2B5EF4-FFF2-40B4-BE49-F238E27FC236}">
                          <a16:creationId xmlns:a16="http://schemas.microsoft.com/office/drawing/2014/main" id="{6806B2AC-AA4A-8A7E-6B96-E7BC7D6AC30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66462" y="4231882"/>
                      <a:ext cx="293670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hu-HU" sz="800" dirty="0"/>
                        <a:t>35</a:t>
                      </a:r>
                    </a:p>
                  </p:txBody>
                </p:sp>
              </p:grpSp>
              <p:pic>
                <p:nvPicPr>
                  <p:cNvPr id="88" name="Kép 87" descr="A képen fekete, fekete-fehér, monokróm, fehér látható&#10;&#10;Automatikusan generált leírás">
                    <a:extLst>
                      <a:ext uri="{FF2B5EF4-FFF2-40B4-BE49-F238E27FC236}">
                        <a16:creationId xmlns:a16="http://schemas.microsoft.com/office/drawing/2014/main" id="{62F71E53-55E9-BBC2-BC9F-175377726387}"/>
                      </a:ext>
                    </a:extLst>
                  </p:cNvPr>
                  <p:cNvPicPr>
                    <a:picLocks/>
                  </p:cNvPicPr>
                  <p:nvPr/>
                </p:nvPicPr>
                <p:blipFill>
                  <a:blip r:embed="rId10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8943027" y="3061343"/>
                    <a:ext cx="2340000" cy="540000"/>
                  </a:xfrm>
                  <a:prstGeom prst="rect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</p:pic>
            </p:grpSp>
            <p:sp>
              <p:nvSpPr>
                <p:cNvPr id="84" name="Szövegdoboz 83">
                  <a:extLst>
                    <a:ext uri="{FF2B5EF4-FFF2-40B4-BE49-F238E27FC236}">
                      <a16:creationId xmlns:a16="http://schemas.microsoft.com/office/drawing/2014/main" id="{4962A602-ECE5-A7AF-7F50-060515EA0A4E}"/>
                    </a:ext>
                  </a:extLst>
                </p:cNvPr>
                <p:cNvSpPr txBox="1"/>
                <p:nvPr/>
              </p:nvSpPr>
              <p:spPr>
                <a:xfrm>
                  <a:off x="9327169" y="2830961"/>
                  <a:ext cx="4700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hu-HU" sz="800" dirty="0"/>
                    <a:t>DMSO</a:t>
                  </a:r>
                </a:p>
              </p:txBody>
            </p:sp>
            <p:sp>
              <p:nvSpPr>
                <p:cNvPr id="85" name="Szövegdoboz 84">
                  <a:extLst>
                    <a:ext uri="{FF2B5EF4-FFF2-40B4-BE49-F238E27FC236}">
                      <a16:creationId xmlns:a16="http://schemas.microsoft.com/office/drawing/2014/main" id="{1937E354-D0CD-63F6-A3A7-AB4FA57FB09A}"/>
                    </a:ext>
                  </a:extLst>
                </p:cNvPr>
                <p:cNvSpPr txBox="1"/>
                <p:nvPr/>
              </p:nvSpPr>
              <p:spPr>
                <a:xfrm>
                  <a:off x="10509332" y="2837296"/>
                  <a:ext cx="45717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hu-HU" sz="800" dirty="0"/>
                    <a:t>UDCA</a:t>
                  </a:r>
                </a:p>
              </p:txBody>
            </p:sp>
          </p:grpSp>
          <p:sp>
            <p:nvSpPr>
              <p:cNvPr id="79" name="Szövegdoboz 78">
                <a:extLst>
                  <a:ext uri="{FF2B5EF4-FFF2-40B4-BE49-F238E27FC236}">
                    <a16:creationId xmlns:a16="http://schemas.microsoft.com/office/drawing/2014/main" id="{316AF4B9-726A-1FA4-0FEA-2A07DF6F0CC1}"/>
                  </a:ext>
                </a:extLst>
              </p:cNvPr>
              <p:cNvSpPr txBox="1"/>
              <p:nvPr/>
            </p:nvSpPr>
            <p:spPr>
              <a:xfrm>
                <a:off x="8693613" y="3052740"/>
                <a:ext cx="2936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hu-HU" sz="800" dirty="0"/>
                  <a:t>35</a:t>
                </a:r>
              </a:p>
            </p:txBody>
          </p:sp>
          <p:sp>
            <p:nvSpPr>
              <p:cNvPr id="81" name="Szövegdoboz 80">
                <a:extLst>
                  <a:ext uri="{FF2B5EF4-FFF2-40B4-BE49-F238E27FC236}">
                    <a16:creationId xmlns:a16="http://schemas.microsoft.com/office/drawing/2014/main" id="{2BE32FD2-63F2-43A3-F11A-E3D2FB9EE88E}"/>
                  </a:ext>
                </a:extLst>
              </p:cNvPr>
              <p:cNvSpPr txBox="1"/>
              <p:nvPr/>
            </p:nvSpPr>
            <p:spPr>
              <a:xfrm>
                <a:off x="8693613" y="3327238"/>
                <a:ext cx="2936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hu-HU" sz="800" dirty="0"/>
                  <a:t>25</a:t>
                </a:r>
              </a:p>
            </p:txBody>
          </p:sp>
        </p:grpSp>
        <p:sp>
          <p:nvSpPr>
            <p:cNvPr id="65" name="Szövegdoboz 64">
              <a:extLst>
                <a:ext uri="{FF2B5EF4-FFF2-40B4-BE49-F238E27FC236}">
                  <a16:creationId xmlns:a16="http://schemas.microsoft.com/office/drawing/2014/main" id="{23FA67AC-E506-EEE8-48AB-656FC2BD43EB}"/>
                </a:ext>
              </a:extLst>
            </p:cNvPr>
            <p:cNvSpPr txBox="1"/>
            <p:nvPr/>
          </p:nvSpPr>
          <p:spPr>
            <a:xfrm>
              <a:off x="8656819" y="3853997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00" dirty="0"/>
                <a:t>55</a:t>
              </a:r>
            </a:p>
          </p:txBody>
        </p:sp>
        <p:sp>
          <p:nvSpPr>
            <p:cNvPr id="66" name="Szövegdoboz 65">
              <a:extLst>
                <a:ext uri="{FF2B5EF4-FFF2-40B4-BE49-F238E27FC236}">
                  <a16:creationId xmlns:a16="http://schemas.microsoft.com/office/drawing/2014/main" id="{9407C494-69E5-D709-CD9D-F6C7A7DC374E}"/>
                </a:ext>
              </a:extLst>
            </p:cNvPr>
            <p:cNvSpPr txBox="1"/>
            <p:nvPr/>
          </p:nvSpPr>
          <p:spPr>
            <a:xfrm>
              <a:off x="8661058" y="4195324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00" dirty="0"/>
                <a:t>35</a:t>
              </a:r>
            </a:p>
          </p:txBody>
        </p:sp>
        <p:sp>
          <p:nvSpPr>
            <p:cNvPr id="67" name="Szövegdoboz 66">
              <a:extLst>
                <a:ext uri="{FF2B5EF4-FFF2-40B4-BE49-F238E27FC236}">
                  <a16:creationId xmlns:a16="http://schemas.microsoft.com/office/drawing/2014/main" id="{5A2A30F2-DAE7-F4D1-1E96-7314047E7D1B}"/>
                </a:ext>
              </a:extLst>
            </p:cNvPr>
            <p:cNvSpPr txBox="1"/>
            <p:nvPr/>
          </p:nvSpPr>
          <p:spPr>
            <a:xfrm>
              <a:off x="9300456" y="3671520"/>
              <a:ext cx="4700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00" dirty="0"/>
                <a:t>DMSO</a:t>
              </a:r>
            </a:p>
          </p:txBody>
        </p:sp>
        <p:sp>
          <p:nvSpPr>
            <p:cNvPr id="71" name="Szövegdoboz 70">
              <a:extLst>
                <a:ext uri="{FF2B5EF4-FFF2-40B4-BE49-F238E27FC236}">
                  <a16:creationId xmlns:a16="http://schemas.microsoft.com/office/drawing/2014/main" id="{A3183767-2C77-BC94-229F-0186E4F9867A}"/>
                </a:ext>
              </a:extLst>
            </p:cNvPr>
            <p:cNvSpPr txBox="1"/>
            <p:nvPr/>
          </p:nvSpPr>
          <p:spPr>
            <a:xfrm>
              <a:off x="10510900" y="3668428"/>
              <a:ext cx="4571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00" dirty="0"/>
                <a:t>UDCA</a:t>
              </a:r>
            </a:p>
          </p:txBody>
        </p:sp>
      </p:grpSp>
      <p:sp>
        <p:nvSpPr>
          <p:cNvPr id="132" name="Szövegdoboz 131">
            <a:extLst>
              <a:ext uri="{FF2B5EF4-FFF2-40B4-BE49-F238E27FC236}">
                <a16:creationId xmlns:a16="http://schemas.microsoft.com/office/drawing/2014/main" id="{4E61EA46-CF03-FBB6-50D2-3D75129E7EDA}"/>
              </a:ext>
            </a:extLst>
          </p:cNvPr>
          <p:cNvSpPr txBox="1"/>
          <p:nvPr/>
        </p:nvSpPr>
        <p:spPr>
          <a:xfrm>
            <a:off x="74409" y="2915807"/>
            <a:ext cx="22506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b="1" dirty="0" smtClean="0"/>
              <a:t>Capan-2:</a:t>
            </a:r>
            <a:endParaRPr lang="hu-HU" b="1" dirty="0"/>
          </a:p>
        </p:txBody>
      </p:sp>
    </p:spTree>
    <p:extLst>
      <p:ext uri="{BB962C8B-B14F-4D97-AF65-F5344CB8AC3E}">
        <p14:creationId xmlns:p14="http://schemas.microsoft.com/office/powerpoint/2010/main" val="23955391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E338438-1633-DCD7-A183-7D01EA69F1D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zövegdoboz 3">
            <a:extLst>
              <a:ext uri="{FF2B5EF4-FFF2-40B4-BE49-F238E27FC236}">
                <a16:creationId xmlns:a16="http://schemas.microsoft.com/office/drawing/2014/main" id="{BDE4A484-0F48-4C91-CB43-3F96CEE30F2B}"/>
              </a:ext>
            </a:extLst>
          </p:cNvPr>
          <p:cNvSpPr txBox="1"/>
          <p:nvPr/>
        </p:nvSpPr>
        <p:spPr>
          <a:xfrm>
            <a:off x="68367" y="68366"/>
            <a:ext cx="3393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b="1" dirty="0" err="1"/>
              <a:t>Fibroblast</a:t>
            </a:r>
            <a:r>
              <a:rPr lang="hu-HU" b="1" dirty="0"/>
              <a:t> </a:t>
            </a:r>
            <a:r>
              <a:rPr lang="hu-HU" b="1" dirty="0" err="1"/>
              <a:t>blots</a:t>
            </a:r>
            <a:r>
              <a:rPr lang="hu-HU" b="1" dirty="0"/>
              <a:t>:</a:t>
            </a:r>
          </a:p>
        </p:txBody>
      </p:sp>
      <p:grpSp>
        <p:nvGrpSpPr>
          <p:cNvPr id="37" name="Csoportba foglalás 36">
            <a:extLst>
              <a:ext uri="{FF2B5EF4-FFF2-40B4-BE49-F238E27FC236}">
                <a16:creationId xmlns:a16="http://schemas.microsoft.com/office/drawing/2014/main" id="{BD7D503B-9C5B-5F1E-5869-7FD5BCE12D8B}"/>
              </a:ext>
            </a:extLst>
          </p:cNvPr>
          <p:cNvGrpSpPr/>
          <p:nvPr/>
        </p:nvGrpSpPr>
        <p:grpSpPr>
          <a:xfrm>
            <a:off x="68367" y="369556"/>
            <a:ext cx="11964550" cy="2067858"/>
            <a:chOff x="68367" y="369556"/>
            <a:chExt cx="11964550" cy="2067858"/>
          </a:xfrm>
        </p:grpSpPr>
        <p:grpSp>
          <p:nvGrpSpPr>
            <p:cNvPr id="77" name="Csoportba foglalás 76">
              <a:extLst>
                <a:ext uri="{FF2B5EF4-FFF2-40B4-BE49-F238E27FC236}">
                  <a16:creationId xmlns:a16="http://schemas.microsoft.com/office/drawing/2014/main" id="{3AF2C4A5-B02E-3B33-71E0-10518CEBA70D}"/>
                </a:ext>
              </a:extLst>
            </p:cNvPr>
            <p:cNvGrpSpPr/>
            <p:nvPr/>
          </p:nvGrpSpPr>
          <p:grpSpPr>
            <a:xfrm>
              <a:off x="68367" y="369556"/>
              <a:ext cx="11964550" cy="2067858"/>
              <a:chOff x="68367" y="369556"/>
              <a:chExt cx="11964550" cy="2067858"/>
            </a:xfrm>
          </p:grpSpPr>
          <p:grpSp>
            <p:nvGrpSpPr>
              <p:cNvPr id="55" name="Csoportba foglalás 54">
                <a:extLst>
                  <a:ext uri="{FF2B5EF4-FFF2-40B4-BE49-F238E27FC236}">
                    <a16:creationId xmlns:a16="http://schemas.microsoft.com/office/drawing/2014/main" id="{A4D6155A-8CBA-99F4-880A-23EDE95525BF}"/>
                  </a:ext>
                </a:extLst>
              </p:cNvPr>
              <p:cNvGrpSpPr/>
              <p:nvPr/>
            </p:nvGrpSpPr>
            <p:grpSpPr>
              <a:xfrm>
                <a:off x="68367" y="369556"/>
                <a:ext cx="11964550" cy="2067858"/>
                <a:chOff x="68367" y="369556"/>
                <a:chExt cx="11964550" cy="2067858"/>
              </a:xfrm>
            </p:grpSpPr>
            <p:grpSp>
              <p:nvGrpSpPr>
                <p:cNvPr id="33" name="Csoportba foglalás 32">
                  <a:extLst>
                    <a:ext uri="{FF2B5EF4-FFF2-40B4-BE49-F238E27FC236}">
                      <a16:creationId xmlns:a16="http://schemas.microsoft.com/office/drawing/2014/main" id="{0F6F283D-1BDD-52C4-E308-D58DAE5C6DEB}"/>
                    </a:ext>
                  </a:extLst>
                </p:cNvPr>
                <p:cNvGrpSpPr/>
                <p:nvPr/>
              </p:nvGrpSpPr>
              <p:grpSpPr>
                <a:xfrm>
                  <a:off x="68367" y="369556"/>
                  <a:ext cx="11964550" cy="2067858"/>
                  <a:chOff x="68367" y="369556"/>
                  <a:chExt cx="11964550" cy="2067858"/>
                </a:xfrm>
              </p:grpSpPr>
              <p:grpSp>
                <p:nvGrpSpPr>
                  <p:cNvPr id="76" name="Csoportba foglalás 75">
                    <a:extLst>
                      <a:ext uri="{FF2B5EF4-FFF2-40B4-BE49-F238E27FC236}">
                        <a16:creationId xmlns:a16="http://schemas.microsoft.com/office/drawing/2014/main" id="{E647D122-5D00-A8AB-8C31-9C2CF93ECC74}"/>
                      </a:ext>
                    </a:extLst>
                  </p:cNvPr>
                  <p:cNvGrpSpPr/>
                  <p:nvPr/>
                </p:nvGrpSpPr>
                <p:grpSpPr>
                  <a:xfrm>
                    <a:off x="68367" y="369556"/>
                    <a:ext cx="11964550" cy="2067858"/>
                    <a:chOff x="68367" y="369556"/>
                    <a:chExt cx="11964550" cy="2067858"/>
                  </a:xfrm>
                </p:grpSpPr>
                <p:grpSp>
                  <p:nvGrpSpPr>
                    <p:cNvPr id="64" name="Csoportba foglalás 63">
                      <a:extLst>
                        <a:ext uri="{FF2B5EF4-FFF2-40B4-BE49-F238E27FC236}">
                          <a16:creationId xmlns:a16="http://schemas.microsoft.com/office/drawing/2014/main" id="{B4AD5EEC-D641-DD75-B555-162A564A9C94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8367" y="369556"/>
                      <a:ext cx="11964550" cy="2067858"/>
                      <a:chOff x="68367" y="369556"/>
                      <a:chExt cx="11964550" cy="2067858"/>
                    </a:xfrm>
                  </p:grpSpPr>
                  <p:grpSp>
                    <p:nvGrpSpPr>
                      <p:cNvPr id="59" name="Csoportba foglalás 58">
                        <a:extLst>
                          <a:ext uri="{FF2B5EF4-FFF2-40B4-BE49-F238E27FC236}">
                            <a16:creationId xmlns:a16="http://schemas.microsoft.com/office/drawing/2014/main" id="{715D1D3E-2E18-372D-E52B-41F3909C7DC5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68367" y="369556"/>
                        <a:ext cx="11964550" cy="2067858"/>
                        <a:chOff x="68367" y="369556"/>
                        <a:chExt cx="11964550" cy="2067858"/>
                      </a:xfrm>
                    </p:grpSpPr>
                    <p:grpSp>
                      <p:nvGrpSpPr>
                        <p:cNvPr id="5" name="Csoportba foglalás 4">
                          <a:extLst>
                            <a:ext uri="{FF2B5EF4-FFF2-40B4-BE49-F238E27FC236}">
                              <a16:creationId xmlns:a16="http://schemas.microsoft.com/office/drawing/2014/main" id="{D19E9195-56FF-7644-5F6B-962584644085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68367" y="369556"/>
                          <a:ext cx="11964550" cy="2067858"/>
                          <a:chOff x="68367" y="369556"/>
                          <a:chExt cx="11964550" cy="2067858"/>
                        </a:xfrm>
                      </p:grpSpPr>
                      <p:sp>
                        <p:nvSpPr>
                          <p:cNvPr id="6" name="Szövegdoboz 5">
                            <a:extLst>
                              <a:ext uri="{FF2B5EF4-FFF2-40B4-BE49-F238E27FC236}">
                                <a16:creationId xmlns:a16="http://schemas.microsoft.com/office/drawing/2014/main" id="{80894135-D86A-AC01-A0CD-37C6BE8434BD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469568" y="1517669"/>
                            <a:ext cx="470000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hu-HU" sz="800" dirty="0"/>
                              <a:t>DMSO</a:t>
                            </a:r>
                          </a:p>
                        </p:txBody>
                      </p:sp>
                      <p:sp>
                        <p:nvSpPr>
                          <p:cNvPr id="7" name="Szövegdoboz 6">
                            <a:extLst>
                              <a:ext uri="{FF2B5EF4-FFF2-40B4-BE49-F238E27FC236}">
                                <a16:creationId xmlns:a16="http://schemas.microsoft.com/office/drawing/2014/main" id="{E5061F98-CBF0-8DAD-3C40-2C939D1FA229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777554" y="1514516"/>
                            <a:ext cx="457176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hu-HU" sz="800" dirty="0"/>
                              <a:t>UDCA</a:t>
                            </a:r>
                          </a:p>
                        </p:txBody>
                      </p:sp>
                      <p:sp>
                        <p:nvSpPr>
                          <p:cNvPr id="8" name="Szövegdoboz 7">
                            <a:extLst>
                              <a:ext uri="{FF2B5EF4-FFF2-40B4-BE49-F238E27FC236}">
                                <a16:creationId xmlns:a16="http://schemas.microsoft.com/office/drawing/2014/main" id="{4E24F3AD-0CA4-9D57-2CD3-13D022A3C0D7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835719" y="1514516"/>
                            <a:ext cx="470000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hu-HU" sz="800" dirty="0"/>
                              <a:t>DMSO</a:t>
                            </a:r>
                          </a:p>
                        </p:txBody>
                      </p:sp>
                      <p:sp>
                        <p:nvSpPr>
                          <p:cNvPr id="9" name="Szövegdoboz 8">
                            <a:extLst>
                              <a:ext uri="{FF2B5EF4-FFF2-40B4-BE49-F238E27FC236}">
                                <a16:creationId xmlns:a16="http://schemas.microsoft.com/office/drawing/2014/main" id="{940F2034-FC42-9279-EF06-681DB1785418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161223" y="1510630"/>
                            <a:ext cx="457176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hu-HU" sz="800" dirty="0"/>
                              <a:t>UDCA</a:t>
                            </a:r>
                          </a:p>
                        </p:txBody>
                      </p:sp>
                      <p:sp>
                        <p:nvSpPr>
                          <p:cNvPr id="10" name="Szövegdoboz 9">
                            <a:extLst>
                              <a:ext uri="{FF2B5EF4-FFF2-40B4-BE49-F238E27FC236}">
                                <a16:creationId xmlns:a16="http://schemas.microsoft.com/office/drawing/2014/main" id="{52DFBA5B-6853-5849-32DB-BD4C4870312C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3066053" y="1517669"/>
                            <a:ext cx="470000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hu-HU" sz="800" dirty="0"/>
                              <a:t>DMSO</a:t>
                            </a:r>
                          </a:p>
                        </p:txBody>
                      </p:sp>
                      <p:sp>
                        <p:nvSpPr>
                          <p:cNvPr id="11" name="Szövegdoboz 10">
                            <a:extLst>
                              <a:ext uri="{FF2B5EF4-FFF2-40B4-BE49-F238E27FC236}">
                                <a16:creationId xmlns:a16="http://schemas.microsoft.com/office/drawing/2014/main" id="{DAA0A2A1-7ADF-468F-3A12-CD79E03DE3F2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3361215" y="1514516"/>
                            <a:ext cx="457176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hu-HU" sz="800" dirty="0"/>
                              <a:t>UDCA</a:t>
                            </a:r>
                          </a:p>
                        </p:txBody>
                      </p:sp>
                      <p:grpSp>
                        <p:nvGrpSpPr>
                          <p:cNvPr id="13" name="Csoportba foglalás 12">
                            <a:extLst>
                              <a:ext uri="{FF2B5EF4-FFF2-40B4-BE49-F238E27FC236}">
                                <a16:creationId xmlns:a16="http://schemas.microsoft.com/office/drawing/2014/main" id="{344FAD98-550F-A37A-43A2-9190AF04ADAD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68367" y="369556"/>
                            <a:ext cx="11964550" cy="2067858"/>
                            <a:chOff x="68367" y="369556"/>
                            <a:chExt cx="11964550" cy="2067858"/>
                          </a:xfrm>
                        </p:grpSpPr>
                        <p:grpSp>
                          <p:nvGrpSpPr>
                            <p:cNvPr id="17" name="Csoportba foglalás 16">
                              <a:extLst>
                                <a:ext uri="{FF2B5EF4-FFF2-40B4-BE49-F238E27FC236}">
                                  <a16:creationId xmlns:a16="http://schemas.microsoft.com/office/drawing/2014/main" id="{0B665ECA-D8ED-FBD4-F8A5-FB69FDDB9F69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68367" y="369556"/>
                              <a:ext cx="11964550" cy="2067858"/>
                              <a:chOff x="68367" y="369556"/>
                              <a:chExt cx="11964550" cy="2067858"/>
                            </a:xfrm>
                          </p:grpSpPr>
                          <p:sp>
                            <p:nvSpPr>
                              <p:cNvPr id="24" name="Szövegdoboz 23">
                                <a:extLst>
                                  <a:ext uri="{FF2B5EF4-FFF2-40B4-BE49-F238E27FC236}">
                                    <a16:creationId xmlns:a16="http://schemas.microsoft.com/office/drawing/2014/main" id="{B383022D-54D6-BE7D-A34A-AC12888A21B8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2536142" y="677956"/>
                                <a:ext cx="470000" cy="215444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r>
                                  <a:rPr lang="hu-HU" sz="800" dirty="0"/>
                                  <a:t>DMSO</a:t>
                                </a:r>
                              </a:p>
                            </p:txBody>
                          </p:sp>
                          <p:sp>
                            <p:nvSpPr>
                              <p:cNvPr id="25" name="Szövegdoboz 24">
                                <a:extLst>
                                  <a:ext uri="{FF2B5EF4-FFF2-40B4-BE49-F238E27FC236}">
                                    <a16:creationId xmlns:a16="http://schemas.microsoft.com/office/drawing/2014/main" id="{C176FB1B-C1D7-7E61-D59B-03CC608B3FB2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2861533" y="684732"/>
                                <a:ext cx="457176" cy="215444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r>
                                  <a:rPr lang="hu-HU" sz="800" dirty="0"/>
                                  <a:t>UDCA</a:t>
                                </a:r>
                              </a:p>
                            </p:txBody>
                          </p:sp>
                          <p:grpSp>
                            <p:nvGrpSpPr>
                              <p:cNvPr id="40" name="Csoportba foglalás 39">
                                <a:extLst>
                                  <a:ext uri="{FF2B5EF4-FFF2-40B4-BE49-F238E27FC236}">
                                    <a16:creationId xmlns:a16="http://schemas.microsoft.com/office/drawing/2014/main" id="{6E50ACA3-C270-D181-7EF5-9146E8BE0C0B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68367" y="369556"/>
                                <a:ext cx="11964550" cy="2067858"/>
                                <a:chOff x="68367" y="406763"/>
                                <a:chExt cx="11964550" cy="2067858"/>
                              </a:xfrm>
                            </p:grpSpPr>
                            <p:sp>
                              <p:nvSpPr>
                                <p:cNvPr id="45" name="Szövegdoboz 44">
                                  <a:extLst>
                                    <a:ext uri="{FF2B5EF4-FFF2-40B4-BE49-F238E27FC236}">
                                      <a16:creationId xmlns:a16="http://schemas.microsoft.com/office/drawing/2014/main" id="{A7FD32B1-E076-2D99-2E50-5C2FC60631DC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68367" y="1048238"/>
                                  <a:ext cx="999857" cy="307777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1400" dirty="0" err="1"/>
                                    <a:t>Slug</a:t>
                                  </a:r>
                                  <a:r>
                                    <a:rPr lang="hu-HU" sz="1400" dirty="0"/>
                                    <a:t>:</a:t>
                                  </a:r>
                                </a:p>
                              </p:txBody>
                            </p:sp>
                            <p:sp>
                              <p:nvSpPr>
                                <p:cNvPr id="46" name="Szövegdoboz 45">
                                  <a:extLst>
                                    <a:ext uri="{FF2B5EF4-FFF2-40B4-BE49-F238E27FC236}">
                                      <a16:creationId xmlns:a16="http://schemas.microsoft.com/office/drawing/2014/main" id="{053A422C-C925-211C-9741-2E9F0DF12DBC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68367" y="1815547"/>
                                  <a:ext cx="1046556" cy="307777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1400" dirty="0"/>
                                    <a:t>β-</a:t>
                                  </a:r>
                                  <a:r>
                                    <a:rPr lang="hu-HU" sz="1400" dirty="0" err="1"/>
                                    <a:t>actin</a:t>
                                  </a:r>
                                  <a:r>
                                    <a:rPr lang="hu-HU" sz="1400" dirty="0"/>
                                    <a:t>:</a:t>
                                  </a:r>
                                </a:p>
                              </p:txBody>
                            </p:sp>
                            <p:grpSp>
                              <p:nvGrpSpPr>
                                <p:cNvPr id="47" name="Csoportba foglalás 46">
                                  <a:extLst>
                                    <a:ext uri="{FF2B5EF4-FFF2-40B4-BE49-F238E27FC236}">
                                      <a16:creationId xmlns:a16="http://schemas.microsoft.com/office/drawing/2014/main" id="{DA522FFC-5F1D-62D1-D121-3BA90ADF6AF6}"/>
                                    </a:ext>
                                  </a:extLst>
                                </p:cNvPr>
                                <p:cNvGrpSpPr/>
                                <p:nvPr/>
                              </p:nvGrpSpPr>
                              <p:grpSpPr>
                                <a:xfrm>
                                  <a:off x="1773736" y="406763"/>
                                  <a:ext cx="837995" cy="523988"/>
                                  <a:chOff x="1773736" y="406763"/>
                                  <a:chExt cx="837995" cy="523988"/>
                                </a:xfrm>
                              </p:grpSpPr>
                              <p:grpSp>
                                <p:nvGrpSpPr>
                                  <p:cNvPr id="51" name="Csoportba foglalás 50">
                                    <a:extLst>
                                      <a:ext uri="{FF2B5EF4-FFF2-40B4-BE49-F238E27FC236}">
                                        <a16:creationId xmlns:a16="http://schemas.microsoft.com/office/drawing/2014/main" id="{F8C6DB1E-515B-B5E1-8DCC-B23227B0FCDC}"/>
                                      </a:ext>
                                    </a:extLst>
                                  </p:cNvPr>
                                  <p:cNvGrpSpPr/>
                                  <p:nvPr/>
                                </p:nvGrpSpPr>
                                <p:grpSpPr>
                                  <a:xfrm>
                                    <a:off x="1804977" y="715163"/>
                                    <a:ext cx="806754" cy="215588"/>
                                    <a:chOff x="1804977" y="339153"/>
                                    <a:chExt cx="806754" cy="215588"/>
                                  </a:xfrm>
                                </p:grpSpPr>
                                <p:sp>
                                  <p:nvSpPr>
                                    <p:cNvPr id="53" name="Szövegdoboz 52">
                                      <a:extLst>
                                        <a:ext uri="{FF2B5EF4-FFF2-40B4-BE49-F238E27FC236}">
                                          <a16:creationId xmlns:a16="http://schemas.microsoft.com/office/drawing/2014/main" id="{BC7806BB-4C67-BF6F-9974-E388D0C6AFE1}"/>
                                        </a:ext>
                                      </a:extLst>
                                    </p:cNvPr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1804977" y="339153"/>
                                      <a:ext cx="470000" cy="2154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none" rtlCol="0">
                                      <a:spAutoFit/>
                                    </a:bodyPr>
                                    <a:lstStyle/>
                                    <a:p>
                                      <a:r>
                                        <a:rPr lang="hu-HU" sz="800" dirty="0"/>
                                        <a:t>DMSO</a:t>
                                      </a:r>
                                    </a:p>
                                  </p:txBody>
                                </p:sp>
                                <p:sp>
                                  <p:nvSpPr>
                                    <p:cNvPr id="54" name="Szövegdoboz 53">
                                      <a:extLst>
                                        <a:ext uri="{FF2B5EF4-FFF2-40B4-BE49-F238E27FC236}">
                                          <a16:creationId xmlns:a16="http://schemas.microsoft.com/office/drawing/2014/main" id="{D302C31B-FA24-8D17-B4AB-14900B67D410}"/>
                                        </a:ext>
                                      </a:extLst>
                                    </p:cNvPr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2154555" y="339297"/>
                                      <a:ext cx="457176" cy="2154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none" rtlCol="0">
                                      <a:spAutoFit/>
                                    </a:bodyPr>
                                    <a:lstStyle/>
                                    <a:p>
                                      <a:r>
                                        <a:rPr lang="hu-HU" sz="800" dirty="0"/>
                                        <a:t>UDCA</a:t>
                                      </a:r>
                                    </a:p>
                                  </p:txBody>
                                </p:sp>
                              </p:grpSp>
                              <p:sp>
                                <p:nvSpPr>
                                  <p:cNvPr id="52" name="Szövegdoboz 51">
                                    <a:extLst>
                                      <a:ext uri="{FF2B5EF4-FFF2-40B4-BE49-F238E27FC236}">
                                        <a16:creationId xmlns:a16="http://schemas.microsoft.com/office/drawing/2014/main" id="{3EC3353D-E356-4C5D-0C03-98D9C2D47714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1773736" y="406763"/>
                                    <a:ext cx="332142" cy="307777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hu-HU" sz="1400" b="1" dirty="0"/>
                                      <a:t>1.</a:t>
                                    </a:r>
                                  </a:p>
                                </p:txBody>
                              </p:sp>
                            </p:grpSp>
                            <p:sp>
                              <p:nvSpPr>
                                <p:cNvPr id="48" name="Szövegdoboz 47">
                                  <a:extLst>
                                    <a:ext uri="{FF2B5EF4-FFF2-40B4-BE49-F238E27FC236}">
                                      <a16:creationId xmlns:a16="http://schemas.microsoft.com/office/drawing/2014/main" id="{A73E890E-07AD-B4F8-CAC2-0F018D55592A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2507866" y="415477"/>
                                  <a:ext cx="335348" cy="307777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non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1400" b="1" dirty="0"/>
                                    <a:t>2.</a:t>
                                  </a:r>
                                </a:p>
                              </p:txBody>
                            </p:sp>
                            <p:sp>
                              <p:nvSpPr>
                                <p:cNvPr id="49" name="Szövegdoboz 48">
                                  <a:extLst>
                                    <a:ext uri="{FF2B5EF4-FFF2-40B4-BE49-F238E27FC236}">
                                      <a16:creationId xmlns:a16="http://schemas.microsoft.com/office/drawing/2014/main" id="{95980EA9-91A9-27D8-737C-BC9283CC78C9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3163309" y="415477"/>
                                  <a:ext cx="335348" cy="307777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non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1400" b="1" dirty="0"/>
                                    <a:t>3.</a:t>
                                  </a:r>
                                </a:p>
                              </p:txBody>
                            </p:sp>
                            <p:sp>
                              <p:nvSpPr>
                                <p:cNvPr id="50" name="Téglalap 49">
                                  <a:extLst>
                                    <a:ext uri="{FF2B5EF4-FFF2-40B4-BE49-F238E27FC236}">
                                      <a16:creationId xmlns:a16="http://schemas.microsoft.com/office/drawing/2014/main" id="{B7A25ADC-2111-0F7F-C3DA-42D4A0F0723F}"/>
                                    </a:ext>
                                  </a:extLst>
                                </p:cNvPr>
                                <p:cNvSpPr/>
                                <p:nvPr/>
                              </p:nvSpPr>
                              <p:spPr>
                                <a:xfrm>
                                  <a:off x="70822" y="474905"/>
                                  <a:ext cx="11962095" cy="1999716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style>
                                <a:lnRef idx="2">
                                  <a:schemeClr val="accent1">
                                    <a:shade val="15000"/>
                                  </a:schemeClr>
                                </a:lnRef>
                                <a:fillRef idx="1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lt1"/>
                                </a:fontRef>
                              </p:style>
                              <p:txBody>
                                <a:bodyPr rtlCol="0" anchor="ctr"/>
                                <a:lstStyle/>
                                <a:p>
                                  <a:pPr algn="ctr"/>
                                  <a:endParaRPr lang="hu-HU"/>
                                </a:p>
                              </p:txBody>
                            </p:sp>
                          </p:grpSp>
                        </p:grpSp>
                        <p:sp>
                          <p:nvSpPr>
                            <p:cNvPr id="19" name="Szövegdoboz 18">
                              <a:extLst>
                                <a:ext uri="{FF2B5EF4-FFF2-40B4-BE49-F238E27FC236}">
                                  <a16:creationId xmlns:a16="http://schemas.microsoft.com/office/drawing/2014/main" id="{67A0012B-6C92-77EB-A15E-D35E8E34D864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3168055" y="675392"/>
                              <a:ext cx="470000" cy="215444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r>
                                <a:rPr lang="hu-HU" sz="800" dirty="0"/>
                                <a:t>DMSO</a:t>
                              </a:r>
                            </a:p>
                          </p:txBody>
                        </p:sp>
                        <p:sp>
                          <p:nvSpPr>
                            <p:cNvPr id="20" name="Szövegdoboz 19">
                              <a:extLst>
                                <a:ext uri="{FF2B5EF4-FFF2-40B4-BE49-F238E27FC236}">
                                  <a16:creationId xmlns:a16="http://schemas.microsoft.com/office/drawing/2014/main" id="{9095EBC2-DC3C-201A-053A-9660443DCBD8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3461900" y="677956"/>
                              <a:ext cx="457176" cy="215444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r>
                                <a:rPr lang="hu-HU" sz="800" dirty="0"/>
                                <a:t>UDCA</a:t>
                              </a:r>
                            </a:p>
                          </p:txBody>
                        </p:sp>
                      </p:grpSp>
                    </p:grpSp>
                    <p:sp>
                      <p:nvSpPr>
                        <p:cNvPr id="58" name="Szövegdoboz 57">
                          <a:extLst>
                            <a:ext uri="{FF2B5EF4-FFF2-40B4-BE49-F238E27FC236}">
                              <a16:creationId xmlns:a16="http://schemas.microsoft.com/office/drawing/2014/main" id="{7BCE613E-9881-3416-2125-35B072B17A57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499097" y="912658"/>
                          <a:ext cx="293670" cy="21544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hu-HU" sz="800" dirty="0"/>
                            <a:t>35</a:t>
                          </a:r>
                        </a:p>
                      </p:txBody>
                    </p:sp>
                  </p:grpSp>
                  <p:sp>
                    <p:nvSpPr>
                      <p:cNvPr id="63" name="Szövegdoboz 62">
                        <a:extLst>
                          <a:ext uri="{FF2B5EF4-FFF2-40B4-BE49-F238E27FC236}">
                            <a16:creationId xmlns:a16="http://schemas.microsoft.com/office/drawing/2014/main" id="{52638783-B906-8A1B-4043-039F36C1BC9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491238" y="1696650"/>
                        <a:ext cx="29367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hu-HU" sz="800" dirty="0"/>
                          <a:t>55</a:t>
                        </a:r>
                      </a:p>
                    </p:txBody>
                  </p:sp>
                </p:grpSp>
                <p:sp>
                  <p:nvSpPr>
                    <p:cNvPr id="74" name="Szövegdoboz 73">
                      <a:extLst>
                        <a:ext uri="{FF2B5EF4-FFF2-40B4-BE49-F238E27FC236}">
                          <a16:creationId xmlns:a16="http://schemas.microsoft.com/office/drawing/2014/main" id="{A1F3D7F7-77FF-666B-DA74-8942EBE553D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61135" y="2068132"/>
                      <a:ext cx="184731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endParaRPr lang="hu-HU" sz="800" dirty="0"/>
                    </a:p>
                  </p:txBody>
                </p:sp>
                <p:sp>
                  <p:nvSpPr>
                    <p:cNvPr id="75" name="Szövegdoboz 74">
                      <a:extLst>
                        <a:ext uri="{FF2B5EF4-FFF2-40B4-BE49-F238E27FC236}">
                          <a16:creationId xmlns:a16="http://schemas.microsoft.com/office/drawing/2014/main" id="{0C0B3557-82EA-5AD1-395C-D6A412B7E2B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62703" y="1654921"/>
                      <a:ext cx="184731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endParaRPr lang="hu-HU" sz="800" dirty="0"/>
                    </a:p>
                  </p:txBody>
                </p:sp>
              </p:grpSp>
              <p:sp>
                <p:nvSpPr>
                  <p:cNvPr id="32" name="Szövegdoboz 31">
                    <a:extLst>
                      <a:ext uri="{FF2B5EF4-FFF2-40B4-BE49-F238E27FC236}">
                        <a16:creationId xmlns:a16="http://schemas.microsoft.com/office/drawing/2014/main" id="{49E32803-410D-70C9-2AB1-36653C6082DB}"/>
                      </a:ext>
                    </a:extLst>
                  </p:cNvPr>
                  <p:cNvSpPr txBox="1"/>
                  <p:nvPr/>
                </p:nvSpPr>
                <p:spPr>
                  <a:xfrm>
                    <a:off x="1483379" y="2150710"/>
                    <a:ext cx="29367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hu-HU" sz="800" dirty="0"/>
                      <a:t>35</a:t>
                    </a:r>
                  </a:p>
                </p:txBody>
              </p:sp>
            </p:grpSp>
            <p:sp>
              <p:nvSpPr>
                <p:cNvPr id="38" name="Szövegdoboz 37">
                  <a:extLst>
                    <a:ext uri="{FF2B5EF4-FFF2-40B4-BE49-F238E27FC236}">
                      <a16:creationId xmlns:a16="http://schemas.microsoft.com/office/drawing/2014/main" id="{B5FC670A-4A6C-A292-B6EF-147F6E6B2A52}"/>
                    </a:ext>
                  </a:extLst>
                </p:cNvPr>
                <p:cNvSpPr txBox="1"/>
                <p:nvPr/>
              </p:nvSpPr>
              <p:spPr>
                <a:xfrm>
                  <a:off x="8627333" y="763394"/>
                  <a:ext cx="18473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endParaRPr lang="hu-HU" sz="800" dirty="0"/>
                </a:p>
              </p:txBody>
            </p:sp>
            <p:sp>
              <p:nvSpPr>
                <p:cNvPr id="43" name="Szövegdoboz 42">
                  <a:extLst>
                    <a:ext uri="{FF2B5EF4-FFF2-40B4-BE49-F238E27FC236}">
                      <a16:creationId xmlns:a16="http://schemas.microsoft.com/office/drawing/2014/main" id="{2A919964-D2CA-CDE1-65B6-6078863A4191}"/>
                    </a:ext>
                  </a:extLst>
                </p:cNvPr>
                <p:cNvSpPr txBox="1"/>
                <p:nvPr/>
              </p:nvSpPr>
              <p:spPr>
                <a:xfrm>
                  <a:off x="8621044" y="1228453"/>
                  <a:ext cx="18473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endParaRPr lang="hu-HU" sz="800" dirty="0"/>
                </a:p>
              </p:txBody>
            </p:sp>
          </p:grpSp>
          <p:sp>
            <p:nvSpPr>
              <p:cNvPr id="73" name="Szövegdoboz 72">
                <a:extLst>
                  <a:ext uri="{FF2B5EF4-FFF2-40B4-BE49-F238E27FC236}">
                    <a16:creationId xmlns:a16="http://schemas.microsoft.com/office/drawing/2014/main" id="{34721B97-5A92-383A-BB69-ED2EA97CF31C}"/>
                  </a:ext>
                </a:extLst>
              </p:cNvPr>
              <p:cNvSpPr txBox="1"/>
              <p:nvPr/>
            </p:nvSpPr>
            <p:spPr>
              <a:xfrm>
                <a:off x="8621039" y="2105143"/>
                <a:ext cx="18473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endParaRPr lang="hu-HU" sz="800" dirty="0"/>
              </a:p>
            </p:txBody>
          </p:sp>
        </p:grpSp>
        <p:sp>
          <p:nvSpPr>
            <p:cNvPr id="31" name="Szövegdoboz 30">
              <a:extLst>
                <a:ext uri="{FF2B5EF4-FFF2-40B4-BE49-F238E27FC236}">
                  <a16:creationId xmlns:a16="http://schemas.microsoft.com/office/drawing/2014/main" id="{8F3066F1-631C-A8B1-20A3-2AAF6D613284}"/>
                </a:ext>
              </a:extLst>
            </p:cNvPr>
            <p:cNvSpPr txBox="1"/>
            <p:nvPr/>
          </p:nvSpPr>
          <p:spPr>
            <a:xfrm>
              <a:off x="1500665" y="1263025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00" dirty="0"/>
                <a:t>25</a:t>
              </a:r>
            </a:p>
          </p:txBody>
        </p:sp>
      </p:grpSp>
      <p:pic>
        <p:nvPicPr>
          <p:cNvPr id="3" name="Kép 2" descr="A képen képernyőkép, fekete, Téglalap, sötétség látható&#10;&#10;Automatikusan generált leírás">
            <a:extLst>
              <a:ext uri="{FF2B5EF4-FFF2-40B4-BE49-F238E27FC236}">
                <a16:creationId xmlns:a16="http://schemas.microsoft.com/office/drawing/2014/main" id="{C313F1ED-113B-237B-5879-8F08E3EE6E4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017" t="68319" r="21156" b="15304"/>
          <a:stretch/>
        </p:blipFill>
        <p:spPr>
          <a:xfrm>
            <a:off x="1777049" y="1708673"/>
            <a:ext cx="2109049" cy="6454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Kép 15">
            <a:extLst>
              <a:ext uri="{FF2B5EF4-FFF2-40B4-BE49-F238E27FC236}">
                <a16:creationId xmlns:a16="http://schemas.microsoft.com/office/drawing/2014/main" id="{890AD990-B4AD-84EE-9ACC-A9A08B4FEB6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36" t="47672" r="32419" b="36524"/>
          <a:stretch/>
        </p:blipFill>
        <p:spPr>
          <a:xfrm>
            <a:off x="1775202" y="860495"/>
            <a:ext cx="2109049" cy="641998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41" name="Csoportba foglalás 40">
            <a:extLst>
              <a:ext uri="{FF2B5EF4-FFF2-40B4-BE49-F238E27FC236}">
                <a16:creationId xmlns:a16="http://schemas.microsoft.com/office/drawing/2014/main" id="{5E62DB51-87A5-C503-3393-C1CCA31C2493}"/>
              </a:ext>
            </a:extLst>
          </p:cNvPr>
          <p:cNvGrpSpPr/>
          <p:nvPr/>
        </p:nvGrpSpPr>
        <p:grpSpPr>
          <a:xfrm>
            <a:off x="59401" y="2508542"/>
            <a:ext cx="11964551" cy="1999716"/>
            <a:chOff x="68366" y="437698"/>
            <a:chExt cx="11964551" cy="1999716"/>
          </a:xfrm>
        </p:grpSpPr>
        <p:grpSp>
          <p:nvGrpSpPr>
            <p:cNvPr id="61" name="Csoportba foglalás 60">
              <a:extLst>
                <a:ext uri="{FF2B5EF4-FFF2-40B4-BE49-F238E27FC236}">
                  <a16:creationId xmlns:a16="http://schemas.microsoft.com/office/drawing/2014/main" id="{373D09B7-BFB0-E03B-F0DC-5FB33D908943}"/>
                </a:ext>
              </a:extLst>
            </p:cNvPr>
            <p:cNvGrpSpPr/>
            <p:nvPr/>
          </p:nvGrpSpPr>
          <p:grpSpPr>
            <a:xfrm>
              <a:off x="68366" y="437698"/>
              <a:ext cx="11964551" cy="1999716"/>
              <a:chOff x="68366" y="437698"/>
              <a:chExt cx="11964551" cy="1999716"/>
            </a:xfrm>
          </p:grpSpPr>
          <p:grpSp>
            <p:nvGrpSpPr>
              <p:cNvPr id="65" name="Csoportba foglalás 64">
                <a:extLst>
                  <a:ext uri="{FF2B5EF4-FFF2-40B4-BE49-F238E27FC236}">
                    <a16:creationId xmlns:a16="http://schemas.microsoft.com/office/drawing/2014/main" id="{9D691EFC-E02E-EBC8-CC53-8E969396152F}"/>
                  </a:ext>
                </a:extLst>
              </p:cNvPr>
              <p:cNvGrpSpPr/>
              <p:nvPr/>
            </p:nvGrpSpPr>
            <p:grpSpPr>
              <a:xfrm>
                <a:off x="68366" y="437698"/>
                <a:ext cx="11964551" cy="1999716"/>
                <a:chOff x="68366" y="437698"/>
                <a:chExt cx="11964551" cy="1999716"/>
              </a:xfrm>
            </p:grpSpPr>
            <p:grpSp>
              <p:nvGrpSpPr>
                <p:cNvPr id="67" name="Csoportba foglalás 66">
                  <a:extLst>
                    <a:ext uri="{FF2B5EF4-FFF2-40B4-BE49-F238E27FC236}">
                      <a16:creationId xmlns:a16="http://schemas.microsoft.com/office/drawing/2014/main" id="{14B4FC9C-0634-2F0B-B1CD-F27FECDE8F2F}"/>
                    </a:ext>
                  </a:extLst>
                </p:cNvPr>
                <p:cNvGrpSpPr/>
                <p:nvPr/>
              </p:nvGrpSpPr>
              <p:grpSpPr>
                <a:xfrm>
                  <a:off x="68366" y="437698"/>
                  <a:ext cx="11964551" cy="1999716"/>
                  <a:chOff x="68366" y="437698"/>
                  <a:chExt cx="11964551" cy="1999716"/>
                </a:xfrm>
              </p:grpSpPr>
              <p:grpSp>
                <p:nvGrpSpPr>
                  <p:cNvPr id="79" name="Csoportba foglalás 78">
                    <a:extLst>
                      <a:ext uri="{FF2B5EF4-FFF2-40B4-BE49-F238E27FC236}">
                        <a16:creationId xmlns:a16="http://schemas.microsoft.com/office/drawing/2014/main" id="{688F6423-61FB-BC56-8B65-C62A5F2552A9}"/>
                      </a:ext>
                    </a:extLst>
                  </p:cNvPr>
                  <p:cNvGrpSpPr/>
                  <p:nvPr/>
                </p:nvGrpSpPr>
                <p:grpSpPr>
                  <a:xfrm>
                    <a:off x="68366" y="437698"/>
                    <a:ext cx="11964551" cy="1999716"/>
                    <a:chOff x="68366" y="437698"/>
                    <a:chExt cx="11964551" cy="1999716"/>
                  </a:xfrm>
                </p:grpSpPr>
                <p:grpSp>
                  <p:nvGrpSpPr>
                    <p:cNvPr id="83" name="Csoportba foglalás 82">
                      <a:extLst>
                        <a:ext uri="{FF2B5EF4-FFF2-40B4-BE49-F238E27FC236}">
                          <a16:creationId xmlns:a16="http://schemas.microsoft.com/office/drawing/2014/main" id="{182327A8-9669-9895-53DA-79B2132F8A6F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8366" y="437698"/>
                      <a:ext cx="11964551" cy="1999716"/>
                      <a:chOff x="68366" y="437698"/>
                      <a:chExt cx="11964551" cy="1999716"/>
                    </a:xfrm>
                  </p:grpSpPr>
                  <p:grpSp>
                    <p:nvGrpSpPr>
                      <p:cNvPr id="85" name="Csoportba foglalás 84">
                        <a:extLst>
                          <a:ext uri="{FF2B5EF4-FFF2-40B4-BE49-F238E27FC236}">
                            <a16:creationId xmlns:a16="http://schemas.microsoft.com/office/drawing/2014/main" id="{BFDEDFCA-0B98-06E6-9F4E-8E9F04321CBB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68366" y="437698"/>
                        <a:ext cx="11964551" cy="1999716"/>
                        <a:chOff x="68366" y="437698"/>
                        <a:chExt cx="11964551" cy="1999716"/>
                      </a:xfrm>
                    </p:grpSpPr>
                    <p:grpSp>
                      <p:nvGrpSpPr>
                        <p:cNvPr id="90" name="Csoportba foglalás 89">
                          <a:extLst>
                            <a:ext uri="{FF2B5EF4-FFF2-40B4-BE49-F238E27FC236}">
                              <a16:creationId xmlns:a16="http://schemas.microsoft.com/office/drawing/2014/main" id="{46BDF15E-C49E-698F-A45E-42C12C4BD5C0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68366" y="437698"/>
                          <a:ext cx="11964551" cy="1999716"/>
                          <a:chOff x="68366" y="437698"/>
                          <a:chExt cx="11964551" cy="1999716"/>
                        </a:xfrm>
                      </p:grpSpPr>
                      <p:grpSp>
                        <p:nvGrpSpPr>
                          <p:cNvPr id="94" name="Csoportba foglalás 93">
                            <a:extLst>
                              <a:ext uri="{FF2B5EF4-FFF2-40B4-BE49-F238E27FC236}">
                                <a16:creationId xmlns:a16="http://schemas.microsoft.com/office/drawing/2014/main" id="{063CE047-39C3-4B64-A010-2868E461C40E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68366" y="437698"/>
                            <a:ext cx="11964551" cy="1999716"/>
                            <a:chOff x="68366" y="437698"/>
                            <a:chExt cx="11964551" cy="1999716"/>
                          </a:xfrm>
                        </p:grpSpPr>
                        <p:grpSp>
                          <p:nvGrpSpPr>
                            <p:cNvPr id="96" name="Csoportba foglalás 95">
                              <a:extLst>
                                <a:ext uri="{FF2B5EF4-FFF2-40B4-BE49-F238E27FC236}">
                                  <a16:creationId xmlns:a16="http://schemas.microsoft.com/office/drawing/2014/main" id="{7552C3DB-891C-3C40-60E8-8AC22DB0BCE2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68366" y="437698"/>
                              <a:ext cx="11964551" cy="1999716"/>
                              <a:chOff x="68366" y="437698"/>
                              <a:chExt cx="11964551" cy="1999716"/>
                            </a:xfrm>
                          </p:grpSpPr>
                          <p:sp>
                            <p:nvSpPr>
                              <p:cNvPr id="102" name="Szövegdoboz 101">
                                <a:extLst>
                                  <a:ext uri="{FF2B5EF4-FFF2-40B4-BE49-F238E27FC236}">
                                    <a16:creationId xmlns:a16="http://schemas.microsoft.com/office/drawing/2014/main" id="{2F3F149C-EE1C-088D-2DD6-2EE80D47452E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2508679" y="1493623"/>
                                <a:ext cx="470000" cy="215444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r>
                                  <a:rPr lang="hu-HU" sz="800" dirty="0"/>
                                  <a:t>DMSO</a:t>
                                </a:r>
                              </a:p>
                            </p:txBody>
                          </p:sp>
                          <p:sp>
                            <p:nvSpPr>
                              <p:cNvPr id="103" name="Szövegdoboz 102">
                                <a:extLst>
                                  <a:ext uri="{FF2B5EF4-FFF2-40B4-BE49-F238E27FC236}">
                                    <a16:creationId xmlns:a16="http://schemas.microsoft.com/office/drawing/2014/main" id="{120DB450-29CA-27E9-5E77-58163D06CAB5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2814653" y="1497117"/>
                                <a:ext cx="457176" cy="215444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r>
                                  <a:rPr lang="hu-HU" sz="800" dirty="0"/>
                                  <a:t>UDCA</a:t>
                                </a:r>
                              </a:p>
                            </p:txBody>
                          </p:sp>
                          <p:sp>
                            <p:nvSpPr>
                              <p:cNvPr id="104" name="Szövegdoboz 103">
                                <a:extLst>
                                  <a:ext uri="{FF2B5EF4-FFF2-40B4-BE49-F238E27FC236}">
                                    <a16:creationId xmlns:a16="http://schemas.microsoft.com/office/drawing/2014/main" id="{CE71DA6A-4A54-3E9D-1ABB-3AB739E99994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1789269" y="1503801"/>
                                <a:ext cx="470000" cy="215444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r>
                                  <a:rPr lang="hu-HU" sz="800" dirty="0"/>
                                  <a:t>DMSO</a:t>
                                </a:r>
                              </a:p>
                            </p:txBody>
                          </p:sp>
                          <p:sp>
                            <p:nvSpPr>
                              <p:cNvPr id="105" name="Szövegdoboz 104">
                                <a:extLst>
                                  <a:ext uri="{FF2B5EF4-FFF2-40B4-BE49-F238E27FC236}">
                                    <a16:creationId xmlns:a16="http://schemas.microsoft.com/office/drawing/2014/main" id="{CCC60A4E-D66F-6A34-7D02-11EC3E26D1D6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2131192" y="1504501"/>
                                <a:ext cx="457176" cy="215444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r>
                                  <a:rPr lang="hu-HU" sz="800" dirty="0"/>
                                  <a:t>UDCA</a:t>
                                </a:r>
                              </a:p>
                            </p:txBody>
                          </p:sp>
                          <p:sp>
                            <p:nvSpPr>
                              <p:cNvPr id="106" name="Szövegdoboz 105">
                                <a:extLst>
                                  <a:ext uri="{FF2B5EF4-FFF2-40B4-BE49-F238E27FC236}">
                                    <a16:creationId xmlns:a16="http://schemas.microsoft.com/office/drawing/2014/main" id="{602E4383-3344-CB82-3232-E8F8677ED61C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3107803" y="1493528"/>
                                <a:ext cx="470000" cy="215444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r>
                                  <a:rPr lang="hu-HU" sz="800" dirty="0"/>
                                  <a:t>DMSO</a:t>
                                </a:r>
                              </a:p>
                            </p:txBody>
                          </p:sp>
                          <p:sp>
                            <p:nvSpPr>
                              <p:cNvPr id="107" name="Szövegdoboz 106">
                                <a:extLst>
                                  <a:ext uri="{FF2B5EF4-FFF2-40B4-BE49-F238E27FC236}">
                                    <a16:creationId xmlns:a16="http://schemas.microsoft.com/office/drawing/2014/main" id="{7B86DE3A-2D49-A525-A14D-AEA5F0F91EDC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3395362" y="1497117"/>
                                <a:ext cx="457176" cy="215444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r>
                                  <a:rPr lang="hu-HU" sz="800" dirty="0"/>
                                  <a:t>UDCA</a:t>
                                </a:r>
                              </a:p>
                            </p:txBody>
                          </p:sp>
                          <p:grpSp>
                            <p:nvGrpSpPr>
                              <p:cNvPr id="108" name="Csoportba foglalás 107">
                                <a:extLst>
                                  <a:ext uri="{FF2B5EF4-FFF2-40B4-BE49-F238E27FC236}">
                                    <a16:creationId xmlns:a16="http://schemas.microsoft.com/office/drawing/2014/main" id="{36C0E59A-CBD1-4C03-B9DE-8E4A7AB4AEA6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68366" y="437698"/>
                                <a:ext cx="11964551" cy="1999716"/>
                                <a:chOff x="68366" y="437698"/>
                                <a:chExt cx="11964551" cy="1999716"/>
                              </a:xfrm>
                            </p:grpSpPr>
                            <p:grpSp>
                              <p:nvGrpSpPr>
                                <p:cNvPr id="109" name="Csoportba foglalás 108">
                                  <a:extLst>
                                    <a:ext uri="{FF2B5EF4-FFF2-40B4-BE49-F238E27FC236}">
                                      <a16:creationId xmlns:a16="http://schemas.microsoft.com/office/drawing/2014/main" id="{47686C87-19FB-0511-89F4-1A82412FC649}"/>
                                    </a:ext>
                                  </a:extLst>
                                </p:cNvPr>
                                <p:cNvGrpSpPr/>
                                <p:nvPr/>
                              </p:nvGrpSpPr>
                              <p:grpSpPr>
                                <a:xfrm>
                                  <a:off x="68366" y="437698"/>
                                  <a:ext cx="11964551" cy="1999716"/>
                                  <a:chOff x="68366" y="437698"/>
                                  <a:chExt cx="11964551" cy="1999716"/>
                                </a:xfrm>
                              </p:grpSpPr>
                              <p:sp>
                                <p:nvSpPr>
                                  <p:cNvPr id="112" name="Szövegdoboz 111">
                                    <a:extLst>
                                      <a:ext uri="{FF2B5EF4-FFF2-40B4-BE49-F238E27FC236}">
                                        <a16:creationId xmlns:a16="http://schemas.microsoft.com/office/drawing/2014/main" id="{8049E7DE-59C4-FF2F-A538-3EFB042128DC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2502257" y="776265"/>
                                    <a:ext cx="470000" cy="215444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hu-HU" sz="800" dirty="0"/>
                                      <a:t>DMSO</a:t>
                                    </a:r>
                                  </a:p>
                                </p:txBody>
                              </p:sp>
                              <p:sp>
                                <p:nvSpPr>
                                  <p:cNvPr id="113" name="Szövegdoboz 112">
                                    <a:extLst>
                                      <a:ext uri="{FF2B5EF4-FFF2-40B4-BE49-F238E27FC236}">
                                        <a16:creationId xmlns:a16="http://schemas.microsoft.com/office/drawing/2014/main" id="{58B821C9-2491-E25B-BB8F-8C575F6B3D49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2852842" y="783114"/>
                                    <a:ext cx="457176" cy="215444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hu-HU" sz="800" dirty="0"/>
                                      <a:t>UDCA</a:t>
                                    </a:r>
                                  </a:p>
                                </p:txBody>
                              </p:sp>
                              <p:grpSp>
                                <p:nvGrpSpPr>
                                  <p:cNvPr id="114" name="Csoportba foglalás 113">
                                    <a:extLst>
                                      <a:ext uri="{FF2B5EF4-FFF2-40B4-BE49-F238E27FC236}">
                                        <a16:creationId xmlns:a16="http://schemas.microsoft.com/office/drawing/2014/main" id="{4AC11C46-4460-8677-E372-F650F24F7291}"/>
                                      </a:ext>
                                    </a:extLst>
                                  </p:cNvPr>
                                  <p:cNvGrpSpPr/>
                                  <p:nvPr/>
                                </p:nvGrpSpPr>
                                <p:grpSpPr>
                                  <a:xfrm>
                                    <a:off x="68366" y="437698"/>
                                    <a:ext cx="11964551" cy="1999716"/>
                                    <a:chOff x="68366" y="474905"/>
                                    <a:chExt cx="11964551" cy="1999716"/>
                                  </a:xfrm>
                                </p:grpSpPr>
                                <p:sp>
                                  <p:nvSpPr>
                                    <p:cNvPr id="115" name="Szövegdoboz 114">
                                      <a:extLst>
                                        <a:ext uri="{FF2B5EF4-FFF2-40B4-BE49-F238E27FC236}">
                                          <a16:creationId xmlns:a16="http://schemas.microsoft.com/office/drawing/2014/main" id="{3C84FD82-6F5F-2244-D41D-DC0859E22E24}"/>
                                        </a:ext>
                                      </a:extLst>
                                    </p:cNvPr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68367" y="1048238"/>
                                      <a:ext cx="999857" cy="307777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square" rtlCol="0">
                                      <a:spAutoFit/>
                                    </a:bodyPr>
                                    <a:lstStyle/>
                                    <a:p>
                                      <a:r>
                                        <a:rPr lang="hu-HU" sz="1400" dirty="0"/>
                                        <a:t>Nrf2:</a:t>
                                      </a:r>
                                    </a:p>
                                  </p:txBody>
                                </p:sp>
                                <p:sp>
                                  <p:nvSpPr>
                                    <p:cNvPr id="116" name="Szövegdoboz 115">
                                      <a:extLst>
                                        <a:ext uri="{FF2B5EF4-FFF2-40B4-BE49-F238E27FC236}">
                                          <a16:creationId xmlns:a16="http://schemas.microsoft.com/office/drawing/2014/main" id="{40ECC75B-427D-FE12-C117-E9EFB1BDB0BA}"/>
                                        </a:ext>
                                      </a:extLst>
                                    </p:cNvPr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68366" y="1815547"/>
                                      <a:ext cx="1076587" cy="307777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square" rtlCol="0">
                                      <a:spAutoFit/>
                                    </a:bodyPr>
                                    <a:lstStyle/>
                                    <a:p>
                                      <a:r>
                                        <a:rPr lang="hu-HU" sz="1400" dirty="0"/>
                                        <a:t>β-</a:t>
                                      </a:r>
                                      <a:r>
                                        <a:rPr lang="hu-HU" sz="1400" dirty="0" err="1"/>
                                        <a:t>actin</a:t>
                                      </a:r>
                                      <a:r>
                                        <a:rPr lang="hu-HU" sz="1400" dirty="0"/>
                                        <a:t>:</a:t>
                                      </a:r>
                                    </a:p>
                                  </p:txBody>
                                </p:sp>
                                <p:grpSp>
                                  <p:nvGrpSpPr>
                                    <p:cNvPr id="117" name="Csoportba foglalás 116">
                                      <a:extLst>
                                        <a:ext uri="{FF2B5EF4-FFF2-40B4-BE49-F238E27FC236}">
                                          <a16:creationId xmlns:a16="http://schemas.microsoft.com/office/drawing/2014/main" id="{B3402E93-7ED7-A570-0D80-91E5E02945C1}"/>
                                        </a:ext>
                                      </a:extLst>
                                    </p:cNvPr>
                                    <p:cNvGrpSpPr/>
                                    <p:nvPr/>
                                  </p:nvGrpSpPr>
                                  <p:grpSpPr>
                                    <a:xfrm>
                                      <a:off x="1775944" y="494934"/>
                                      <a:ext cx="815426" cy="536563"/>
                                      <a:chOff x="1775944" y="494934"/>
                                      <a:chExt cx="815426" cy="536563"/>
                                    </a:xfrm>
                                  </p:grpSpPr>
                                  <p:grpSp>
                                    <p:nvGrpSpPr>
                                      <p:cNvPr id="121" name="Csoportba foglalás 120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027E38FB-199B-D014-6CF6-6A972B385110}"/>
                                          </a:ext>
                                        </a:extLst>
                                      </p:cNvPr>
                                      <p:cNvGrpSpPr/>
                                      <p:nvPr/>
                                    </p:nvGrpSpPr>
                                    <p:grpSpPr>
                                      <a:xfrm>
                                        <a:off x="1775944" y="816053"/>
                                        <a:ext cx="815426" cy="215444"/>
                                        <a:chOff x="1775944" y="440043"/>
                                        <a:chExt cx="815426" cy="215444"/>
                                      </a:xfrm>
                                    </p:grpSpPr>
                                    <p:sp>
                                      <p:nvSpPr>
                                        <p:cNvPr id="123" name="Szövegdoboz 122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7A52ECCD-2AE0-4FE0-D3E1-F383BC3C7B0C}"/>
                                            </a:ext>
                                          </a:extLst>
                                        </p:cNvPr>
                                        <p:cNvSpPr txBox="1"/>
                                        <p:nvPr/>
                                      </p:nvSpPr>
                                      <p:spPr>
                                        <a:xfrm>
                                          <a:off x="1775944" y="440043"/>
                                          <a:ext cx="470000" cy="215444"/>
                                        </a:xfrm>
                                        <a:prstGeom prst="rect">
                                          <a:avLst/>
                                        </a:prstGeom>
                                        <a:noFill/>
                                      </p:spPr>
                                      <p:txBody>
                                        <a:bodyPr wrap="none" rtlCol="0">
                                          <a:spAutoFit/>
                                        </a:bodyPr>
                                        <a:lstStyle/>
                                        <a:p>
                                          <a:r>
                                            <a:rPr lang="hu-HU" sz="800" dirty="0"/>
                                            <a:t>DMSO</a:t>
                                          </a:r>
                                        </a:p>
                                      </p:txBody>
                                    </p:sp>
                                    <p:sp>
                                      <p:nvSpPr>
                                        <p:cNvPr id="124" name="Szövegdoboz 123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66124837-1385-780C-9AD8-D190374677FD}"/>
                                            </a:ext>
                                          </a:extLst>
                                        </p:cNvPr>
                                        <p:cNvSpPr txBox="1"/>
                                        <p:nvPr/>
                                      </p:nvSpPr>
                                      <p:spPr>
                                        <a:xfrm>
                                          <a:off x="2134194" y="440043"/>
                                          <a:ext cx="457176" cy="215444"/>
                                        </a:xfrm>
                                        <a:prstGeom prst="rect">
                                          <a:avLst/>
                                        </a:prstGeom>
                                        <a:noFill/>
                                      </p:spPr>
                                      <p:txBody>
                                        <a:bodyPr wrap="none" rtlCol="0">
                                          <a:spAutoFit/>
                                        </a:bodyPr>
                                        <a:lstStyle/>
                                        <a:p>
                                          <a:r>
                                            <a:rPr lang="hu-HU" sz="800" dirty="0"/>
                                            <a:t>UDCA</a:t>
                                          </a:r>
                                        </a:p>
                                      </p:txBody>
                                    </p:sp>
                                  </p:grpSp>
                                  <p:sp>
                                    <p:nvSpPr>
                                      <p:cNvPr id="122" name="Szövegdoboz 121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3B938FDC-E77A-0BDE-D775-F701A302FF01}"/>
                                          </a:ext>
                                        </a:extLst>
                                      </p:cNvPr>
                                      <p:cNvSpPr txBox="1"/>
                                      <p:nvPr/>
                                    </p:nvSpPr>
                                    <p:spPr>
                                      <a:xfrm>
                                        <a:off x="1820013" y="494934"/>
                                        <a:ext cx="332142" cy="307777"/>
                                      </a:xfrm>
                                      <a:prstGeom prst="rect">
                                        <a:avLst/>
                                      </a:prstGeom>
                                      <a:noFill/>
                                    </p:spPr>
                                    <p:txBody>
                                      <a:bodyPr wrap="none" rtlCol="0">
                                        <a:spAutoFit/>
                                      </a:bodyPr>
                                      <a:lstStyle/>
                                      <a:p>
                                        <a:r>
                                          <a:rPr lang="hu-HU" sz="1400" b="1" dirty="0"/>
                                          <a:t>1.</a:t>
                                        </a:r>
                                      </a:p>
                                    </p:txBody>
                                  </p:sp>
                                </p:grpSp>
                                <p:sp>
                                  <p:nvSpPr>
                                    <p:cNvPr id="118" name="Szövegdoboz 117">
                                      <a:extLst>
                                        <a:ext uri="{FF2B5EF4-FFF2-40B4-BE49-F238E27FC236}">
                                          <a16:creationId xmlns:a16="http://schemas.microsoft.com/office/drawing/2014/main" id="{6BDC6154-6286-7133-CC8F-AE3BA9C8DF65}"/>
                                        </a:ext>
                                      </a:extLst>
                                    </p:cNvPr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2516831" y="533616"/>
                                      <a:ext cx="335348" cy="307777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none" rtlCol="0">
                                      <a:spAutoFit/>
                                    </a:bodyPr>
                                    <a:lstStyle/>
                                    <a:p>
                                      <a:r>
                                        <a:rPr lang="hu-HU" sz="1400" b="1" dirty="0"/>
                                        <a:t>2.</a:t>
                                      </a:r>
                                    </a:p>
                                  </p:txBody>
                                </p:sp>
                                <p:sp>
                                  <p:nvSpPr>
                                    <p:cNvPr id="119" name="Szövegdoboz 118">
                                      <a:extLst>
                                        <a:ext uri="{FF2B5EF4-FFF2-40B4-BE49-F238E27FC236}">
                                          <a16:creationId xmlns:a16="http://schemas.microsoft.com/office/drawing/2014/main" id="{0BAADE06-43BF-A103-2260-0BFD04C08464}"/>
                                        </a:ext>
                                      </a:extLst>
                                    </p:cNvPr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3163732" y="531512"/>
                                      <a:ext cx="335348" cy="307777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none" rtlCol="0">
                                      <a:spAutoFit/>
                                    </a:bodyPr>
                                    <a:lstStyle/>
                                    <a:p>
                                      <a:r>
                                        <a:rPr lang="hu-HU" sz="1400" b="1" dirty="0"/>
                                        <a:t>3.</a:t>
                                      </a:r>
                                    </a:p>
                                  </p:txBody>
                                </p:sp>
                                <p:sp>
                                  <p:nvSpPr>
                                    <p:cNvPr id="120" name="Téglalap 119">
                                      <a:extLst>
                                        <a:ext uri="{FF2B5EF4-FFF2-40B4-BE49-F238E27FC236}">
                                          <a16:creationId xmlns:a16="http://schemas.microsoft.com/office/drawing/2014/main" id="{23A0D9B2-D260-1157-C093-C07F968A24AB}"/>
                                        </a:ext>
                                      </a:extLst>
                                    </p:cNvPr>
                                    <p:cNvSpPr/>
                                    <p:nvPr/>
                                  </p:nvSpPr>
                                  <p:spPr>
                                    <a:xfrm>
                                      <a:off x="70822" y="474905"/>
                                      <a:ext cx="11962095" cy="1999716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style>
                                    <a:lnRef idx="2">
                                      <a:schemeClr val="accent1">
                                        <a:shade val="15000"/>
                                      </a:schemeClr>
                                    </a:lnRef>
                                    <a:fillRef idx="1">
                                      <a:schemeClr val="accent1"/>
                                    </a:fillRef>
                                    <a:effectRef idx="0">
                                      <a:schemeClr val="accent1"/>
                                    </a:effectRef>
                                    <a:fontRef idx="minor">
                                      <a:schemeClr val="lt1"/>
                                    </a:fontRef>
                                  </p:style>
                                  <p:txBody>
                                    <a:bodyPr rtlCol="0" anchor="ctr"/>
                                    <a:lstStyle/>
                                    <a:p>
                                      <a:pPr algn="ctr"/>
                                      <a:endParaRPr lang="hu-HU"/>
                                    </a:p>
                                  </p:txBody>
                                </p:sp>
                              </p:grpSp>
                            </p:grpSp>
                            <p:sp>
                              <p:nvSpPr>
                                <p:cNvPr id="110" name="Szövegdoboz 109">
                                  <a:extLst>
                                    <a:ext uri="{FF2B5EF4-FFF2-40B4-BE49-F238E27FC236}">
                                      <a16:creationId xmlns:a16="http://schemas.microsoft.com/office/drawing/2014/main" id="{8B56FD6B-3865-EDC5-323C-09D330DBA3D4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3153950" y="783114"/>
                                  <a:ext cx="470000" cy="215444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non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800" dirty="0"/>
                                    <a:t>DMSO</a:t>
                                  </a:r>
                                </a:p>
                              </p:txBody>
                            </p:sp>
                            <p:sp>
                              <p:nvSpPr>
                                <p:cNvPr id="111" name="Szövegdoboz 110">
                                  <a:extLst>
                                    <a:ext uri="{FF2B5EF4-FFF2-40B4-BE49-F238E27FC236}">
                                      <a16:creationId xmlns:a16="http://schemas.microsoft.com/office/drawing/2014/main" id="{778D1337-0A5C-FC0B-7F8A-F4542193D3FB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3459740" y="789765"/>
                                  <a:ext cx="457176" cy="215444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non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800" dirty="0"/>
                                    <a:t>UDCA</a:t>
                                  </a:r>
                                </a:p>
                              </p:txBody>
                            </p:sp>
                          </p:grpSp>
                        </p:grpSp>
                        <p:sp>
                          <p:nvSpPr>
                            <p:cNvPr id="99" name="Szövegdoboz 98">
                              <a:extLst>
                                <a:ext uri="{FF2B5EF4-FFF2-40B4-BE49-F238E27FC236}">
                                  <a16:creationId xmlns:a16="http://schemas.microsoft.com/office/drawing/2014/main" id="{E236E837-52DA-FD22-DF68-CD0377405F5D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1499097" y="912658"/>
                              <a:ext cx="184731" cy="215444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endParaRPr lang="hu-HU" sz="800" dirty="0"/>
                            </a:p>
                          </p:txBody>
                        </p:sp>
                      </p:grpSp>
                      <p:sp>
                        <p:nvSpPr>
                          <p:cNvPr id="95" name="Szövegdoboz 94">
                            <a:extLst>
                              <a:ext uri="{FF2B5EF4-FFF2-40B4-BE49-F238E27FC236}">
                                <a16:creationId xmlns:a16="http://schemas.microsoft.com/office/drawing/2014/main" id="{DB066A4B-599B-1419-7761-08A22BED1124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491238" y="1696650"/>
                            <a:ext cx="293670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hu-HU" sz="800" dirty="0"/>
                              <a:t>55</a:t>
                            </a:r>
                          </a:p>
                        </p:txBody>
                      </p:sp>
                    </p:grpSp>
                    <p:sp>
                      <p:nvSpPr>
                        <p:cNvPr id="92" name="Szövegdoboz 91">
                          <a:extLst>
                            <a:ext uri="{FF2B5EF4-FFF2-40B4-BE49-F238E27FC236}">
                              <a16:creationId xmlns:a16="http://schemas.microsoft.com/office/drawing/2014/main" id="{15073E91-CF3E-D43C-38B7-E978F0406995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944899" y="1275014"/>
                          <a:ext cx="184731" cy="21544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endParaRPr lang="hu-HU" sz="800" dirty="0"/>
                        </a:p>
                      </p:txBody>
                    </p:sp>
                    <p:sp>
                      <p:nvSpPr>
                        <p:cNvPr id="93" name="Szövegdoboz 92">
                          <a:extLst>
                            <a:ext uri="{FF2B5EF4-FFF2-40B4-BE49-F238E27FC236}">
                              <a16:creationId xmlns:a16="http://schemas.microsoft.com/office/drawing/2014/main" id="{1019ECEF-FE39-4B32-8F56-8E0818AE139E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970562" y="833216"/>
                          <a:ext cx="184731" cy="21544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endParaRPr lang="hu-HU" sz="800" dirty="0"/>
                        </a:p>
                      </p:txBody>
                    </p:sp>
                  </p:grpSp>
                  <p:sp>
                    <p:nvSpPr>
                      <p:cNvPr id="86" name="Szövegdoboz 85">
                        <a:extLst>
                          <a:ext uri="{FF2B5EF4-FFF2-40B4-BE49-F238E27FC236}">
                            <a16:creationId xmlns:a16="http://schemas.microsoft.com/office/drawing/2014/main" id="{E73EFBD7-13C9-3D34-D647-0160FD86CDC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961135" y="2068132"/>
                        <a:ext cx="184731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endParaRPr lang="hu-HU" sz="800" dirty="0"/>
                      </a:p>
                    </p:txBody>
                  </p:sp>
                  <p:sp>
                    <p:nvSpPr>
                      <p:cNvPr id="88" name="Szövegdoboz 87">
                        <a:extLst>
                          <a:ext uri="{FF2B5EF4-FFF2-40B4-BE49-F238E27FC236}">
                            <a16:creationId xmlns:a16="http://schemas.microsoft.com/office/drawing/2014/main" id="{C8B099AF-1ADA-5E2F-3E06-3135BAC65C6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962703" y="1654921"/>
                        <a:ext cx="184731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endParaRPr lang="hu-HU" sz="800" dirty="0"/>
                      </a:p>
                    </p:txBody>
                  </p:sp>
                </p:grpSp>
                <p:sp>
                  <p:nvSpPr>
                    <p:cNvPr id="84" name="Szövegdoboz 83">
                      <a:extLst>
                        <a:ext uri="{FF2B5EF4-FFF2-40B4-BE49-F238E27FC236}">
                          <a16:creationId xmlns:a16="http://schemas.microsoft.com/office/drawing/2014/main" id="{46F98CD1-2774-83E2-61BA-CC49F6B06CC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628166" y="1643919"/>
                      <a:ext cx="184731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endParaRPr lang="hu-HU" sz="800" dirty="0"/>
                    </a:p>
                  </p:txBody>
                </p:sp>
              </p:grpSp>
              <p:sp>
                <p:nvSpPr>
                  <p:cNvPr id="81" name="Szövegdoboz 80">
                    <a:extLst>
                      <a:ext uri="{FF2B5EF4-FFF2-40B4-BE49-F238E27FC236}">
                        <a16:creationId xmlns:a16="http://schemas.microsoft.com/office/drawing/2014/main" id="{CCCD9250-FF3E-4900-05D1-A56A656B192E}"/>
                      </a:ext>
                    </a:extLst>
                  </p:cNvPr>
                  <p:cNvSpPr txBox="1"/>
                  <p:nvPr/>
                </p:nvSpPr>
                <p:spPr>
                  <a:xfrm>
                    <a:off x="1483379" y="2150710"/>
                    <a:ext cx="29367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hu-HU" sz="800" dirty="0"/>
                      <a:t>35</a:t>
                    </a:r>
                  </a:p>
                </p:txBody>
              </p:sp>
            </p:grpSp>
            <p:sp>
              <p:nvSpPr>
                <p:cNvPr id="71" name="Szövegdoboz 70">
                  <a:extLst>
                    <a:ext uri="{FF2B5EF4-FFF2-40B4-BE49-F238E27FC236}">
                      <a16:creationId xmlns:a16="http://schemas.microsoft.com/office/drawing/2014/main" id="{DA6F1901-8E9E-FEC5-1484-D105A073223C}"/>
                    </a:ext>
                  </a:extLst>
                </p:cNvPr>
                <p:cNvSpPr txBox="1"/>
                <p:nvPr/>
              </p:nvSpPr>
              <p:spPr>
                <a:xfrm>
                  <a:off x="8627333" y="763394"/>
                  <a:ext cx="18473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endParaRPr lang="hu-HU" sz="800" dirty="0"/>
                </a:p>
              </p:txBody>
            </p:sp>
            <p:sp>
              <p:nvSpPr>
                <p:cNvPr id="72" name="Szövegdoboz 71">
                  <a:extLst>
                    <a:ext uri="{FF2B5EF4-FFF2-40B4-BE49-F238E27FC236}">
                      <a16:creationId xmlns:a16="http://schemas.microsoft.com/office/drawing/2014/main" id="{B67ECD86-C3AA-A64A-A872-B1DC26D49AA5}"/>
                    </a:ext>
                  </a:extLst>
                </p:cNvPr>
                <p:cNvSpPr txBox="1"/>
                <p:nvPr/>
              </p:nvSpPr>
              <p:spPr>
                <a:xfrm>
                  <a:off x="8621044" y="1228453"/>
                  <a:ext cx="18473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endParaRPr lang="hu-HU" sz="800" dirty="0"/>
                </a:p>
              </p:txBody>
            </p:sp>
          </p:grpSp>
          <p:sp>
            <p:nvSpPr>
              <p:cNvPr id="66" name="Szövegdoboz 65">
                <a:extLst>
                  <a:ext uri="{FF2B5EF4-FFF2-40B4-BE49-F238E27FC236}">
                    <a16:creationId xmlns:a16="http://schemas.microsoft.com/office/drawing/2014/main" id="{F490569E-34C0-E1E4-FD65-91D438659ED3}"/>
                  </a:ext>
                </a:extLst>
              </p:cNvPr>
              <p:cNvSpPr txBox="1"/>
              <p:nvPr/>
            </p:nvSpPr>
            <p:spPr>
              <a:xfrm>
                <a:off x="8621039" y="2105143"/>
                <a:ext cx="18473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endParaRPr lang="hu-HU" sz="800" dirty="0"/>
              </a:p>
            </p:txBody>
          </p:sp>
        </p:grpSp>
        <p:sp>
          <p:nvSpPr>
            <p:cNvPr id="57" name="Szövegdoboz 56">
              <a:extLst>
                <a:ext uri="{FF2B5EF4-FFF2-40B4-BE49-F238E27FC236}">
                  <a16:creationId xmlns:a16="http://schemas.microsoft.com/office/drawing/2014/main" id="{641A356E-9394-0197-2640-8AB2C2FA66AC}"/>
                </a:ext>
              </a:extLst>
            </p:cNvPr>
            <p:cNvSpPr txBox="1"/>
            <p:nvPr/>
          </p:nvSpPr>
          <p:spPr>
            <a:xfrm>
              <a:off x="4020447" y="1211086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00" dirty="0"/>
                <a:t>55</a:t>
              </a:r>
            </a:p>
          </p:txBody>
        </p:sp>
      </p:grpSp>
      <p:pic>
        <p:nvPicPr>
          <p:cNvPr id="128" name="Kép 127" descr="A képen fekete, monokróm, fekete-fehér, Monokróm fényképezés látható&#10;&#10;Automatikusan generált leírás">
            <a:extLst>
              <a:ext uri="{FF2B5EF4-FFF2-40B4-BE49-F238E27FC236}">
                <a16:creationId xmlns:a16="http://schemas.microsoft.com/office/drawing/2014/main" id="{340B0ED6-5899-B4A9-AC8C-7548EA4B710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723933" y="3036514"/>
            <a:ext cx="2342359" cy="41706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9" name="Kép 128" descr="A képen képernyőkép, fekete, Téglalap, sötétség látható&#10;&#10;Automatikusan generált leírás">
            <a:extLst>
              <a:ext uri="{FF2B5EF4-FFF2-40B4-BE49-F238E27FC236}">
                <a16:creationId xmlns:a16="http://schemas.microsoft.com/office/drawing/2014/main" id="{902C46F0-9CE2-F8D1-EDC9-8D4A25DC314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017" t="68319" r="21156" b="15304"/>
          <a:stretch/>
        </p:blipFill>
        <p:spPr>
          <a:xfrm>
            <a:off x="1747892" y="3767494"/>
            <a:ext cx="2265299" cy="645459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8656057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D594EED-582E-2BF9-C2DD-3EEC85BDF2B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zövegdoboz 3">
            <a:extLst>
              <a:ext uri="{FF2B5EF4-FFF2-40B4-BE49-F238E27FC236}">
                <a16:creationId xmlns:a16="http://schemas.microsoft.com/office/drawing/2014/main" id="{5288A7F6-7C81-C3A6-54C5-FD383B1ACB81}"/>
              </a:ext>
            </a:extLst>
          </p:cNvPr>
          <p:cNvSpPr txBox="1"/>
          <p:nvPr/>
        </p:nvSpPr>
        <p:spPr>
          <a:xfrm>
            <a:off x="68367" y="68366"/>
            <a:ext cx="27849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b="1" dirty="0" err="1"/>
              <a:t>Fibroblast</a:t>
            </a:r>
            <a:r>
              <a:rPr lang="hu-HU" b="1" dirty="0"/>
              <a:t> </a:t>
            </a:r>
            <a:r>
              <a:rPr lang="hu-HU" b="1" dirty="0" err="1"/>
              <a:t>blots</a:t>
            </a:r>
            <a:r>
              <a:rPr lang="hu-HU" b="1" dirty="0"/>
              <a:t>:</a:t>
            </a:r>
          </a:p>
        </p:txBody>
      </p:sp>
      <p:grpSp>
        <p:nvGrpSpPr>
          <p:cNvPr id="37" name="Csoportba foglalás 36">
            <a:extLst>
              <a:ext uri="{FF2B5EF4-FFF2-40B4-BE49-F238E27FC236}">
                <a16:creationId xmlns:a16="http://schemas.microsoft.com/office/drawing/2014/main" id="{8AAC36FF-DA8C-DD12-1C93-75F6BADFA672}"/>
              </a:ext>
            </a:extLst>
          </p:cNvPr>
          <p:cNvGrpSpPr/>
          <p:nvPr/>
        </p:nvGrpSpPr>
        <p:grpSpPr>
          <a:xfrm>
            <a:off x="68367" y="498881"/>
            <a:ext cx="11964550" cy="5204510"/>
            <a:chOff x="68367" y="437698"/>
            <a:chExt cx="11964550" cy="2742281"/>
          </a:xfrm>
        </p:grpSpPr>
        <p:grpSp>
          <p:nvGrpSpPr>
            <p:cNvPr id="77" name="Csoportba foglalás 76">
              <a:extLst>
                <a:ext uri="{FF2B5EF4-FFF2-40B4-BE49-F238E27FC236}">
                  <a16:creationId xmlns:a16="http://schemas.microsoft.com/office/drawing/2014/main" id="{97FB83EE-CF99-15B2-A578-77B3A11A97F8}"/>
                </a:ext>
              </a:extLst>
            </p:cNvPr>
            <p:cNvGrpSpPr/>
            <p:nvPr/>
          </p:nvGrpSpPr>
          <p:grpSpPr>
            <a:xfrm>
              <a:off x="68367" y="437698"/>
              <a:ext cx="11964550" cy="2742281"/>
              <a:chOff x="68367" y="437698"/>
              <a:chExt cx="11964550" cy="2742281"/>
            </a:xfrm>
          </p:grpSpPr>
          <p:grpSp>
            <p:nvGrpSpPr>
              <p:cNvPr id="55" name="Csoportba foglalás 54">
                <a:extLst>
                  <a:ext uri="{FF2B5EF4-FFF2-40B4-BE49-F238E27FC236}">
                    <a16:creationId xmlns:a16="http://schemas.microsoft.com/office/drawing/2014/main" id="{FDE1A297-39FA-D60E-9D5C-113EDF0E730F}"/>
                  </a:ext>
                </a:extLst>
              </p:cNvPr>
              <p:cNvGrpSpPr/>
              <p:nvPr/>
            </p:nvGrpSpPr>
            <p:grpSpPr>
              <a:xfrm>
                <a:off x="68367" y="437698"/>
                <a:ext cx="11964550" cy="2742281"/>
                <a:chOff x="68367" y="437698"/>
                <a:chExt cx="11964550" cy="2742281"/>
              </a:xfrm>
            </p:grpSpPr>
            <p:grpSp>
              <p:nvGrpSpPr>
                <p:cNvPr id="33" name="Csoportba foglalás 32">
                  <a:extLst>
                    <a:ext uri="{FF2B5EF4-FFF2-40B4-BE49-F238E27FC236}">
                      <a16:creationId xmlns:a16="http://schemas.microsoft.com/office/drawing/2014/main" id="{F2AB12ED-0155-D8D6-9A1B-4F332C836B5C}"/>
                    </a:ext>
                  </a:extLst>
                </p:cNvPr>
                <p:cNvGrpSpPr/>
                <p:nvPr/>
              </p:nvGrpSpPr>
              <p:grpSpPr>
                <a:xfrm>
                  <a:off x="68367" y="437698"/>
                  <a:ext cx="11964550" cy="2742281"/>
                  <a:chOff x="68367" y="437698"/>
                  <a:chExt cx="11964550" cy="2742281"/>
                </a:xfrm>
              </p:grpSpPr>
              <p:grpSp>
                <p:nvGrpSpPr>
                  <p:cNvPr id="76" name="Csoportba foglalás 75">
                    <a:extLst>
                      <a:ext uri="{FF2B5EF4-FFF2-40B4-BE49-F238E27FC236}">
                        <a16:creationId xmlns:a16="http://schemas.microsoft.com/office/drawing/2014/main" id="{1EAFA571-D91B-C87F-0F30-04F69B75A5DA}"/>
                      </a:ext>
                    </a:extLst>
                  </p:cNvPr>
                  <p:cNvGrpSpPr/>
                  <p:nvPr/>
                </p:nvGrpSpPr>
                <p:grpSpPr>
                  <a:xfrm>
                    <a:off x="68367" y="437698"/>
                    <a:ext cx="11964550" cy="2742281"/>
                    <a:chOff x="68367" y="437698"/>
                    <a:chExt cx="11964550" cy="2742281"/>
                  </a:xfrm>
                </p:grpSpPr>
                <p:grpSp>
                  <p:nvGrpSpPr>
                    <p:cNvPr id="64" name="Csoportba foglalás 63">
                      <a:extLst>
                        <a:ext uri="{FF2B5EF4-FFF2-40B4-BE49-F238E27FC236}">
                          <a16:creationId xmlns:a16="http://schemas.microsoft.com/office/drawing/2014/main" id="{6A865B6A-F4D4-D72B-3658-148FAA99B80C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8367" y="437698"/>
                      <a:ext cx="11964550" cy="2742281"/>
                      <a:chOff x="68367" y="437698"/>
                      <a:chExt cx="11964550" cy="2742281"/>
                    </a:xfrm>
                  </p:grpSpPr>
                  <p:grpSp>
                    <p:nvGrpSpPr>
                      <p:cNvPr id="59" name="Csoportba foglalás 58">
                        <a:extLst>
                          <a:ext uri="{FF2B5EF4-FFF2-40B4-BE49-F238E27FC236}">
                            <a16:creationId xmlns:a16="http://schemas.microsoft.com/office/drawing/2014/main" id="{FD5314F3-4F09-20C6-CC28-66718523F043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68367" y="437698"/>
                        <a:ext cx="11964550" cy="2742281"/>
                        <a:chOff x="68367" y="437698"/>
                        <a:chExt cx="11964550" cy="2742281"/>
                      </a:xfrm>
                    </p:grpSpPr>
                    <p:grpSp>
                      <p:nvGrpSpPr>
                        <p:cNvPr id="5" name="Csoportba foglalás 4">
                          <a:extLst>
                            <a:ext uri="{FF2B5EF4-FFF2-40B4-BE49-F238E27FC236}">
                              <a16:creationId xmlns:a16="http://schemas.microsoft.com/office/drawing/2014/main" id="{DDCFD553-31B5-3C37-DED2-874B35E38AC1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68367" y="437698"/>
                          <a:ext cx="11964550" cy="2742281"/>
                          <a:chOff x="68367" y="437698"/>
                          <a:chExt cx="11964550" cy="2742281"/>
                        </a:xfrm>
                      </p:grpSpPr>
                      <p:sp>
                        <p:nvSpPr>
                          <p:cNvPr id="6" name="Szövegdoboz 5">
                            <a:extLst>
                              <a:ext uri="{FF2B5EF4-FFF2-40B4-BE49-F238E27FC236}">
                                <a16:creationId xmlns:a16="http://schemas.microsoft.com/office/drawing/2014/main" id="{324AA1AF-B7A2-F1F0-CB1E-9D83E956B237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443676" y="2158685"/>
                            <a:ext cx="470000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hu-HU" sz="800" dirty="0"/>
                              <a:t>DMSO</a:t>
                            </a:r>
                          </a:p>
                        </p:txBody>
                      </p:sp>
                      <p:sp>
                        <p:nvSpPr>
                          <p:cNvPr id="7" name="Szövegdoboz 6">
                            <a:extLst>
                              <a:ext uri="{FF2B5EF4-FFF2-40B4-BE49-F238E27FC236}">
                                <a16:creationId xmlns:a16="http://schemas.microsoft.com/office/drawing/2014/main" id="{BDE38458-6795-9085-1057-6E37EBC85416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761710" y="2158685"/>
                            <a:ext cx="457176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hu-HU" sz="800" dirty="0"/>
                              <a:t>UDCA</a:t>
                            </a:r>
                          </a:p>
                        </p:txBody>
                      </p:sp>
                      <p:sp>
                        <p:nvSpPr>
                          <p:cNvPr id="8" name="Szövegdoboz 7">
                            <a:extLst>
                              <a:ext uri="{FF2B5EF4-FFF2-40B4-BE49-F238E27FC236}">
                                <a16:creationId xmlns:a16="http://schemas.microsoft.com/office/drawing/2014/main" id="{D15CC163-27E7-8330-2178-F4290FB65B9B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782696" y="2158685"/>
                            <a:ext cx="470000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hu-HU" sz="800" dirty="0"/>
                              <a:t>DMSO</a:t>
                            </a:r>
                          </a:p>
                        </p:txBody>
                      </p:sp>
                      <p:sp>
                        <p:nvSpPr>
                          <p:cNvPr id="9" name="Szövegdoboz 8">
                            <a:extLst>
                              <a:ext uri="{FF2B5EF4-FFF2-40B4-BE49-F238E27FC236}">
                                <a16:creationId xmlns:a16="http://schemas.microsoft.com/office/drawing/2014/main" id="{03C0D60B-8CA6-CBE1-5056-B20B20BB6952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107145" y="2158685"/>
                            <a:ext cx="457176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hu-HU" sz="800" dirty="0"/>
                              <a:t>UDCA</a:t>
                            </a:r>
                          </a:p>
                        </p:txBody>
                      </p:sp>
                      <p:sp>
                        <p:nvSpPr>
                          <p:cNvPr id="10" name="Szövegdoboz 9">
                            <a:extLst>
                              <a:ext uri="{FF2B5EF4-FFF2-40B4-BE49-F238E27FC236}">
                                <a16:creationId xmlns:a16="http://schemas.microsoft.com/office/drawing/2014/main" id="{CF4BFA36-6CBC-DEF8-3216-3FA876A2D1D4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3066919" y="2153986"/>
                            <a:ext cx="470000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hu-HU" sz="800" dirty="0"/>
                              <a:t>DMSO</a:t>
                            </a:r>
                          </a:p>
                        </p:txBody>
                      </p:sp>
                      <p:sp>
                        <p:nvSpPr>
                          <p:cNvPr id="11" name="Szövegdoboz 10">
                            <a:extLst>
                              <a:ext uri="{FF2B5EF4-FFF2-40B4-BE49-F238E27FC236}">
                                <a16:creationId xmlns:a16="http://schemas.microsoft.com/office/drawing/2014/main" id="{74208139-18A1-ACC7-3D08-F5AF41FC2E64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3358331" y="2148582"/>
                            <a:ext cx="457176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hu-HU" sz="800" dirty="0"/>
                              <a:t>UDCA</a:t>
                            </a:r>
                          </a:p>
                        </p:txBody>
                      </p:sp>
                      <p:grpSp>
                        <p:nvGrpSpPr>
                          <p:cNvPr id="13" name="Csoportba foglalás 12">
                            <a:extLst>
                              <a:ext uri="{FF2B5EF4-FFF2-40B4-BE49-F238E27FC236}">
                                <a16:creationId xmlns:a16="http://schemas.microsoft.com/office/drawing/2014/main" id="{35691941-2183-FE3B-7C53-40401036F46C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68367" y="437698"/>
                            <a:ext cx="11964550" cy="2742281"/>
                            <a:chOff x="68367" y="437698"/>
                            <a:chExt cx="11964550" cy="2742281"/>
                          </a:xfrm>
                        </p:grpSpPr>
                        <p:grpSp>
                          <p:nvGrpSpPr>
                            <p:cNvPr id="17" name="Csoportba foglalás 16">
                              <a:extLst>
                                <a:ext uri="{FF2B5EF4-FFF2-40B4-BE49-F238E27FC236}">
                                  <a16:creationId xmlns:a16="http://schemas.microsoft.com/office/drawing/2014/main" id="{A7137D3E-CEFA-9EE7-6D0A-0706FFEAFD3E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68367" y="437698"/>
                              <a:ext cx="11964550" cy="2742281"/>
                              <a:chOff x="68367" y="437698"/>
                              <a:chExt cx="11964550" cy="2742281"/>
                            </a:xfrm>
                          </p:grpSpPr>
                          <p:sp>
                            <p:nvSpPr>
                              <p:cNvPr id="24" name="Szövegdoboz 23">
                                <a:extLst>
                                  <a:ext uri="{FF2B5EF4-FFF2-40B4-BE49-F238E27FC236}">
                                    <a16:creationId xmlns:a16="http://schemas.microsoft.com/office/drawing/2014/main" id="{11DA0A9C-5C70-50C6-930E-8EA455B18910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2536142" y="677956"/>
                                <a:ext cx="470000" cy="215444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r>
                                  <a:rPr lang="hu-HU" sz="800" dirty="0"/>
                                  <a:t>DMSO</a:t>
                                </a:r>
                              </a:p>
                            </p:txBody>
                          </p:sp>
                          <p:sp>
                            <p:nvSpPr>
                              <p:cNvPr id="25" name="Szövegdoboz 24">
                                <a:extLst>
                                  <a:ext uri="{FF2B5EF4-FFF2-40B4-BE49-F238E27FC236}">
                                    <a16:creationId xmlns:a16="http://schemas.microsoft.com/office/drawing/2014/main" id="{C7AE7FE1-F0FF-C31F-098C-4340C98217D7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2861533" y="684732"/>
                                <a:ext cx="457176" cy="215444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r>
                                  <a:rPr lang="hu-HU" sz="800" dirty="0"/>
                                  <a:t>UDCA</a:t>
                                </a:r>
                              </a:p>
                            </p:txBody>
                          </p:sp>
                          <p:grpSp>
                            <p:nvGrpSpPr>
                              <p:cNvPr id="40" name="Csoportba foglalás 39">
                                <a:extLst>
                                  <a:ext uri="{FF2B5EF4-FFF2-40B4-BE49-F238E27FC236}">
                                    <a16:creationId xmlns:a16="http://schemas.microsoft.com/office/drawing/2014/main" id="{7FE21E20-FB1A-B2D2-47CD-81DC4EE8E02D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68367" y="437698"/>
                                <a:ext cx="11964550" cy="2742281"/>
                                <a:chOff x="68367" y="474905"/>
                                <a:chExt cx="11964550" cy="2742281"/>
                              </a:xfrm>
                            </p:grpSpPr>
                            <p:sp>
                              <p:nvSpPr>
                                <p:cNvPr id="45" name="Szövegdoboz 44">
                                  <a:extLst>
                                    <a:ext uri="{FF2B5EF4-FFF2-40B4-BE49-F238E27FC236}">
                                      <a16:creationId xmlns:a16="http://schemas.microsoft.com/office/drawing/2014/main" id="{C98A107D-FE89-F335-3BC8-A84F438671A2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68367" y="1048238"/>
                                  <a:ext cx="999857" cy="162169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1400" dirty="0"/>
                                    <a:t>4HNE:</a:t>
                                  </a:r>
                                </a:p>
                              </p:txBody>
                            </p:sp>
                            <p:sp>
                              <p:nvSpPr>
                                <p:cNvPr id="46" name="Szövegdoboz 45">
                                  <a:extLst>
                                    <a:ext uri="{FF2B5EF4-FFF2-40B4-BE49-F238E27FC236}">
                                      <a16:creationId xmlns:a16="http://schemas.microsoft.com/office/drawing/2014/main" id="{767E6F26-43D3-7332-1346-DF4F78E7667F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138977" y="2280738"/>
                                  <a:ext cx="1355875" cy="162169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1400" dirty="0"/>
                                    <a:t>β-</a:t>
                                  </a:r>
                                  <a:r>
                                    <a:rPr lang="hu-HU" sz="1400" dirty="0" err="1"/>
                                    <a:t>actin</a:t>
                                  </a:r>
                                  <a:r>
                                    <a:rPr lang="hu-HU" sz="1400" dirty="0"/>
                                    <a:t>:</a:t>
                                  </a:r>
                                </a:p>
                              </p:txBody>
                            </p:sp>
                            <p:grpSp>
                              <p:nvGrpSpPr>
                                <p:cNvPr id="47" name="Csoportba foglalás 46">
                                  <a:extLst>
                                    <a:ext uri="{FF2B5EF4-FFF2-40B4-BE49-F238E27FC236}">
                                      <a16:creationId xmlns:a16="http://schemas.microsoft.com/office/drawing/2014/main" id="{A9C9E6AC-D7F4-9CD2-80C2-A27DA0F779D4}"/>
                                    </a:ext>
                                  </a:extLst>
                                </p:cNvPr>
                                <p:cNvGrpSpPr/>
                                <p:nvPr/>
                              </p:nvGrpSpPr>
                              <p:grpSpPr>
                                <a:xfrm>
                                  <a:off x="1782696" y="580127"/>
                                  <a:ext cx="829035" cy="350624"/>
                                  <a:chOff x="1782696" y="580127"/>
                                  <a:chExt cx="829035" cy="350624"/>
                                </a:xfrm>
                              </p:grpSpPr>
                              <p:grpSp>
                                <p:nvGrpSpPr>
                                  <p:cNvPr id="51" name="Csoportba foglalás 50">
                                    <a:extLst>
                                      <a:ext uri="{FF2B5EF4-FFF2-40B4-BE49-F238E27FC236}">
                                        <a16:creationId xmlns:a16="http://schemas.microsoft.com/office/drawing/2014/main" id="{B0FCB764-9608-4009-9B1C-BF9E617CF77F}"/>
                                      </a:ext>
                                    </a:extLst>
                                  </p:cNvPr>
                                  <p:cNvGrpSpPr/>
                                  <p:nvPr/>
                                </p:nvGrpSpPr>
                                <p:grpSpPr>
                                  <a:xfrm>
                                    <a:off x="1804977" y="715163"/>
                                    <a:ext cx="806754" cy="215588"/>
                                    <a:chOff x="1804977" y="339153"/>
                                    <a:chExt cx="806754" cy="215588"/>
                                  </a:xfrm>
                                </p:grpSpPr>
                                <p:sp>
                                  <p:nvSpPr>
                                    <p:cNvPr id="53" name="Szövegdoboz 52">
                                      <a:extLst>
                                        <a:ext uri="{FF2B5EF4-FFF2-40B4-BE49-F238E27FC236}">
                                          <a16:creationId xmlns:a16="http://schemas.microsoft.com/office/drawing/2014/main" id="{CC9CD681-CFF4-C8BB-EE20-A0041569DADA}"/>
                                        </a:ext>
                                      </a:extLst>
                                    </p:cNvPr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1804977" y="339153"/>
                                      <a:ext cx="470000" cy="2154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none" rtlCol="0">
                                      <a:spAutoFit/>
                                    </a:bodyPr>
                                    <a:lstStyle/>
                                    <a:p>
                                      <a:r>
                                        <a:rPr lang="hu-HU" sz="800" dirty="0"/>
                                        <a:t>DMSO</a:t>
                                      </a:r>
                                    </a:p>
                                  </p:txBody>
                                </p:sp>
                                <p:sp>
                                  <p:nvSpPr>
                                    <p:cNvPr id="54" name="Szövegdoboz 53">
                                      <a:extLst>
                                        <a:ext uri="{FF2B5EF4-FFF2-40B4-BE49-F238E27FC236}">
                                          <a16:creationId xmlns:a16="http://schemas.microsoft.com/office/drawing/2014/main" id="{97EB5075-BD1D-6D13-5582-BA45498408AE}"/>
                                        </a:ext>
                                      </a:extLst>
                                    </p:cNvPr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2154555" y="339297"/>
                                      <a:ext cx="457176" cy="2154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none" rtlCol="0">
                                      <a:spAutoFit/>
                                    </a:bodyPr>
                                    <a:lstStyle/>
                                    <a:p>
                                      <a:r>
                                        <a:rPr lang="hu-HU" sz="800" dirty="0"/>
                                        <a:t>UDCA</a:t>
                                      </a:r>
                                    </a:p>
                                  </p:txBody>
                                </p:sp>
                              </p:grpSp>
                              <p:sp>
                                <p:nvSpPr>
                                  <p:cNvPr id="52" name="Szövegdoboz 51">
                                    <a:extLst>
                                      <a:ext uri="{FF2B5EF4-FFF2-40B4-BE49-F238E27FC236}">
                                        <a16:creationId xmlns:a16="http://schemas.microsoft.com/office/drawing/2014/main" id="{C856DF16-2D3B-A35A-939C-EF6A5A7AD340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1782696" y="580127"/>
                                    <a:ext cx="332142" cy="307777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hu-HU" sz="1400" b="1" dirty="0"/>
                                      <a:t>1.</a:t>
                                    </a:r>
                                  </a:p>
                                </p:txBody>
                              </p:sp>
                            </p:grpSp>
                            <p:sp>
                              <p:nvSpPr>
                                <p:cNvPr id="48" name="Szövegdoboz 47">
                                  <a:extLst>
                                    <a:ext uri="{FF2B5EF4-FFF2-40B4-BE49-F238E27FC236}">
                                      <a16:creationId xmlns:a16="http://schemas.microsoft.com/office/drawing/2014/main" id="{B86291B7-D836-0D92-6089-6E1B49CAA825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2517958" y="558925"/>
                                  <a:ext cx="335348" cy="307777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non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1400" b="1" dirty="0"/>
                                    <a:t>2.</a:t>
                                  </a:r>
                                </a:p>
                              </p:txBody>
                            </p:sp>
                            <p:sp>
                              <p:nvSpPr>
                                <p:cNvPr id="49" name="Szövegdoboz 48">
                                  <a:extLst>
                                    <a:ext uri="{FF2B5EF4-FFF2-40B4-BE49-F238E27FC236}">
                                      <a16:creationId xmlns:a16="http://schemas.microsoft.com/office/drawing/2014/main" id="{09E1417B-E537-3DE7-611C-B0779B108DC0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3159262" y="569954"/>
                                  <a:ext cx="335348" cy="307777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non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1400" b="1" dirty="0"/>
                                    <a:t>3.</a:t>
                                  </a:r>
                                </a:p>
                              </p:txBody>
                            </p:sp>
                            <p:sp>
                              <p:nvSpPr>
                                <p:cNvPr id="50" name="Téglalap 49">
                                  <a:extLst>
                                    <a:ext uri="{FF2B5EF4-FFF2-40B4-BE49-F238E27FC236}">
                                      <a16:creationId xmlns:a16="http://schemas.microsoft.com/office/drawing/2014/main" id="{18AB55F7-A317-305F-1D13-D999D7A9B21E}"/>
                                    </a:ext>
                                  </a:extLst>
                                </p:cNvPr>
                                <p:cNvSpPr/>
                                <p:nvPr/>
                              </p:nvSpPr>
                              <p:spPr>
                                <a:xfrm>
                                  <a:off x="70822" y="474905"/>
                                  <a:ext cx="11962095" cy="2742281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style>
                                <a:lnRef idx="2">
                                  <a:schemeClr val="accent1">
                                    <a:shade val="15000"/>
                                  </a:schemeClr>
                                </a:lnRef>
                                <a:fillRef idx="1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lt1"/>
                                </a:fontRef>
                              </p:style>
                              <p:txBody>
                                <a:bodyPr rtlCol="0" anchor="ctr"/>
                                <a:lstStyle/>
                                <a:p>
                                  <a:pPr algn="ctr"/>
                                  <a:endParaRPr lang="hu-HU"/>
                                </a:p>
                              </p:txBody>
                            </p:sp>
                          </p:grpSp>
                        </p:grpSp>
                        <p:sp>
                          <p:nvSpPr>
                            <p:cNvPr id="19" name="Szövegdoboz 18">
                              <a:extLst>
                                <a:ext uri="{FF2B5EF4-FFF2-40B4-BE49-F238E27FC236}">
                                  <a16:creationId xmlns:a16="http://schemas.microsoft.com/office/drawing/2014/main" id="{0F14C3D4-1093-D1C7-54A4-0CC832548005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3168055" y="675392"/>
                              <a:ext cx="470000" cy="215444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r>
                                <a:rPr lang="hu-HU" sz="800" dirty="0"/>
                                <a:t>DMSO</a:t>
                              </a:r>
                            </a:p>
                          </p:txBody>
                        </p:sp>
                        <p:sp>
                          <p:nvSpPr>
                            <p:cNvPr id="20" name="Szövegdoboz 19">
                              <a:extLst>
                                <a:ext uri="{FF2B5EF4-FFF2-40B4-BE49-F238E27FC236}">
                                  <a16:creationId xmlns:a16="http://schemas.microsoft.com/office/drawing/2014/main" id="{084C27D0-1D34-CED9-7EEB-746ADB518328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3461900" y="677956"/>
                              <a:ext cx="457176" cy="215444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r>
                                <a:rPr lang="hu-HU" sz="800" dirty="0"/>
                                <a:t>UDCA</a:t>
                              </a:r>
                            </a:p>
                          </p:txBody>
                        </p:sp>
                      </p:grpSp>
                    </p:grpSp>
                    <p:sp>
                      <p:nvSpPr>
                        <p:cNvPr id="58" name="Szövegdoboz 57">
                          <a:extLst>
                            <a:ext uri="{FF2B5EF4-FFF2-40B4-BE49-F238E27FC236}">
                              <a16:creationId xmlns:a16="http://schemas.microsoft.com/office/drawing/2014/main" id="{C7A28A0C-390C-3060-E89D-C33A5B078D9C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856293" y="1711191"/>
                          <a:ext cx="293670" cy="21544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hu-HU" sz="800" dirty="0"/>
                            <a:t>35</a:t>
                          </a:r>
                        </a:p>
                      </p:txBody>
                    </p:sp>
                  </p:grpSp>
                  <p:sp>
                    <p:nvSpPr>
                      <p:cNvPr id="63" name="Szövegdoboz 62">
                        <a:extLst>
                          <a:ext uri="{FF2B5EF4-FFF2-40B4-BE49-F238E27FC236}">
                            <a16:creationId xmlns:a16="http://schemas.microsoft.com/office/drawing/2014/main" id="{41B0A9F3-6165-3792-D2D0-6955DA223443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0800000" flipV="1">
                        <a:off x="1476141" y="2243531"/>
                        <a:ext cx="464933" cy="11351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hu-HU" sz="800" dirty="0"/>
                          <a:t>55</a:t>
                        </a:r>
                      </a:p>
                    </p:txBody>
                  </p:sp>
                </p:grpSp>
                <p:sp>
                  <p:nvSpPr>
                    <p:cNvPr id="74" name="Szövegdoboz 73">
                      <a:extLst>
                        <a:ext uri="{FF2B5EF4-FFF2-40B4-BE49-F238E27FC236}">
                          <a16:creationId xmlns:a16="http://schemas.microsoft.com/office/drawing/2014/main" id="{80C5C796-27A1-1EBF-34B9-1DFA88E9DF0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61135" y="2068132"/>
                      <a:ext cx="184731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endParaRPr lang="hu-HU" sz="800" dirty="0"/>
                    </a:p>
                  </p:txBody>
                </p:sp>
                <p:sp>
                  <p:nvSpPr>
                    <p:cNvPr id="75" name="Szövegdoboz 74">
                      <a:extLst>
                        <a:ext uri="{FF2B5EF4-FFF2-40B4-BE49-F238E27FC236}">
                          <a16:creationId xmlns:a16="http://schemas.microsoft.com/office/drawing/2014/main" id="{6CB8F441-D91C-1807-5DB9-ABD36A5D2DB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62703" y="1654921"/>
                      <a:ext cx="184731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endParaRPr lang="hu-HU" sz="800" dirty="0"/>
                    </a:p>
                  </p:txBody>
                </p:sp>
              </p:grpSp>
              <p:sp>
                <p:nvSpPr>
                  <p:cNvPr id="32" name="Szövegdoboz 31">
                    <a:extLst>
                      <a:ext uri="{FF2B5EF4-FFF2-40B4-BE49-F238E27FC236}">
                        <a16:creationId xmlns:a16="http://schemas.microsoft.com/office/drawing/2014/main" id="{853893D5-A5E2-633F-BD40-CCFDBE19DBA9}"/>
                      </a:ext>
                    </a:extLst>
                  </p:cNvPr>
                  <p:cNvSpPr txBox="1"/>
                  <p:nvPr/>
                </p:nvSpPr>
                <p:spPr>
                  <a:xfrm>
                    <a:off x="1511307" y="2424801"/>
                    <a:ext cx="29367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hu-HU" sz="800" dirty="0"/>
                      <a:t>35</a:t>
                    </a:r>
                  </a:p>
                </p:txBody>
              </p:sp>
            </p:grpSp>
            <p:sp>
              <p:nvSpPr>
                <p:cNvPr id="38" name="Szövegdoboz 37">
                  <a:extLst>
                    <a:ext uri="{FF2B5EF4-FFF2-40B4-BE49-F238E27FC236}">
                      <a16:creationId xmlns:a16="http://schemas.microsoft.com/office/drawing/2014/main" id="{AD552E58-2DAA-3908-36EB-629988E75D23}"/>
                    </a:ext>
                  </a:extLst>
                </p:cNvPr>
                <p:cNvSpPr txBox="1"/>
                <p:nvPr/>
              </p:nvSpPr>
              <p:spPr>
                <a:xfrm>
                  <a:off x="8627333" y="763394"/>
                  <a:ext cx="18473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endParaRPr lang="hu-HU" sz="800" dirty="0"/>
                </a:p>
              </p:txBody>
            </p:sp>
            <p:sp>
              <p:nvSpPr>
                <p:cNvPr id="43" name="Szövegdoboz 42">
                  <a:extLst>
                    <a:ext uri="{FF2B5EF4-FFF2-40B4-BE49-F238E27FC236}">
                      <a16:creationId xmlns:a16="http://schemas.microsoft.com/office/drawing/2014/main" id="{9DC6751A-CE7B-0BB8-35F2-BD89942CE3FF}"/>
                    </a:ext>
                  </a:extLst>
                </p:cNvPr>
                <p:cNvSpPr txBox="1"/>
                <p:nvPr/>
              </p:nvSpPr>
              <p:spPr>
                <a:xfrm>
                  <a:off x="8621044" y="1228453"/>
                  <a:ext cx="18473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endParaRPr lang="hu-HU" sz="800" dirty="0"/>
                </a:p>
              </p:txBody>
            </p:sp>
          </p:grpSp>
          <p:sp>
            <p:nvSpPr>
              <p:cNvPr id="73" name="Szövegdoboz 72">
                <a:extLst>
                  <a:ext uri="{FF2B5EF4-FFF2-40B4-BE49-F238E27FC236}">
                    <a16:creationId xmlns:a16="http://schemas.microsoft.com/office/drawing/2014/main" id="{31ACACB8-7B4B-3C3C-1F19-5366E64FDDFC}"/>
                  </a:ext>
                </a:extLst>
              </p:cNvPr>
              <p:cNvSpPr txBox="1"/>
              <p:nvPr/>
            </p:nvSpPr>
            <p:spPr>
              <a:xfrm>
                <a:off x="8621039" y="2105143"/>
                <a:ext cx="18473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endParaRPr lang="hu-HU" sz="800" dirty="0"/>
              </a:p>
            </p:txBody>
          </p:sp>
        </p:grpSp>
        <p:sp>
          <p:nvSpPr>
            <p:cNvPr id="31" name="Szövegdoboz 30">
              <a:extLst>
                <a:ext uri="{FF2B5EF4-FFF2-40B4-BE49-F238E27FC236}">
                  <a16:creationId xmlns:a16="http://schemas.microsoft.com/office/drawing/2014/main" id="{AD94EDE8-1D27-AFAD-970F-C4F15A20F1FC}"/>
                </a:ext>
              </a:extLst>
            </p:cNvPr>
            <p:cNvSpPr txBox="1"/>
            <p:nvPr/>
          </p:nvSpPr>
          <p:spPr>
            <a:xfrm>
              <a:off x="3818144" y="1417866"/>
              <a:ext cx="293670" cy="1135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00" dirty="0"/>
                <a:t>55</a:t>
              </a:r>
            </a:p>
          </p:txBody>
        </p:sp>
      </p:grpSp>
      <p:pic>
        <p:nvPicPr>
          <p:cNvPr id="12" name="Kép 11" descr="A képen fekete-fehér, vázlat, monokróm, Monokróm fényképezés látható&#10;&#10;Automatikusan generált leírás">
            <a:extLst>
              <a:ext uri="{FF2B5EF4-FFF2-40B4-BE49-F238E27FC236}">
                <a16:creationId xmlns:a16="http://schemas.microsoft.com/office/drawing/2014/main" id="{9E1401B0-5464-CB08-82E1-836F4AA0D22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0232" y="1180468"/>
            <a:ext cx="2258843" cy="24127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Kép 14" descr="A képen vázlat, fekete-fehér, fehér, monokróm látható&#10;&#10;Automatikusan generált leírás">
            <a:extLst>
              <a:ext uri="{FF2B5EF4-FFF2-40B4-BE49-F238E27FC236}">
                <a16:creationId xmlns:a16="http://schemas.microsoft.com/office/drawing/2014/main" id="{B4EA1543-0226-257B-C86D-C636D5AE8B8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130" t="54630" r="16351" b="31129"/>
          <a:stretch/>
        </p:blipFill>
        <p:spPr>
          <a:xfrm>
            <a:off x="1751040" y="4002129"/>
            <a:ext cx="2105253" cy="40813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" name="Szövegdoboz 17">
            <a:extLst>
              <a:ext uri="{FF2B5EF4-FFF2-40B4-BE49-F238E27FC236}">
                <a16:creationId xmlns:a16="http://schemas.microsoft.com/office/drawing/2014/main" id="{0CB43E6A-2DD4-7903-118C-D740317DFBE1}"/>
              </a:ext>
            </a:extLst>
          </p:cNvPr>
          <p:cNvSpPr txBox="1"/>
          <p:nvPr/>
        </p:nvSpPr>
        <p:spPr>
          <a:xfrm>
            <a:off x="3818144" y="2073239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/>
              <a:t>70</a:t>
            </a:r>
          </a:p>
        </p:txBody>
      </p:sp>
      <p:sp>
        <p:nvSpPr>
          <p:cNvPr id="21" name="Szövegdoboz 20">
            <a:extLst>
              <a:ext uri="{FF2B5EF4-FFF2-40B4-BE49-F238E27FC236}">
                <a16:creationId xmlns:a16="http://schemas.microsoft.com/office/drawing/2014/main" id="{D92A6A49-7E14-5190-6FF3-ACD986CB3D40}"/>
              </a:ext>
            </a:extLst>
          </p:cNvPr>
          <p:cNvSpPr txBox="1"/>
          <p:nvPr/>
        </p:nvSpPr>
        <p:spPr>
          <a:xfrm>
            <a:off x="3818144" y="1836485"/>
            <a:ext cx="3481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/>
              <a:t>100</a:t>
            </a:r>
          </a:p>
        </p:txBody>
      </p:sp>
    </p:spTree>
    <p:extLst>
      <p:ext uri="{BB962C8B-B14F-4D97-AF65-F5344CB8AC3E}">
        <p14:creationId xmlns:p14="http://schemas.microsoft.com/office/powerpoint/2010/main" val="12067238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21</TotalTime>
  <Words>157</Words>
  <Application>Microsoft Office PowerPoint</Application>
  <PresentationFormat>Szélesvásznú</PresentationFormat>
  <Paragraphs>126</Paragraphs>
  <Slides>3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3</vt:i4>
      </vt:variant>
      <vt:variant>
        <vt:lpstr>Téma</vt:lpstr>
      </vt:variant>
      <vt:variant>
        <vt:i4>1</vt:i4>
      </vt:variant>
      <vt:variant>
        <vt:lpstr>Diacímek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-téma</vt:lpstr>
      <vt:lpstr>PowerPoint-bemutató</vt:lpstr>
      <vt:lpstr>PowerPoint-bemutató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Patrik</dc:creator>
  <cp:lastModifiedBy>Edit</cp:lastModifiedBy>
  <cp:revision>181</cp:revision>
  <dcterms:created xsi:type="dcterms:W3CDTF">2024-03-11T09:39:17Z</dcterms:created>
  <dcterms:modified xsi:type="dcterms:W3CDTF">2024-11-21T10:51:16Z</dcterms:modified>
</cp:coreProperties>
</file>